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omments/modernComment_100_2E1DB92B.xml" ContentType="application/vnd.ms-powerpoint.comment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23D6D5B-CD88-AF17-24DB-5DF83A29D096}" name="Jermann, Philip" initials="JP" userId="S::philip.jermann@thermofisher.com::e10035d5-5694-4da2-b251-c7f1ed8245bc" providerId="AD"/>
  <p188:author id="{B7447899-6E9E-B954-F80B-6EAAB7E45A49}" name="MDPI" initials="M" userId="MDPI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47126F1-0408-4D63-8D1F-44ACA5FE5673}" v="2" dt="2023-08-28T14:34:31.69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5" d="100"/>
          <a:sy n="85" d="100"/>
        </p:scale>
        <p:origin x="49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14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rmann, Philip" userId="e10035d5-5694-4da2-b251-c7f1ed8245bc" providerId="ADAL" clId="{EE2A5C2B-1DAC-47C8-9ABA-E79B5AD3E96C}"/>
    <pc:docChg chg="custSel modSld">
      <pc:chgData name="Jermann, Philip" userId="e10035d5-5694-4da2-b251-c7f1ed8245bc" providerId="ADAL" clId="{EE2A5C2B-1DAC-47C8-9ABA-E79B5AD3E96C}" dt="2023-03-15T12:41:53.759" v="2" actId="1076"/>
      <pc:docMkLst>
        <pc:docMk/>
      </pc:docMkLst>
      <pc:sldChg chg="addSp delSp modSp mod">
        <pc:chgData name="Jermann, Philip" userId="e10035d5-5694-4da2-b251-c7f1ed8245bc" providerId="ADAL" clId="{EE2A5C2B-1DAC-47C8-9ABA-E79B5AD3E96C}" dt="2023-03-15T12:41:53.759" v="2" actId="1076"/>
        <pc:sldMkLst>
          <pc:docMk/>
          <pc:sldMk cId="2424727736" sldId="259"/>
        </pc:sldMkLst>
        <pc:picChg chg="add mod">
          <ac:chgData name="Jermann, Philip" userId="e10035d5-5694-4da2-b251-c7f1ed8245bc" providerId="ADAL" clId="{EE2A5C2B-1DAC-47C8-9ABA-E79B5AD3E96C}" dt="2023-03-15T12:41:53.759" v="2" actId="1076"/>
          <ac:picMkLst>
            <pc:docMk/>
            <pc:sldMk cId="2424727736" sldId="259"/>
            <ac:picMk id="2" creationId="{6611314E-E92B-B516-4EE7-A44A4E12036A}"/>
          </ac:picMkLst>
        </pc:picChg>
        <pc:picChg chg="del">
          <ac:chgData name="Jermann, Philip" userId="e10035d5-5694-4da2-b251-c7f1ed8245bc" providerId="ADAL" clId="{EE2A5C2B-1DAC-47C8-9ABA-E79B5AD3E96C}" dt="2023-03-15T12:41:50.186" v="0" actId="478"/>
          <ac:picMkLst>
            <pc:docMk/>
            <pc:sldMk cId="2424727736" sldId="259"/>
            <ac:picMk id="26" creationId="{D77B73E7-F116-9B59-B4BB-D4538BFD04BB}"/>
          </ac:picMkLst>
        </pc:picChg>
      </pc:sldChg>
    </pc:docChg>
  </pc:docChgLst>
  <pc:docChgLst>
    <pc:chgData name="Durães, Cecília" userId="8a818ba3-3ef8-416c-8969-302cb0ffa99c" providerId="ADAL" clId="{D1CF6AE8-3BA6-456C-BE3E-CFEC7E69C5E9}"/>
    <pc:docChg chg="undo custSel addSld modSld">
      <pc:chgData name="Durães, Cecília" userId="8a818ba3-3ef8-416c-8969-302cb0ffa99c" providerId="ADAL" clId="{D1CF6AE8-3BA6-456C-BE3E-CFEC7E69C5E9}" dt="2022-09-22T17:45:16.451" v="1129" actId="1076"/>
      <pc:docMkLst>
        <pc:docMk/>
      </pc:docMkLst>
      <pc:sldChg chg="addSp delSp modSp mod">
        <pc:chgData name="Durães, Cecília" userId="8a818ba3-3ef8-416c-8969-302cb0ffa99c" providerId="ADAL" clId="{D1CF6AE8-3BA6-456C-BE3E-CFEC7E69C5E9}" dt="2022-09-21T22:07:45.894" v="1061" actId="1076"/>
        <pc:sldMkLst>
          <pc:docMk/>
          <pc:sldMk cId="773699883" sldId="256"/>
        </pc:sldMkLst>
        <pc:spChg chg="add del mod">
          <ac:chgData name="Durães, Cecília" userId="8a818ba3-3ef8-416c-8969-302cb0ffa99c" providerId="ADAL" clId="{D1CF6AE8-3BA6-456C-BE3E-CFEC7E69C5E9}" dt="2022-09-20T15:38:51.398" v="248" actId="478"/>
          <ac:spMkLst>
            <pc:docMk/>
            <pc:sldMk cId="773699883" sldId="256"/>
            <ac:spMk id="5" creationId="{2F1AF691-FEC3-D6AA-240A-8EC865CFA667}"/>
          </ac:spMkLst>
        </pc:spChg>
        <pc:spChg chg="add del mod">
          <ac:chgData name="Durães, Cecília" userId="8a818ba3-3ef8-416c-8969-302cb0ffa99c" providerId="ADAL" clId="{D1CF6AE8-3BA6-456C-BE3E-CFEC7E69C5E9}" dt="2022-09-20T16:00:55.697" v="298" actId="478"/>
          <ac:spMkLst>
            <pc:docMk/>
            <pc:sldMk cId="773699883" sldId="256"/>
            <ac:spMk id="6" creationId="{62B53F20-2A7F-DABD-AE0E-59E9A67886A8}"/>
          </ac:spMkLst>
        </pc:spChg>
        <pc:spChg chg="add del mod">
          <ac:chgData name="Durães, Cecília" userId="8a818ba3-3ef8-416c-8969-302cb0ffa99c" providerId="ADAL" clId="{D1CF6AE8-3BA6-456C-BE3E-CFEC7E69C5E9}" dt="2022-09-20T16:00:52.379" v="297" actId="478"/>
          <ac:spMkLst>
            <pc:docMk/>
            <pc:sldMk cId="773699883" sldId="256"/>
            <ac:spMk id="7" creationId="{EC99B82B-7AD4-9CEB-D9B6-1E8B2168D8AF}"/>
          </ac:spMkLst>
        </pc:spChg>
        <pc:spChg chg="add mod">
          <ac:chgData name="Durães, Cecília" userId="8a818ba3-3ef8-416c-8969-302cb0ffa99c" providerId="ADAL" clId="{D1CF6AE8-3BA6-456C-BE3E-CFEC7E69C5E9}" dt="2022-09-20T16:00:47.072" v="295" actId="164"/>
          <ac:spMkLst>
            <pc:docMk/>
            <pc:sldMk cId="773699883" sldId="256"/>
            <ac:spMk id="56" creationId="{5F451771-BCBC-CD49-8D2D-BE1A037367FC}"/>
          </ac:spMkLst>
        </pc:spChg>
        <pc:spChg chg="add mod">
          <ac:chgData name="Durães, Cecília" userId="8a818ba3-3ef8-416c-8969-302cb0ffa99c" providerId="ADAL" clId="{D1CF6AE8-3BA6-456C-BE3E-CFEC7E69C5E9}" dt="2022-09-21T22:07:45.894" v="1061" actId="1076"/>
          <ac:spMkLst>
            <pc:docMk/>
            <pc:sldMk cId="773699883" sldId="256"/>
            <ac:spMk id="58" creationId="{2343FFA6-5BB5-61DA-2524-406F466E9EE2}"/>
          </ac:spMkLst>
        </pc:spChg>
        <pc:grpChg chg="add mod">
          <ac:chgData name="Durães, Cecília" userId="8a818ba3-3ef8-416c-8969-302cb0ffa99c" providerId="ADAL" clId="{D1CF6AE8-3BA6-456C-BE3E-CFEC7E69C5E9}" dt="2022-09-20T16:01:00.369" v="299" actId="1076"/>
          <ac:grpSpMkLst>
            <pc:docMk/>
            <pc:sldMk cId="773699883" sldId="256"/>
            <ac:grpSpMk id="59" creationId="{E1B0DA4E-2FE2-8461-1B0F-7B0D42901C0D}"/>
          </ac:grpSpMkLst>
        </pc:grpChg>
        <pc:graphicFrameChg chg="add del mod">
          <ac:chgData name="Durães, Cecília" userId="8a818ba3-3ef8-416c-8969-302cb0ffa99c" providerId="ADAL" clId="{D1CF6AE8-3BA6-456C-BE3E-CFEC7E69C5E9}" dt="2022-09-20T15:33:58.586" v="7" actId="478"/>
          <ac:graphicFrameMkLst>
            <pc:docMk/>
            <pc:sldMk cId="773699883" sldId="256"/>
            <ac:graphicFrameMk id="8" creationId="{BD3898D2-F3B3-5BD1-0D38-197CF4E10AC6}"/>
          </ac:graphicFrameMkLst>
        </pc:graphicFrameChg>
        <pc:picChg chg="add del">
          <ac:chgData name="Durães, Cecília" userId="8a818ba3-3ef8-416c-8969-302cb0ffa99c" providerId="ADAL" clId="{D1CF6AE8-3BA6-456C-BE3E-CFEC7E69C5E9}" dt="2022-09-20T15:33:08.250" v="3"/>
          <ac:picMkLst>
            <pc:docMk/>
            <pc:sldMk cId="773699883" sldId="256"/>
            <ac:picMk id="4" creationId="{5F636C65-3924-7965-FEE7-9AFEEF202BEC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9" creationId="{CA1B197E-45B6-F9B3-BDB5-48D89150826D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10" creationId="{E90743A5-45E0-C37B-1E39-169B5D4004B1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11" creationId="{99B5545F-6B56-2BAA-7559-DF5D346EC8C3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12" creationId="{3F46FFCC-0A78-9547-5C5C-3345DE589980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13" creationId="{B45754F6-EE4E-D4A8-288C-8F504BA8CA6E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14" creationId="{A9890EC7-10A8-485D-A0E9-AF941F7C9755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15" creationId="{7BDB6491-1330-54EA-5CF5-4C2BC156A9CC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16" creationId="{EA044A63-29D2-275F-42AA-6303CE7B149A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17" creationId="{B14453FE-6520-EAD1-4D45-E97DC0C4EB0F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18" creationId="{2382F6F8-1B18-F6FC-B718-9EFC8FE89AA0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19" creationId="{46C65B2B-7F93-5380-58CC-AD845566BAA1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20" creationId="{D0612408-218D-DA0B-F393-644B64F626BD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21" creationId="{5477A0D5-5B6B-C3A1-971B-405E85FDCA57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22" creationId="{2CA4D1E3-0C8A-D669-7199-82B60B13B6D4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23" creationId="{551C0A07-6858-09F3-228A-3F418BC8878E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24" creationId="{5677C776-23F9-5FB6-5178-D779B980628A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25" creationId="{810CF781-B8DE-F44D-7B48-8E905F0373DF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26" creationId="{6CD0D9B5-8587-26CE-D2A4-CC704739F933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27" creationId="{A64269F2-AEE3-77E0-34D4-00E74270E270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28" creationId="{F0B972E7-3804-4D9C-398A-F7E09FFD7260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29" creationId="{8F01EE57-5C4A-AF72-7C49-47EF85E7159C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30" creationId="{BF367E6B-EBFA-D07B-C248-90D1268C6705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31" creationId="{30A42492-1D9F-7AF6-6D64-75600A5D0D99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32" creationId="{0B4D9E98-D822-F808-4418-9951AB40A32A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33" creationId="{B49ECF22-C4B2-D773-7536-ECA414E09678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34" creationId="{625F8697-AC0E-79AD-7FA3-0F85E103A700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35" creationId="{CFA125E4-9569-8F40-BB5F-B37DD8E9D45B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36" creationId="{56B6B212-1D5A-6532-26C5-010E5C25C79F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37" creationId="{74A28DE2-84CC-AFD3-0580-1113D66CC86D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38" creationId="{39480819-43E1-990C-6E69-A1EE0CF46C9A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39" creationId="{9AC134C9-87EA-683C-5EA7-6A54E91149AA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40" creationId="{E2ACA984-CB74-8BED-A92B-D6D43D25EFF9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41" creationId="{9FF8A42F-5A73-BD4C-FF60-9CFBF4EC0578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42" creationId="{66355C6E-63F9-B3C6-ADF8-A2125D36B11B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43" creationId="{6F3BBEE1-7D87-60C3-D438-E4282DC89D17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44" creationId="{09A43BCA-8413-3739-E22A-DB2D8F9F25B6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45" creationId="{B4644CFA-45BA-D7D4-30B6-8AB137210986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46" creationId="{391BB670-341B-AAD5-085B-AD63D041DA82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47" creationId="{EAFC63E9-4D3A-B5BC-E421-D4DAB6CECC36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48" creationId="{0BCA424E-1121-D628-3C57-B253B24DBB57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49" creationId="{42B0B88E-BF2F-1869-D635-CB83063F8F94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50" creationId="{83CCF996-0C0E-347D-69A9-75BC17F38976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51" creationId="{64117D3B-91D4-5C81-D6D0-481009941644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52" creationId="{0C4631CC-8911-369F-B876-CBE1473293D1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53" creationId="{8F98352A-DADA-A44D-B0CE-A8B6F47A3AAC}"/>
          </ac:picMkLst>
        </pc:picChg>
        <pc:picChg chg="add del mod">
          <ac:chgData name="Durães, Cecília" userId="8a818ba3-3ef8-416c-8969-302cb0ffa99c" providerId="ADAL" clId="{D1CF6AE8-3BA6-456C-BE3E-CFEC7E69C5E9}" dt="2022-09-20T15:34:05.367" v="9" actId="478"/>
          <ac:picMkLst>
            <pc:docMk/>
            <pc:sldMk cId="773699883" sldId="256"/>
            <ac:picMk id="54" creationId="{03965E2D-292E-789B-8256-4F04C9AA29BF}"/>
          </ac:picMkLst>
        </pc:picChg>
        <pc:picChg chg="add mod">
          <ac:chgData name="Durães, Cecília" userId="8a818ba3-3ef8-416c-8969-302cb0ffa99c" providerId="ADAL" clId="{D1CF6AE8-3BA6-456C-BE3E-CFEC7E69C5E9}" dt="2022-09-20T16:00:47.072" v="295" actId="164"/>
          <ac:picMkLst>
            <pc:docMk/>
            <pc:sldMk cId="773699883" sldId="256"/>
            <ac:picMk id="55" creationId="{BF894C79-F69C-3C51-71CD-335F601C2DA0}"/>
          </ac:picMkLst>
        </pc:picChg>
        <pc:picChg chg="add mod">
          <ac:chgData name="Durães, Cecília" userId="8a818ba3-3ef8-416c-8969-302cb0ffa99c" providerId="ADAL" clId="{D1CF6AE8-3BA6-456C-BE3E-CFEC7E69C5E9}" dt="2022-09-20T16:00:47.072" v="295" actId="164"/>
          <ac:picMkLst>
            <pc:docMk/>
            <pc:sldMk cId="773699883" sldId="256"/>
            <ac:picMk id="57" creationId="{0ED3D65E-A11A-848F-D4E6-1F13EB9D9821}"/>
          </ac:picMkLst>
        </pc:picChg>
      </pc:sldChg>
      <pc:sldChg chg="addSp delSp modSp mod">
        <pc:chgData name="Durães, Cecília" userId="8a818ba3-3ef8-416c-8969-302cb0ffa99c" providerId="ADAL" clId="{D1CF6AE8-3BA6-456C-BE3E-CFEC7E69C5E9}" dt="2022-09-22T16:40:29.090" v="1109" actId="1076"/>
        <pc:sldMkLst>
          <pc:docMk/>
          <pc:sldMk cId="2888505620" sldId="257"/>
        </pc:sldMkLst>
        <pc:spChg chg="add del mod">
          <ac:chgData name="Durães, Cecília" userId="8a818ba3-3ef8-416c-8969-302cb0ffa99c" providerId="ADAL" clId="{D1CF6AE8-3BA6-456C-BE3E-CFEC7E69C5E9}" dt="2022-09-20T15:32:45.957" v="1"/>
          <ac:spMkLst>
            <pc:docMk/>
            <pc:sldMk cId="2888505620" sldId="257"/>
            <ac:spMk id="6" creationId="{D7DF2332-AFA0-234C-96B0-5286BB87CD47}"/>
          </ac:spMkLst>
        </pc:spChg>
        <pc:spChg chg="add mod">
          <ac:chgData name="Durães, Cecília" userId="8a818ba3-3ef8-416c-8969-302cb0ffa99c" providerId="ADAL" clId="{D1CF6AE8-3BA6-456C-BE3E-CFEC7E69C5E9}" dt="2022-09-22T10:48:37.434" v="1092" actId="1076"/>
          <ac:spMkLst>
            <pc:docMk/>
            <pc:sldMk cId="2888505620" sldId="257"/>
            <ac:spMk id="10" creationId="{694C414F-BF50-D5C4-E3B1-2C2B199A8915}"/>
          </ac:spMkLst>
        </pc:spChg>
        <pc:spChg chg="add mod">
          <ac:chgData name="Durães, Cecília" userId="8a818ba3-3ef8-416c-8969-302cb0ffa99c" providerId="ADAL" clId="{D1CF6AE8-3BA6-456C-BE3E-CFEC7E69C5E9}" dt="2022-09-22T10:48:43.690" v="1093" actId="1076"/>
          <ac:spMkLst>
            <pc:docMk/>
            <pc:sldMk cId="2888505620" sldId="257"/>
            <ac:spMk id="12" creationId="{ABBB16C8-8A67-EEC5-9E9A-86CE6429C4A1}"/>
          </ac:spMkLst>
        </pc:spChg>
        <pc:graphicFrameChg chg="add del mod">
          <ac:chgData name="Durães, Cecília" userId="8a818ba3-3ef8-416c-8969-302cb0ffa99c" providerId="ADAL" clId="{D1CF6AE8-3BA6-456C-BE3E-CFEC7E69C5E9}" dt="2022-09-20T15:32:45.957" v="1"/>
          <ac:graphicFrameMkLst>
            <pc:docMk/>
            <pc:sldMk cId="2888505620" sldId="257"/>
            <ac:graphicFrameMk id="4" creationId="{C2ED0A79-1FB1-50E5-BD99-E7824264BB5D}"/>
          </ac:graphicFrameMkLst>
        </pc:graphicFrameChg>
        <pc:graphicFrameChg chg="add del mod modGraphic">
          <ac:chgData name="Durães, Cecília" userId="8a818ba3-3ef8-416c-8969-302cb0ffa99c" providerId="ADAL" clId="{D1CF6AE8-3BA6-456C-BE3E-CFEC7E69C5E9}" dt="2022-09-20T15:59:53.683" v="280" actId="478"/>
          <ac:graphicFrameMkLst>
            <pc:docMk/>
            <pc:sldMk cId="2888505620" sldId="257"/>
            <ac:graphicFrameMk id="7" creationId="{972B0515-2617-807D-1E99-1D7E50255437}"/>
          </ac:graphicFrameMkLst>
        </pc:graphicFrameChg>
        <pc:graphicFrameChg chg="add del mod modGraphic">
          <ac:chgData name="Durães, Cecília" userId="8a818ba3-3ef8-416c-8969-302cb0ffa99c" providerId="ADAL" clId="{D1CF6AE8-3BA6-456C-BE3E-CFEC7E69C5E9}" dt="2022-09-20T16:00:12.987" v="288"/>
          <ac:graphicFrameMkLst>
            <pc:docMk/>
            <pc:sldMk cId="2888505620" sldId="257"/>
            <ac:graphicFrameMk id="8" creationId="{B178DBA4-8712-DAEC-E595-D21169600533}"/>
          </ac:graphicFrameMkLst>
        </pc:graphicFrameChg>
        <pc:picChg chg="add del mod">
          <ac:chgData name="Durães, Cecília" userId="8a818ba3-3ef8-416c-8969-302cb0ffa99c" providerId="ADAL" clId="{D1CF6AE8-3BA6-456C-BE3E-CFEC7E69C5E9}" dt="2022-09-22T16:40:18.322" v="1105" actId="478"/>
          <ac:picMkLst>
            <pc:docMk/>
            <pc:sldMk cId="2888505620" sldId="257"/>
            <ac:picMk id="2" creationId="{A35FEB2B-3035-E3FF-1232-A75B67C4AF77}"/>
          </ac:picMkLst>
        </pc:picChg>
        <pc:picChg chg="add mod">
          <ac:chgData name="Durães, Cecília" userId="8a818ba3-3ef8-416c-8969-302cb0ffa99c" providerId="ADAL" clId="{D1CF6AE8-3BA6-456C-BE3E-CFEC7E69C5E9}" dt="2022-09-22T16:40:29.090" v="1109" actId="1076"/>
          <ac:picMkLst>
            <pc:docMk/>
            <pc:sldMk cId="2888505620" sldId="257"/>
            <ac:picMk id="3" creationId="{D591EE17-5416-7C1E-8197-E77040CB2581}"/>
          </ac:picMkLst>
        </pc:picChg>
        <pc:picChg chg="add del mod">
          <ac:chgData name="Durães, Cecília" userId="8a818ba3-3ef8-416c-8969-302cb0ffa99c" providerId="ADAL" clId="{D1CF6AE8-3BA6-456C-BE3E-CFEC7E69C5E9}" dt="2022-09-20T15:32:45.957" v="1"/>
          <ac:picMkLst>
            <pc:docMk/>
            <pc:sldMk cId="2888505620" sldId="257"/>
            <ac:picMk id="5" creationId="{01F49C91-6485-589B-7518-3098B275DEBF}"/>
          </ac:picMkLst>
        </pc:picChg>
        <pc:picChg chg="add del mod">
          <ac:chgData name="Durães, Cecília" userId="8a818ba3-3ef8-416c-8969-302cb0ffa99c" providerId="ADAL" clId="{D1CF6AE8-3BA6-456C-BE3E-CFEC7E69C5E9}" dt="2022-09-20T16:05:43.236" v="503" actId="478"/>
          <ac:picMkLst>
            <pc:docMk/>
            <pc:sldMk cId="2888505620" sldId="257"/>
            <ac:picMk id="9" creationId="{403B436A-31DE-4BAB-7DC3-21EDFC488FDC}"/>
          </ac:picMkLst>
        </pc:picChg>
        <pc:picChg chg="add del mod">
          <ac:chgData name="Durães, Cecília" userId="8a818ba3-3ef8-416c-8969-302cb0ffa99c" providerId="ADAL" clId="{D1CF6AE8-3BA6-456C-BE3E-CFEC7E69C5E9}" dt="2022-09-21T23:07:54.489" v="1063" actId="478"/>
          <ac:picMkLst>
            <pc:docMk/>
            <pc:sldMk cId="2888505620" sldId="257"/>
            <ac:picMk id="11" creationId="{7D075376-6E66-1C96-40E2-D667AA7EB348}"/>
          </ac:picMkLst>
        </pc:picChg>
        <pc:picChg chg="add del mod">
          <ac:chgData name="Durães, Cecília" userId="8a818ba3-3ef8-416c-8969-302cb0ffa99c" providerId="ADAL" clId="{D1CF6AE8-3BA6-456C-BE3E-CFEC7E69C5E9}" dt="2022-09-22T14:59:48.349" v="1094" actId="478"/>
          <ac:picMkLst>
            <pc:docMk/>
            <pc:sldMk cId="2888505620" sldId="257"/>
            <ac:picMk id="13" creationId="{B510E8B6-ACDC-0716-C152-EC01854027D1}"/>
          </ac:picMkLst>
        </pc:picChg>
      </pc:sldChg>
      <pc:sldChg chg="addSp delSp modSp new mod delAnim modAnim">
        <pc:chgData name="Durães, Cecília" userId="8a818ba3-3ef8-416c-8969-302cb0ffa99c" providerId="ADAL" clId="{D1CF6AE8-3BA6-456C-BE3E-CFEC7E69C5E9}" dt="2022-09-22T16:15:45.515" v="1104" actId="20577"/>
        <pc:sldMkLst>
          <pc:docMk/>
          <pc:sldMk cId="2424727736" sldId="259"/>
        </pc:sldMkLst>
        <pc:spChg chg="del">
          <ac:chgData name="Durães, Cecília" userId="8a818ba3-3ef8-416c-8969-302cb0ffa99c" providerId="ADAL" clId="{D1CF6AE8-3BA6-456C-BE3E-CFEC7E69C5E9}" dt="2022-09-21T10:00:31.214" v="519" actId="478"/>
          <ac:spMkLst>
            <pc:docMk/>
            <pc:sldMk cId="2424727736" sldId="259"/>
            <ac:spMk id="2" creationId="{A8FBB588-B71F-D67A-2C70-FE8BD1205F14}"/>
          </ac:spMkLst>
        </pc:spChg>
        <pc:spChg chg="del">
          <ac:chgData name="Durães, Cecília" userId="8a818ba3-3ef8-416c-8969-302cb0ffa99c" providerId="ADAL" clId="{D1CF6AE8-3BA6-456C-BE3E-CFEC7E69C5E9}" dt="2022-09-21T10:00:33.923" v="520" actId="478"/>
          <ac:spMkLst>
            <pc:docMk/>
            <pc:sldMk cId="2424727736" sldId="259"/>
            <ac:spMk id="3" creationId="{54D0BAF9-CE32-8AF0-03D2-A14F7AF42C63}"/>
          </ac:spMkLst>
        </pc:spChg>
        <pc:spChg chg="add mod">
          <ac:chgData name="Durães, Cecília" userId="8a818ba3-3ef8-416c-8969-302cb0ffa99c" providerId="ADAL" clId="{D1CF6AE8-3BA6-456C-BE3E-CFEC7E69C5E9}" dt="2022-09-21T11:26:16.862" v="525" actId="164"/>
          <ac:spMkLst>
            <pc:docMk/>
            <pc:sldMk cId="2424727736" sldId="259"/>
            <ac:spMk id="5" creationId="{12E0C0BB-8D65-D49F-7420-BA456056CAC2}"/>
          </ac:spMkLst>
        </pc:spChg>
        <pc:spChg chg="mod">
          <ac:chgData name="Durães, Cecília" userId="8a818ba3-3ef8-416c-8969-302cb0ffa99c" providerId="ADAL" clId="{D1CF6AE8-3BA6-456C-BE3E-CFEC7E69C5E9}" dt="2022-09-21T11:26:14.701" v="524" actId="164"/>
          <ac:spMkLst>
            <pc:docMk/>
            <pc:sldMk cId="2424727736" sldId="259"/>
            <ac:spMk id="7" creationId="{56C49736-F916-EFC0-DFAC-ACEB88349468}"/>
          </ac:spMkLst>
        </pc:spChg>
        <pc:spChg chg="mod">
          <ac:chgData name="Durães, Cecília" userId="8a818ba3-3ef8-416c-8969-302cb0ffa99c" providerId="ADAL" clId="{D1CF6AE8-3BA6-456C-BE3E-CFEC7E69C5E9}" dt="2022-09-21T11:26:47.414" v="529" actId="2711"/>
          <ac:spMkLst>
            <pc:docMk/>
            <pc:sldMk cId="2424727736" sldId="259"/>
            <ac:spMk id="8" creationId="{D9037FFB-6540-E1FC-8AB5-328776C83CDB}"/>
          </ac:spMkLst>
        </pc:spChg>
        <pc:spChg chg="add mod">
          <ac:chgData name="Durães, Cecília" userId="8a818ba3-3ef8-416c-8969-302cb0ffa99c" providerId="ADAL" clId="{D1CF6AE8-3BA6-456C-BE3E-CFEC7E69C5E9}" dt="2022-09-21T11:26:16.862" v="525" actId="164"/>
          <ac:spMkLst>
            <pc:docMk/>
            <pc:sldMk cId="2424727736" sldId="259"/>
            <ac:spMk id="13" creationId="{87137B71-72AF-166F-345E-782559CA7694}"/>
          </ac:spMkLst>
        </pc:spChg>
        <pc:spChg chg="mod">
          <ac:chgData name="Durães, Cecília" userId="8a818ba3-3ef8-416c-8969-302cb0ffa99c" providerId="ADAL" clId="{D1CF6AE8-3BA6-456C-BE3E-CFEC7E69C5E9}" dt="2022-09-21T11:26:14.701" v="524" actId="164"/>
          <ac:spMkLst>
            <pc:docMk/>
            <pc:sldMk cId="2424727736" sldId="259"/>
            <ac:spMk id="15" creationId="{4822C00F-2A68-2DE1-4820-863A046405C5}"/>
          </ac:spMkLst>
        </pc:spChg>
        <pc:spChg chg="mod">
          <ac:chgData name="Durães, Cecília" userId="8a818ba3-3ef8-416c-8969-302cb0ffa99c" providerId="ADAL" clId="{D1CF6AE8-3BA6-456C-BE3E-CFEC7E69C5E9}" dt="2022-09-21T11:26:14.701" v="524" actId="164"/>
          <ac:spMkLst>
            <pc:docMk/>
            <pc:sldMk cId="2424727736" sldId="259"/>
            <ac:spMk id="16" creationId="{2358C3D7-6769-EE90-16E6-592AD01B3909}"/>
          </ac:spMkLst>
        </pc:spChg>
        <pc:spChg chg="add mod">
          <ac:chgData name="Durães, Cecília" userId="8a818ba3-3ef8-416c-8969-302cb0ffa99c" providerId="ADAL" clId="{D1CF6AE8-3BA6-456C-BE3E-CFEC7E69C5E9}" dt="2022-09-21T11:26:16.862" v="525" actId="164"/>
          <ac:spMkLst>
            <pc:docMk/>
            <pc:sldMk cId="2424727736" sldId="259"/>
            <ac:spMk id="17" creationId="{6F145F6D-9586-0B76-6F5E-C0AC2C9BA557}"/>
          </ac:spMkLst>
        </pc:spChg>
        <pc:spChg chg="mod">
          <ac:chgData name="Durães, Cecília" userId="8a818ba3-3ef8-416c-8969-302cb0ffa99c" providerId="ADAL" clId="{D1CF6AE8-3BA6-456C-BE3E-CFEC7E69C5E9}" dt="2022-09-21T11:26:14.701" v="524" actId="164"/>
          <ac:spMkLst>
            <pc:docMk/>
            <pc:sldMk cId="2424727736" sldId="259"/>
            <ac:spMk id="19" creationId="{A06DB6A9-328F-EE38-C56C-1FD2806C5AC3}"/>
          </ac:spMkLst>
        </pc:spChg>
        <pc:spChg chg="mod">
          <ac:chgData name="Durães, Cecília" userId="8a818ba3-3ef8-416c-8969-302cb0ffa99c" providerId="ADAL" clId="{D1CF6AE8-3BA6-456C-BE3E-CFEC7E69C5E9}" dt="2022-09-21T11:26:14.701" v="524" actId="164"/>
          <ac:spMkLst>
            <pc:docMk/>
            <pc:sldMk cId="2424727736" sldId="259"/>
            <ac:spMk id="20" creationId="{378E060E-7A54-8B8C-03B1-A3EE666D09CD}"/>
          </ac:spMkLst>
        </pc:spChg>
        <pc:spChg chg="add mod">
          <ac:chgData name="Durães, Cecília" userId="8a818ba3-3ef8-416c-8969-302cb0ffa99c" providerId="ADAL" clId="{D1CF6AE8-3BA6-456C-BE3E-CFEC7E69C5E9}" dt="2022-09-21T11:26:16.862" v="525" actId="164"/>
          <ac:spMkLst>
            <pc:docMk/>
            <pc:sldMk cId="2424727736" sldId="259"/>
            <ac:spMk id="21" creationId="{5FBFCB92-1138-B796-0EE6-E3D99843FF60}"/>
          </ac:spMkLst>
        </pc:spChg>
        <pc:spChg chg="add mod">
          <ac:chgData name="Durães, Cecília" userId="8a818ba3-3ef8-416c-8969-302cb0ffa99c" providerId="ADAL" clId="{D1CF6AE8-3BA6-456C-BE3E-CFEC7E69C5E9}" dt="2022-09-21T11:26:16.862" v="525" actId="164"/>
          <ac:spMkLst>
            <pc:docMk/>
            <pc:sldMk cId="2424727736" sldId="259"/>
            <ac:spMk id="22" creationId="{98FAE60D-2C8E-BFC3-349B-7E867C490823}"/>
          </ac:spMkLst>
        </pc:spChg>
        <pc:spChg chg="add mod">
          <ac:chgData name="Durães, Cecília" userId="8a818ba3-3ef8-416c-8969-302cb0ffa99c" providerId="ADAL" clId="{D1CF6AE8-3BA6-456C-BE3E-CFEC7E69C5E9}" dt="2022-09-21T11:26:16.862" v="525" actId="164"/>
          <ac:spMkLst>
            <pc:docMk/>
            <pc:sldMk cId="2424727736" sldId="259"/>
            <ac:spMk id="23" creationId="{9EA2DC18-378E-9541-008E-FA245C149BB3}"/>
          </ac:spMkLst>
        </pc:spChg>
        <pc:spChg chg="add mod">
          <ac:chgData name="Durães, Cecília" userId="8a818ba3-3ef8-416c-8969-302cb0ffa99c" providerId="ADAL" clId="{D1CF6AE8-3BA6-456C-BE3E-CFEC7E69C5E9}" dt="2022-09-22T16:15:45.515" v="1104" actId="20577"/>
          <ac:spMkLst>
            <pc:docMk/>
            <pc:sldMk cId="2424727736" sldId="259"/>
            <ac:spMk id="27" creationId="{3DCB4652-A7CF-BE3A-6151-5E044264C994}"/>
          </ac:spMkLst>
        </pc:spChg>
        <pc:grpChg chg="add mod">
          <ac:chgData name="Durães, Cecília" userId="8a818ba3-3ef8-416c-8969-302cb0ffa99c" providerId="ADAL" clId="{D1CF6AE8-3BA6-456C-BE3E-CFEC7E69C5E9}" dt="2022-09-21T11:26:16.862" v="525" actId="164"/>
          <ac:grpSpMkLst>
            <pc:docMk/>
            <pc:sldMk cId="2424727736" sldId="259"/>
            <ac:grpSpMk id="6" creationId="{BD21E508-6A49-DBFE-59D4-A905E37D8717}"/>
          </ac:grpSpMkLst>
        </pc:grpChg>
        <pc:grpChg chg="add mod">
          <ac:chgData name="Durães, Cecília" userId="8a818ba3-3ef8-416c-8969-302cb0ffa99c" providerId="ADAL" clId="{D1CF6AE8-3BA6-456C-BE3E-CFEC7E69C5E9}" dt="2022-09-21T11:26:16.862" v="525" actId="164"/>
          <ac:grpSpMkLst>
            <pc:docMk/>
            <pc:sldMk cId="2424727736" sldId="259"/>
            <ac:grpSpMk id="14" creationId="{8C0A5C75-F3CA-1E85-200C-FBD9D1060E73}"/>
          </ac:grpSpMkLst>
        </pc:grpChg>
        <pc:grpChg chg="add mod">
          <ac:chgData name="Durães, Cecília" userId="8a818ba3-3ef8-416c-8969-302cb0ffa99c" providerId="ADAL" clId="{D1CF6AE8-3BA6-456C-BE3E-CFEC7E69C5E9}" dt="2022-09-21T11:26:16.862" v="525" actId="164"/>
          <ac:grpSpMkLst>
            <pc:docMk/>
            <pc:sldMk cId="2424727736" sldId="259"/>
            <ac:grpSpMk id="18" creationId="{7DF13503-F08E-5B7B-E963-4425A12ACD9C}"/>
          </ac:grpSpMkLst>
        </pc:grpChg>
        <pc:grpChg chg="add del mod">
          <ac:chgData name="Durães, Cecília" userId="8a818ba3-3ef8-416c-8969-302cb0ffa99c" providerId="ADAL" clId="{D1CF6AE8-3BA6-456C-BE3E-CFEC7E69C5E9}" dt="2022-09-21T11:26:53.530" v="531" actId="478"/>
          <ac:grpSpMkLst>
            <pc:docMk/>
            <pc:sldMk cId="2424727736" sldId="259"/>
            <ac:grpSpMk id="25" creationId="{C88900A2-EF50-B61E-4B30-D85BBE8788FB}"/>
          </ac:grpSpMkLst>
        </pc:grpChg>
        <pc:picChg chg="add mod">
          <ac:chgData name="Durães, Cecília" userId="8a818ba3-3ef8-416c-8969-302cb0ffa99c" providerId="ADAL" clId="{D1CF6AE8-3BA6-456C-BE3E-CFEC7E69C5E9}" dt="2022-09-21T11:26:16.862" v="525" actId="164"/>
          <ac:picMkLst>
            <pc:docMk/>
            <pc:sldMk cId="2424727736" sldId="259"/>
            <ac:picMk id="4" creationId="{7DB4E0E5-68D5-797C-D653-812DAB01C96B}"/>
          </ac:picMkLst>
        </pc:picChg>
        <pc:picChg chg="add mod">
          <ac:chgData name="Durães, Cecília" userId="8a818ba3-3ef8-416c-8969-302cb0ffa99c" providerId="ADAL" clId="{D1CF6AE8-3BA6-456C-BE3E-CFEC7E69C5E9}" dt="2022-09-22T16:13:45.308" v="1102" actId="14100"/>
          <ac:picMkLst>
            <pc:docMk/>
            <pc:sldMk cId="2424727736" sldId="259"/>
            <ac:picMk id="26" creationId="{D77B73E7-F116-9B59-B4BB-D4538BFD04BB}"/>
          </ac:picMkLst>
        </pc:picChg>
        <pc:cxnChg chg="add mod">
          <ac:chgData name="Durães, Cecília" userId="8a818ba3-3ef8-416c-8969-302cb0ffa99c" providerId="ADAL" clId="{D1CF6AE8-3BA6-456C-BE3E-CFEC7E69C5E9}" dt="2022-09-21T11:26:16.862" v="525" actId="164"/>
          <ac:cxnSpMkLst>
            <pc:docMk/>
            <pc:sldMk cId="2424727736" sldId="259"/>
            <ac:cxnSpMk id="9" creationId="{1B7278A5-7014-8499-A1CD-31D34B4D5BCB}"/>
          </ac:cxnSpMkLst>
        </pc:cxnChg>
        <pc:cxnChg chg="add mod">
          <ac:chgData name="Durães, Cecília" userId="8a818ba3-3ef8-416c-8969-302cb0ffa99c" providerId="ADAL" clId="{D1CF6AE8-3BA6-456C-BE3E-CFEC7E69C5E9}" dt="2022-09-21T11:26:16.862" v="525" actId="164"/>
          <ac:cxnSpMkLst>
            <pc:docMk/>
            <pc:sldMk cId="2424727736" sldId="259"/>
            <ac:cxnSpMk id="10" creationId="{096675C6-8489-7727-399A-9E711CCD2948}"/>
          </ac:cxnSpMkLst>
        </pc:cxnChg>
        <pc:cxnChg chg="add mod">
          <ac:chgData name="Durães, Cecília" userId="8a818ba3-3ef8-416c-8969-302cb0ffa99c" providerId="ADAL" clId="{D1CF6AE8-3BA6-456C-BE3E-CFEC7E69C5E9}" dt="2022-09-21T11:26:16.862" v="525" actId="164"/>
          <ac:cxnSpMkLst>
            <pc:docMk/>
            <pc:sldMk cId="2424727736" sldId="259"/>
            <ac:cxnSpMk id="11" creationId="{AD371525-0EC4-13C0-5E96-308F10FE8D13}"/>
          </ac:cxnSpMkLst>
        </pc:cxnChg>
        <pc:cxnChg chg="add mod">
          <ac:chgData name="Durães, Cecília" userId="8a818ba3-3ef8-416c-8969-302cb0ffa99c" providerId="ADAL" clId="{D1CF6AE8-3BA6-456C-BE3E-CFEC7E69C5E9}" dt="2022-09-21T11:26:16.862" v="525" actId="164"/>
          <ac:cxnSpMkLst>
            <pc:docMk/>
            <pc:sldMk cId="2424727736" sldId="259"/>
            <ac:cxnSpMk id="12" creationId="{AAB82B4E-104D-EBB0-3598-8A76F814FAA5}"/>
          </ac:cxnSpMkLst>
        </pc:cxnChg>
        <pc:cxnChg chg="add del mod">
          <ac:chgData name="Durães, Cecília" userId="8a818ba3-3ef8-416c-8969-302cb0ffa99c" providerId="ADAL" clId="{D1CF6AE8-3BA6-456C-BE3E-CFEC7E69C5E9}" dt="2022-09-21T11:25:53.445" v="522" actId="478"/>
          <ac:cxnSpMkLst>
            <pc:docMk/>
            <pc:sldMk cId="2424727736" sldId="259"/>
            <ac:cxnSpMk id="24" creationId="{1DB64490-B873-D76C-D247-2CE41CB00FBC}"/>
          </ac:cxnSpMkLst>
        </pc:cxnChg>
      </pc:sldChg>
      <pc:sldChg chg="addSp delSp modSp new mod">
        <pc:chgData name="Durães, Cecília" userId="8a818ba3-3ef8-416c-8969-302cb0ffa99c" providerId="ADAL" clId="{D1CF6AE8-3BA6-456C-BE3E-CFEC7E69C5E9}" dt="2022-09-21T22:06:04.563" v="1042" actId="20577"/>
        <pc:sldMkLst>
          <pc:docMk/>
          <pc:sldMk cId="1260288373" sldId="260"/>
        </pc:sldMkLst>
        <pc:spChg chg="del">
          <ac:chgData name="Durães, Cecília" userId="8a818ba3-3ef8-416c-8969-302cb0ffa99c" providerId="ADAL" clId="{D1CF6AE8-3BA6-456C-BE3E-CFEC7E69C5E9}" dt="2022-09-21T11:34:31.254" v="623" actId="478"/>
          <ac:spMkLst>
            <pc:docMk/>
            <pc:sldMk cId="1260288373" sldId="260"/>
            <ac:spMk id="2" creationId="{E5F2A54C-7EC0-C8B1-B1E9-A7DE235DA051}"/>
          </ac:spMkLst>
        </pc:spChg>
        <pc:spChg chg="del">
          <ac:chgData name="Durães, Cecília" userId="8a818ba3-3ef8-416c-8969-302cb0ffa99c" providerId="ADAL" clId="{D1CF6AE8-3BA6-456C-BE3E-CFEC7E69C5E9}" dt="2022-09-21T11:34:34.460" v="624" actId="478"/>
          <ac:spMkLst>
            <pc:docMk/>
            <pc:sldMk cId="1260288373" sldId="260"/>
            <ac:spMk id="3" creationId="{A7862AAF-FEDE-4F11-27BD-83BBB1B3DFA7}"/>
          </ac:spMkLst>
        </pc:spChg>
        <pc:spChg chg="mod">
          <ac:chgData name="Durães, Cecília" userId="8a818ba3-3ef8-416c-8969-302cb0ffa99c" providerId="ADAL" clId="{D1CF6AE8-3BA6-456C-BE3E-CFEC7E69C5E9}" dt="2022-09-21T11:39:27.311" v="649" actId="1076"/>
          <ac:spMkLst>
            <pc:docMk/>
            <pc:sldMk cId="1260288373" sldId="260"/>
            <ac:spMk id="7" creationId="{D725C783-FA2F-A2C3-7EF5-9C37CD3E1230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21" creationId="{DED01BAE-B9CD-6AE4-D7F9-BC29549E26DA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23" creationId="{C2B1DE43-CF2C-8FE6-3C5C-12F88E06FD4E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24" creationId="{8BEF6F3A-DC77-247A-DBF3-19295AEE0FED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25" creationId="{4579ECCC-A519-704A-2D55-071BE1B66B33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27" creationId="{1FDD7722-B0B0-A2DA-2196-C9CAD912FD6F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28" creationId="{90D7DC5F-A91E-B75F-BA95-F06634BEF37B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29" creationId="{A19529A4-4375-192A-B6E1-946D2426B899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31" creationId="{2A1CFD71-4D79-7859-3813-13BEC9A0747E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32" creationId="{6A5B6297-7869-C0DF-F619-57E8853FD965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33" creationId="{5FD81FD6-0281-B488-88DA-0F5C219D0674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35" creationId="{7AB1C447-8871-03D2-F91A-4B1A09C1CDDC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36" creationId="{0FDB4950-423F-1CBB-5527-C10DD93BEB57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37" creationId="{A207E487-2FFA-6EB3-1F52-4914786E0999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39" creationId="{54502B65-BDFB-9A08-296E-E6B82A24B29F}"/>
          </ac:spMkLst>
        </pc:spChg>
        <pc:spChg chg="mod">
          <ac:chgData name="Durães, Cecília" userId="8a818ba3-3ef8-416c-8969-302cb0ffa99c" providerId="ADAL" clId="{D1CF6AE8-3BA6-456C-BE3E-CFEC7E69C5E9}" dt="2022-09-21T11:35:06.913" v="625"/>
          <ac:spMkLst>
            <pc:docMk/>
            <pc:sldMk cId="1260288373" sldId="260"/>
            <ac:spMk id="40" creationId="{A4A574CE-EEA6-67ED-7752-F85023E5DF47}"/>
          </ac:spMkLst>
        </pc:spChg>
        <pc:spChg chg="del mod topLvl">
          <ac:chgData name="Durães, Cecília" userId="8a818ba3-3ef8-416c-8969-302cb0ffa99c" providerId="ADAL" clId="{D1CF6AE8-3BA6-456C-BE3E-CFEC7E69C5E9}" dt="2022-09-21T11:40:51.951" v="658" actId="478"/>
          <ac:spMkLst>
            <pc:docMk/>
            <pc:sldMk cId="1260288373" sldId="260"/>
            <ac:spMk id="42" creationId="{C4725CAC-AD54-0396-9D2D-4E13D15198DD}"/>
          </ac:spMkLst>
        </pc:spChg>
        <pc:spChg chg="add del mod">
          <ac:chgData name="Durães, Cecília" userId="8a818ba3-3ef8-416c-8969-302cb0ffa99c" providerId="ADAL" clId="{D1CF6AE8-3BA6-456C-BE3E-CFEC7E69C5E9}" dt="2022-09-21T11:40:48.564" v="657" actId="478"/>
          <ac:spMkLst>
            <pc:docMk/>
            <pc:sldMk cId="1260288373" sldId="260"/>
            <ac:spMk id="44" creationId="{1020142D-C6DB-88B3-8C43-13BB55D336F5}"/>
          </ac:spMkLst>
        </pc:spChg>
        <pc:spChg chg="add del mod">
          <ac:chgData name="Durães, Cecília" userId="8a818ba3-3ef8-416c-8969-302cb0ffa99c" providerId="ADAL" clId="{D1CF6AE8-3BA6-456C-BE3E-CFEC7E69C5E9}" dt="2022-09-21T11:41:26.773" v="669" actId="478"/>
          <ac:spMkLst>
            <pc:docMk/>
            <pc:sldMk cId="1260288373" sldId="260"/>
            <ac:spMk id="45" creationId="{D584B30D-9DBD-3055-1ED1-C658209C23F2}"/>
          </ac:spMkLst>
        </pc:spChg>
        <pc:spChg chg="add mod">
          <ac:chgData name="Durães, Cecília" userId="8a818ba3-3ef8-416c-8969-302cb0ffa99c" providerId="ADAL" clId="{D1CF6AE8-3BA6-456C-BE3E-CFEC7E69C5E9}" dt="2022-09-21T22:06:04.563" v="1042" actId="20577"/>
          <ac:spMkLst>
            <pc:docMk/>
            <pc:sldMk cId="1260288373" sldId="260"/>
            <ac:spMk id="47" creationId="{3C526D3F-C3DE-E62C-7B27-33059908DF72}"/>
          </ac:spMkLst>
        </pc:spChg>
        <pc:spChg chg="add mod">
          <ac:chgData name="Durães, Cecília" userId="8a818ba3-3ef8-416c-8969-302cb0ffa99c" providerId="ADAL" clId="{D1CF6AE8-3BA6-456C-BE3E-CFEC7E69C5E9}" dt="2022-09-21T21:21:47.016" v="944" actId="1076"/>
          <ac:spMkLst>
            <pc:docMk/>
            <pc:sldMk cId="1260288373" sldId="260"/>
            <ac:spMk id="48" creationId="{9E86529D-3CB4-F6D7-C536-9477C95AD240}"/>
          </ac:spMkLst>
        </pc:spChg>
        <pc:spChg chg="add mod">
          <ac:chgData name="Durães, Cecília" userId="8a818ba3-3ef8-416c-8969-302cb0ffa99c" providerId="ADAL" clId="{D1CF6AE8-3BA6-456C-BE3E-CFEC7E69C5E9}" dt="2022-09-21T21:29:08.325" v="1024" actId="1076"/>
          <ac:spMkLst>
            <pc:docMk/>
            <pc:sldMk cId="1260288373" sldId="260"/>
            <ac:spMk id="49" creationId="{628F312C-AF75-60FA-B308-BD20D3089C31}"/>
          </ac:spMkLst>
        </pc:spChg>
        <pc:spChg chg="mod">
          <ac:chgData name="Durães, Cecília" userId="8a818ba3-3ef8-416c-8969-302cb0ffa99c" providerId="ADAL" clId="{D1CF6AE8-3BA6-456C-BE3E-CFEC7E69C5E9}" dt="2022-09-21T11:42:17.825" v="716" actId="165"/>
          <ac:spMkLst>
            <pc:docMk/>
            <pc:sldMk cId="1260288373" sldId="260"/>
            <ac:spMk id="53" creationId="{1D477240-995C-FAFF-D43D-0E56DC60C0EF}"/>
          </ac:spMkLst>
        </pc:spChg>
        <pc:spChg chg="add del mod">
          <ac:chgData name="Durães, Cecília" userId="8a818ba3-3ef8-416c-8969-302cb0ffa99c" providerId="ADAL" clId="{D1CF6AE8-3BA6-456C-BE3E-CFEC7E69C5E9}" dt="2022-09-21T11:42:21.774" v="717" actId="478"/>
          <ac:spMkLst>
            <pc:docMk/>
            <pc:sldMk cId="1260288373" sldId="260"/>
            <ac:spMk id="54" creationId="{E2C32338-9BF9-5DA0-DD7E-1A6CC11AC6CA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59" creationId="{308A0C0A-BE3C-D2F2-607D-963806931B45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73" creationId="{ECB33FDE-77CC-7CB8-985C-2A133C0DEBDA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75" creationId="{265A68C5-89A9-FBC8-2C2D-95832EC4A77F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76" creationId="{334A132A-7AFA-A447-D1FD-F80EB7C5413C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77" creationId="{E2729530-CADC-72AE-6FFD-7954D6ACAF31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79" creationId="{90C774F2-5080-DFED-689E-3372F0D2CF00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80" creationId="{96F0294D-A67D-51B4-1167-E37607BB7FE0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81" creationId="{97FDE2B3-CAED-5DB0-143E-41B75BCF3CE2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83" creationId="{EB261B4F-F3C2-6CD2-2D54-D2BCEACCFB2C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84" creationId="{CFF50816-04A5-23E9-9AD6-4C320796D4E0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85" creationId="{94624708-8B33-EB01-6616-A18AB8408F90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87" creationId="{E23023D0-00AE-4C55-4C05-040C2308F5DD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88" creationId="{FDE4A83C-4BE1-41F1-21EF-354DDA7DA0E6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89" creationId="{2C70C86D-D4AF-1E9C-6DF1-D7A778601A2C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91" creationId="{525A1A92-9003-E235-829E-CBD0019310CE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92" creationId="{8FE73D4D-88B5-4D56-F043-1FE37D0C1DAF}"/>
          </ac:spMkLst>
        </pc:spChg>
        <pc:spChg chg="mod">
          <ac:chgData name="Durães, Cecília" userId="8a818ba3-3ef8-416c-8969-302cb0ffa99c" providerId="ADAL" clId="{D1CF6AE8-3BA6-456C-BE3E-CFEC7E69C5E9}" dt="2022-09-21T11:42:43.623" v="719"/>
          <ac:spMkLst>
            <pc:docMk/>
            <pc:sldMk cId="1260288373" sldId="260"/>
            <ac:spMk id="94" creationId="{51FDA1FE-DA2E-BCC6-B693-832AEC142DF7}"/>
          </ac:spMkLst>
        </pc:spChg>
        <pc:spChg chg="add del mod">
          <ac:chgData name="Durães, Cecília" userId="8a818ba3-3ef8-416c-8969-302cb0ffa99c" providerId="ADAL" clId="{D1CF6AE8-3BA6-456C-BE3E-CFEC7E69C5E9}" dt="2022-09-21T11:42:47.079" v="720"/>
          <ac:spMkLst>
            <pc:docMk/>
            <pc:sldMk cId="1260288373" sldId="260"/>
            <ac:spMk id="96" creationId="{6C351F9B-70BC-BDA3-7DAE-CAE980278F66}"/>
          </ac:spMkLst>
        </pc:spChg>
        <pc:spChg chg="add del mod">
          <ac:chgData name="Durães, Cecília" userId="8a818ba3-3ef8-416c-8969-302cb0ffa99c" providerId="ADAL" clId="{D1CF6AE8-3BA6-456C-BE3E-CFEC7E69C5E9}" dt="2022-09-21T11:42:47.079" v="720"/>
          <ac:spMkLst>
            <pc:docMk/>
            <pc:sldMk cId="1260288373" sldId="260"/>
            <ac:spMk id="97" creationId="{2690F1EF-E561-2CE3-FEFD-B5CBB5A9C004}"/>
          </ac:spMkLst>
        </pc:spChg>
        <pc:spChg chg="mod">
          <ac:chgData name="Durães, Cecília" userId="8a818ba3-3ef8-416c-8969-302cb0ffa99c" providerId="ADAL" clId="{D1CF6AE8-3BA6-456C-BE3E-CFEC7E69C5E9}" dt="2022-09-21T11:43:32.772" v="729" actId="1076"/>
          <ac:spMkLst>
            <pc:docMk/>
            <pc:sldMk cId="1260288373" sldId="260"/>
            <ac:spMk id="102" creationId="{4B2BB955-54F0-3EB2-E0B6-F7A2C44FEF32}"/>
          </ac:spMkLst>
        </pc:spChg>
        <pc:spChg chg="add del mod">
          <ac:chgData name="Durães, Cecília" userId="8a818ba3-3ef8-416c-8969-302cb0ffa99c" providerId="ADAL" clId="{D1CF6AE8-3BA6-456C-BE3E-CFEC7E69C5E9}" dt="2022-09-21T11:43:50.746" v="731" actId="478"/>
          <ac:spMkLst>
            <pc:docMk/>
            <pc:sldMk cId="1260288373" sldId="260"/>
            <ac:spMk id="104" creationId="{32FF7166-F739-1E9C-1016-038D5BE850C5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18" creationId="{E07EA40D-4540-1303-0B20-6EF1DCE62A2A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20" creationId="{C91228C3-9390-E8BF-BA4B-03EB72366A1E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21" creationId="{F632B195-8D1E-37ED-18DE-747E08527980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22" creationId="{46391F84-7BDF-1DD6-9FE1-F27732CC42AC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24" creationId="{7E13D3DE-8F0F-A060-8664-CB043E643F88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25" creationId="{0D1A7F12-F002-DEA5-140C-23B973165B58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26" creationId="{A33A8659-8A00-D27B-A41E-8445C2728129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28" creationId="{B2FBB5CD-B738-795C-E121-CF13C3297B2A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29" creationId="{AA40F76B-6358-272D-3AF4-70F02382602D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30" creationId="{F0D194C3-CFA9-C7FA-84C1-B03319A9C989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32" creationId="{8A56C4B9-AE85-E839-7FF8-9B29D736768E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33" creationId="{B2B29BDB-FD6E-8A26-E7B8-2766FBEF40CE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34" creationId="{5713A390-CC01-9BDA-A96E-8E518E46F3EE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36" creationId="{DB143745-3A43-D3FF-EB76-8D03B8F5AF5E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37" creationId="{37248E02-811F-6C1C-1AF0-CF8F2330A728}"/>
          </ac:spMkLst>
        </pc:spChg>
        <pc:spChg chg="mod">
          <ac:chgData name="Durães, Cecília" userId="8a818ba3-3ef8-416c-8969-302cb0ffa99c" providerId="ADAL" clId="{D1CF6AE8-3BA6-456C-BE3E-CFEC7E69C5E9}" dt="2022-09-21T21:15:35.377" v="790"/>
          <ac:spMkLst>
            <pc:docMk/>
            <pc:sldMk cId="1260288373" sldId="260"/>
            <ac:spMk id="139" creationId="{53EFCF60-582B-EC66-F89B-71FB1944A206}"/>
          </ac:spMkLst>
        </pc:spChg>
        <pc:spChg chg="add del mod">
          <ac:chgData name="Durães, Cecília" userId="8a818ba3-3ef8-416c-8969-302cb0ffa99c" providerId="ADAL" clId="{D1CF6AE8-3BA6-456C-BE3E-CFEC7E69C5E9}" dt="2022-09-21T21:15:38.419" v="791"/>
          <ac:spMkLst>
            <pc:docMk/>
            <pc:sldMk cId="1260288373" sldId="260"/>
            <ac:spMk id="141" creationId="{8BEA0901-AD73-DB40-A347-9ABCD689DA6D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55" creationId="{AEAF2B43-4C35-F2E2-5E5C-2B4BAACB711F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57" creationId="{D5852D14-9B77-A854-3E05-822E73469B14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58" creationId="{75E486E4-53D4-67C4-AE8B-F26E4CEC73CD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59" creationId="{F8E5984A-1B92-8245-1441-623672D6AF66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61" creationId="{D3CDF005-22D7-AFBE-FAB8-FA143BE90279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62" creationId="{63C477B3-970E-0FDA-B13D-7AFDAAC678AC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63" creationId="{A98B5489-8E50-CC55-92B7-985D5158D90E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65" creationId="{1829DED9-C441-37C8-D2CE-8829777E4CBB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66" creationId="{9CAC8125-B3FD-79AD-C5C6-3C4FE329DF97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67" creationId="{E77661EA-F644-FAFB-C450-E3FB4AC6403E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69" creationId="{47C7006B-50E0-F78D-FC30-E830693AD2AF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70" creationId="{CC50C4B7-1F7F-74FA-7F55-B5331E56A9B6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71" creationId="{0E9FC99C-E26E-84D5-36F2-714C064235C1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73" creationId="{0C03D80A-C83A-96A5-010F-827E2059C050}"/>
          </ac:spMkLst>
        </pc:spChg>
        <pc:spChg chg="mod">
          <ac:chgData name="Durães, Cecília" userId="8a818ba3-3ef8-416c-8969-302cb0ffa99c" providerId="ADAL" clId="{D1CF6AE8-3BA6-456C-BE3E-CFEC7E69C5E9}" dt="2022-09-21T21:17:06.170" v="806" actId="790"/>
          <ac:spMkLst>
            <pc:docMk/>
            <pc:sldMk cId="1260288373" sldId="260"/>
            <ac:spMk id="174" creationId="{A037AB8A-A244-8BC7-3BAF-260C97FAEC80}"/>
          </ac:spMkLst>
        </pc:spChg>
        <pc:spChg chg="mod topLvl">
          <ac:chgData name="Durães, Cecília" userId="8a818ba3-3ef8-416c-8969-302cb0ffa99c" providerId="ADAL" clId="{D1CF6AE8-3BA6-456C-BE3E-CFEC7E69C5E9}" dt="2022-09-21T21:17:36.970" v="808" actId="164"/>
          <ac:spMkLst>
            <pc:docMk/>
            <pc:sldMk cId="1260288373" sldId="260"/>
            <ac:spMk id="176" creationId="{98BFE99D-C1EE-6F1A-9392-C61755C420B7}"/>
          </ac:spMkLst>
        </pc:spChg>
        <pc:spChg chg="add mod">
          <ac:chgData name="Durães, Cecília" userId="8a818ba3-3ef8-416c-8969-302cb0ffa99c" providerId="ADAL" clId="{D1CF6AE8-3BA6-456C-BE3E-CFEC7E69C5E9}" dt="2022-09-21T21:17:36.970" v="808" actId="164"/>
          <ac:spMkLst>
            <pc:docMk/>
            <pc:sldMk cId="1260288373" sldId="260"/>
            <ac:spMk id="178" creationId="{C45DED66-4CD9-8CB7-F4CC-E58D55531268}"/>
          </ac:spMkLst>
        </pc:spChg>
        <pc:spChg chg="mod">
          <ac:chgData name="Durães, Cecília" userId="8a818ba3-3ef8-416c-8969-302cb0ffa99c" providerId="ADAL" clId="{D1CF6AE8-3BA6-456C-BE3E-CFEC7E69C5E9}" dt="2022-09-21T21:18:39.246" v="821" actId="790"/>
          <ac:spMkLst>
            <pc:docMk/>
            <pc:sldMk cId="1260288373" sldId="260"/>
            <ac:spMk id="185" creationId="{926EAE8B-09E3-FAED-637F-F3DC3F39E0BC}"/>
          </ac:spMkLst>
        </pc:spChg>
        <pc:spChg chg="add mod">
          <ac:chgData name="Durães, Cecília" userId="8a818ba3-3ef8-416c-8969-302cb0ffa99c" providerId="ADAL" clId="{D1CF6AE8-3BA6-456C-BE3E-CFEC7E69C5E9}" dt="2022-09-21T21:18:51.156" v="823" actId="164"/>
          <ac:spMkLst>
            <pc:docMk/>
            <pc:sldMk cId="1260288373" sldId="260"/>
            <ac:spMk id="187" creationId="{5BDBC09B-D5D2-2895-A3AE-A0CD4A801BFC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02" creationId="{41DD7A9A-F55A-F7A0-E3A1-209ADA9E2EB5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04" creationId="{C25B3100-2DA8-74EB-D47E-5F60C4DB87F2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05" creationId="{250D659B-AA3C-9C3C-A3BA-7F6A1EA71149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06" creationId="{B17F2FBE-EDBD-65BE-B3A6-63354DA28F31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08" creationId="{7F3A33C1-80C9-531D-FE97-2145DF41B724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09" creationId="{BE0E7788-8780-E90C-5BBB-F5202A62F2E8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10" creationId="{77137584-517E-72A5-F1CB-D17A116269E9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12" creationId="{E28B3544-6BEB-7ECF-BC77-F87ACE578D9E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13" creationId="{0E8EFADE-3351-B48F-7485-C6D90022E9D8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14" creationId="{6C3150CA-73A3-0440-7DDA-CFF50F44DBBE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16" creationId="{1C91D157-5F71-543B-B39F-8902924B8841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17" creationId="{653EB335-2DF6-3E3C-883B-3279A3A02F52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18" creationId="{D5DC8351-4709-4B2C-4207-C789018397A2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20" creationId="{9CA18BB8-9A73-3150-267D-ED01EA4E6183}"/>
          </ac:spMkLst>
        </pc:spChg>
        <pc:spChg chg="mod">
          <ac:chgData name="Durães, Cecília" userId="8a818ba3-3ef8-416c-8969-302cb0ffa99c" providerId="ADAL" clId="{D1CF6AE8-3BA6-456C-BE3E-CFEC7E69C5E9}" dt="2022-09-21T21:28:02.075" v="993" actId="164"/>
          <ac:spMkLst>
            <pc:docMk/>
            <pc:sldMk cId="1260288373" sldId="260"/>
            <ac:spMk id="221" creationId="{D3058C4D-BECA-DB67-FCA8-B662671FB4A3}"/>
          </ac:spMkLst>
        </pc:spChg>
        <pc:spChg chg="del mod topLvl">
          <ac:chgData name="Durães, Cecília" userId="8a818ba3-3ef8-416c-8969-302cb0ffa99c" providerId="ADAL" clId="{D1CF6AE8-3BA6-456C-BE3E-CFEC7E69C5E9}" dt="2022-09-21T21:28:20.844" v="996" actId="478"/>
          <ac:spMkLst>
            <pc:docMk/>
            <pc:sldMk cId="1260288373" sldId="260"/>
            <ac:spMk id="223" creationId="{25F0BC1A-A92B-043D-A6D1-7D1EC503309F}"/>
          </ac:spMkLst>
        </pc:spChg>
        <pc:spChg chg="add mod">
          <ac:chgData name="Durães, Cecília" userId="8a818ba3-3ef8-416c-8969-302cb0ffa99c" providerId="ADAL" clId="{D1CF6AE8-3BA6-456C-BE3E-CFEC7E69C5E9}" dt="2022-09-21T21:28:03.670" v="994" actId="164"/>
          <ac:spMkLst>
            <pc:docMk/>
            <pc:sldMk cId="1260288373" sldId="260"/>
            <ac:spMk id="225" creationId="{4F9DAC56-378E-1A75-92B4-A31B66DC0D1E}"/>
          </ac:spMkLst>
        </pc:spChg>
        <pc:grpChg chg="add del mod">
          <ac:chgData name="Durães, Cecília" userId="8a818ba3-3ef8-416c-8969-302cb0ffa99c" providerId="ADAL" clId="{D1CF6AE8-3BA6-456C-BE3E-CFEC7E69C5E9}" dt="2022-09-21T11:41:24.001" v="668" actId="478"/>
          <ac:grpSpMkLst>
            <pc:docMk/>
            <pc:sldMk cId="1260288373" sldId="260"/>
            <ac:grpSpMk id="4" creationId="{AC455ED5-130E-F921-ACF6-E12B3C5D76CA}"/>
          </ac:grpSpMkLst>
        </pc:grpChg>
        <pc:grpChg chg="del mod">
          <ac:chgData name="Durães, Cecília" userId="8a818ba3-3ef8-416c-8969-302cb0ffa99c" providerId="ADAL" clId="{D1CF6AE8-3BA6-456C-BE3E-CFEC7E69C5E9}" dt="2022-09-21T11:38:54.872" v="641" actId="478"/>
          <ac:grpSpMkLst>
            <pc:docMk/>
            <pc:sldMk cId="1260288373" sldId="260"/>
            <ac:grpSpMk id="6" creationId="{6B004A40-2AB9-C56C-2C2B-E8E3643967D2}"/>
          </ac:grpSpMkLst>
        </pc:grpChg>
        <pc:grpChg chg="add del mod">
          <ac:chgData name="Durães, Cecília" userId="8a818ba3-3ef8-416c-8969-302cb0ffa99c" providerId="ADAL" clId="{D1CF6AE8-3BA6-456C-BE3E-CFEC7E69C5E9}" dt="2022-09-21T11:40:44.681" v="656" actId="478"/>
          <ac:grpSpMkLst>
            <pc:docMk/>
            <pc:sldMk cId="1260288373" sldId="260"/>
            <ac:grpSpMk id="9" creationId="{633C603B-F2D1-B58D-13B9-641B37BAF229}"/>
          </ac:grpSpMkLst>
        </pc:grpChg>
        <pc:grpChg chg="mod">
          <ac:chgData name="Durães, Cecília" userId="8a818ba3-3ef8-416c-8969-302cb0ffa99c" providerId="ADAL" clId="{D1CF6AE8-3BA6-456C-BE3E-CFEC7E69C5E9}" dt="2022-09-21T11:35:06.913" v="625"/>
          <ac:grpSpMkLst>
            <pc:docMk/>
            <pc:sldMk cId="1260288373" sldId="260"/>
            <ac:grpSpMk id="16" creationId="{90F1D266-5FB2-D22D-4015-449A088F5E4E}"/>
          </ac:grpSpMkLst>
        </pc:grpChg>
        <pc:grpChg chg="mod">
          <ac:chgData name="Durães, Cecília" userId="8a818ba3-3ef8-416c-8969-302cb0ffa99c" providerId="ADAL" clId="{D1CF6AE8-3BA6-456C-BE3E-CFEC7E69C5E9}" dt="2022-09-21T11:35:06.913" v="625"/>
          <ac:grpSpMkLst>
            <pc:docMk/>
            <pc:sldMk cId="1260288373" sldId="260"/>
            <ac:grpSpMk id="17" creationId="{F308D7B8-2E8E-8744-5256-7838A8A004DC}"/>
          </ac:grpSpMkLst>
        </pc:grpChg>
        <pc:grpChg chg="mod">
          <ac:chgData name="Durães, Cecília" userId="8a818ba3-3ef8-416c-8969-302cb0ffa99c" providerId="ADAL" clId="{D1CF6AE8-3BA6-456C-BE3E-CFEC7E69C5E9}" dt="2022-09-21T11:35:06.913" v="625"/>
          <ac:grpSpMkLst>
            <pc:docMk/>
            <pc:sldMk cId="1260288373" sldId="260"/>
            <ac:grpSpMk id="18" creationId="{B78DE687-06DE-4316-A12D-86F863C7E81F}"/>
          </ac:grpSpMkLst>
        </pc:grpChg>
        <pc:grpChg chg="mod">
          <ac:chgData name="Durães, Cecília" userId="8a818ba3-3ef8-416c-8969-302cb0ffa99c" providerId="ADAL" clId="{D1CF6AE8-3BA6-456C-BE3E-CFEC7E69C5E9}" dt="2022-09-21T11:35:06.913" v="625"/>
          <ac:grpSpMkLst>
            <pc:docMk/>
            <pc:sldMk cId="1260288373" sldId="260"/>
            <ac:grpSpMk id="19" creationId="{F2EFD31C-86EE-AC4C-F570-702259ADFDE3}"/>
          </ac:grpSpMkLst>
        </pc:grpChg>
        <pc:grpChg chg="mod">
          <ac:chgData name="Durães, Cecília" userId="8a818ba3-3ef8-416c-8969-302cb0ffa99c" providerId="ADAL" clId="{D1CF6AE8-3BA6-456C-BE3E-CFEC7E69C5E9}" dt="2022-09-21T11:35:06.913" v="625"/>
          <ac:grpSpMkLst>
            <pc:docMk/>
            <pc:sldMk cId="1260288373" sldId="260"/>
            <ac:grpSpMk id="20" creationId="{F8A12007-69F9-D137-B8DC-61826CED9988}"/>
          </ac:grpSpMkLst>
        </pc:grpChg>
        <pc:grpChg chg="mod">
          <ac:chgData name="Durães, Cecília" userId="8a818ba3-3ef8-416c-8969-302cb0ffa99c" providerId="ADAL" clId="{D1CF6AE8-3BA6-456C-BE3E-CFEC7E69C5E9}" dt="2022-09-21T11:35:06.913" v="625"/>
          <ac:grpSpMkLst>
            <pc:docMk/>
            <pc:sldMk cId="1260288373" sldId="260"/>
            <ac:grpSpMk id="22" creationId="{CBAFB7A5-C471-AD7E-1D3B-4FABB39CAA5C}"/>
          </ac:grpSpMkLst>
        </pc:grpChg>
        <pc:grpChg chg="mod">
          <ac:chgData name="Durães, Cecília" userId="8a818ba3-3ef8-416c-8969-302cb0ffa99c" providerId="ADAL" clId="{D1CF6AE8-3BA6-456C-BE3E-CFEC7E69C5E9}" dt="2022-09-21T11:35:06.913" v="625"/>
          <ac:grpSpMkLst>
            <pc:docMk/>
            <pc:sldMk cId="1260288373" sldId="260"/>
            <ac:grpSpMk id="26" creationId="{3A41C458-4782-4829-BE1D-51EC4E95FC73}"/>
          </ac:grpSpMkLst>
        </pc:grpChg>
        <pc:grpChg chg="mod">
          <ac:chgData name="Durães, Cecília" userId="8a818ba3-3ef8-416c-8969-302cb0ffa99c" providerId="ADAL" clId="{D1CF6AE8-3BA6-456C-BE3E-CFEC7E69C5E9}" dt="2022-09-21T11:35:06.913" v="625"/>
          <ac:grpSpMkLst>
            <pc:docMk/>
            <pc:sldMk cId="1260288373" sldId="260"/>
            <ac:grpSpMk id="30" creationId="{FAFEF55C-6DE3-40DE-FF9A-FAF312836BFF}"/>
          </ac:grpSpMkLst>
        </pc:grpChg>
        <pc:grpChg chg="mod">
          <ac:chgData name="Durães, Cecília" userId="8a818ba3-3ef8-416c-8969-302cb0ffa99c" providerId="ADAL" clId="{D1CF6AE8-3BA6-456C-BE3E-CFEC7E69C5E9}" dt="2022-09-21T11:35:06.913" v="625"/>
          <ac:grpSpMkLst>
            <pc:docMk/>
            <pc:sldMk cId="1260288373" sldId="260"/>
            <ac:grpSpMk id="34" creationId="{5342C0AC-AD65-095C-5A4E-24212CAC8012}"/>
          </ac:grpSpMkLst>
        </pc:grpChg>
        <pc:grpChg chg="mod">
          <ac:chgData name="Durães, Cecília" userId="8a818ba3-3ef8-416c-8969-302cb0ffa99c" providerId="ADAL" clId="{D1CF6AE8-3BA6-456C-BE3E-CFEC7E69C5E9}" dt="2022-09-21T11:35:06.913" v="625"/>
          <ac:grpSpMkLst>
            <pc:docMk/>
            <pc:sldMk cId="1260288373" sldId="260"/>
            <ac:grpSpMk id="38" creationId="{6A854F3A-E150-A86D-26B7-E9719E29DC7E}"/>
          </ac:grpSpMkLst>
        </pc:grpChg>
        <pc:grpChg chg="add del mod">
          <ac:chgData name="Durães, Cecília" userId="8a818ba3-3ef8-416c-8969-302cb0ffa99c" providerId="ADAL" clId="{D1CF6AE8-3BA6-456C-BE3E-CFEC7E69C5E9}" dt="2022-09-21T11:38:32.302" v="635" actId="478"/>
          <ac:grpSpMkLst>
            <pc:docMk/>
            <pc:sldMk cId="1260288373" sldId="260"/>
            <ac:grpSpMk id="41" creationId="{9C570A09-9ECE-C06C-EF4A-185EA41AD512}"/>
          </ac:grpSpMkLst>
        </pc:grpChg>
        <pc:grpChg chg="add del mod topLvl">
          <ac:chgData name="Durães, Cecília" userId="8a818ba3-3ef8-416c-8969-302cb0ffa99c" providerId="ADAL" clId="{D1CF6AE8-3BA6-456C-BE3E-CFEC7E69C5E9}" dt="2022-09-21T11:42:23.488" v="718" actId="478"/>
          <ac:grpSpMkLst>
            <pc:docMk/>
            <pc:sldMk cId="1260288373" sldId="260"/>
            <ac:grpSpMk id="51" creationId="{F7638100-0C8C-D7E0-E058-2897BFAB5B4E}"/>
          </ac:grpSpMkLst>
        </pc:grpChg>
        <pc:grpChg chg="add del mod">
          <ac:chgData name="Durães, Cecília" userId="8a818ba3-3ef8-416c-8969-302cb0ffa99c" providerId="ADAL" clId="{D1CF6AE8-3BA6-456C-BE3E-CFEC7E69C5E9}" dt="2022-09-21T11:42:17.825" v="716" actId="165"/>
          <ac:grpSpMkLst>
            <pc:docMk/>
            <pc:sldMk cId="1260288373" sldId="260"/>
            <ac:grpSpMk id="55" creationId="{2AB6526C-C742-4EE3-7667-01402D70917A}"/>
          </ac:grpSpMkLst>
        </pc:grpChg>
        <pc:grpChg chg="add del mod">
          <ac:chgData name="Durães, Cecília" userId="8a818ba3-3ef8-416c-8969-302cb0ffa99c" providerId="ADAL" clId="{D1CF6AE8-3BA6-456C-BE3E-CFEC7E69C5E9}" dt="2022-09-21T11:42:47.079" v="720"/>
          <ac:grpSpMkLst>
            <pc:docMk/>
            <pc:sldMk cId="1260288373" sldId="260"/>
            <ac:grpSpMk id="56" creationId="{00F31CFB-549C-2523-159C-7CDB9B55AC05}"/>
          </ac:grpSpMkLst>
        </pc:grpChg>
        <pc:grpChg chg="mod">
          <ac:chgData name="Durães, Cecília" userId="8a818ba3-3ef8-416c-8969-302cb0ffa99c" providerId="ADAL" clId="{D1CF6AE8-3BA6-456C-BE3E-CFEC7E69C5E9}" dt="2022-09-21T11:42:43.623" v="719"/>
          <ac:grpSpMkLst>
            <pc:docMk/>
            <pc:sldMk cId="1260288373" sldId="260"/>
            <ac:grpSpMk id="58" creationId="{9D252F28-DEA3-EB1C-8FA4-F2B7C92641F2}"/>
          </ac:grpSpMkLst>
        </pc:grpChg>
        <pc:grpChg chg="add del mod">
          <ac:chgData name="Durães, Cecília" userId="8a818ba3-3ef8-416c-8969-302cb0ffa99c" providerId="ADAL" clId="{D1CF6AE8-3BA6-456C-BE3E-CFEC7E69C5E9}" dt="2022-09-21T11:42:47.079" v="720"/>
          <ac:grpSpMkLst>
            <pc:docMk/>
            <pc:sldMk cId="1260288373" sldId="260"/>
            <ac:grpSpMk id="61" creationId="{BBCA8242-52A9-9D5A-ACDF-EE3FAA6D701D}"/>
          </ac:grpSpMkLst>
        </pc:grpChg>
        <pc:grpChg chg="mod">
          <ac:chgData name="Durães, Cecília" userId="8a818ba3-3ef8-416c-8969-302cb0ffa99c" providerId="ADAL" clId="{D1CF6AE8-3BA6-456C-BE3E-CFEC7E69C5E9}" dt="2022-09-21T11:42:43.623" v="719"/>
          <ac:grpSpMkLst>
            <pc:docMk/>
            <pc:sldMk cId="1260288373" sldId="260"/>
            <ac:grpSpMk id="68" creationId="{C4FBC6A5-87FE-1DB3-CA05-07962C5ECF5F}"/>
          </ac:grpSpMkLst>
        </pc:grpChg>
        <pc:grpChg chg="mod">
          <ac:chgData name="Durães, Cecília" userId="8a818ba3-3ef8-416c-8969-302cb0ffa99c" providerId="ADAL" clId="{D1CF6AE8-3BA6-456C-BE3E-CFEC7E69C5E9}" dt="2022-09-21T11:42:43.623" v="719"/>
          <ac:grpSpMkLst>
            <pc:docMk/>
            <pc:sldMk cId="1260288373" sldId="260"/>
            <ac:grpSpMk id="69" creationId="{8911CB17-BE75-3B33-7115-4C7BB103941A}"/>
          </ac:grpSpMkLst>
        </pc:grpChg>
        <pc:grpChg chg="mod">
          <ac:chgData name="Durães, Cecília" userId="8a818ba3-3ef8-416c-8969-302cb0ffa99c" providerId="ADAL" clId="{D1CF6AE8-3BA6-456C-BE3E-CFEC7E69C5E9}" dt="2022-09-21T11:42:43.623" v="719"/>
          <ac:grpSpMkLst>
            <pc:docMk/>
            <pc:sldMk cId="1260288373" sldId="260"/>
            <ac:grpSpMk id="70" creationId="{45998477-989C-8CED-E424-9999991AC21D}"/>
          </ac:grpSpMkLst>
        </pc:grpChg>
        <pc:grpChg chg="mod">
          <ac:chgData name="Durães, Cecília" userId="8a818ba3-3ef8-416c-8969-302cb0ffa99c" providerId="ADAL" clId="{D1CF6AE8-3BA6-456C-BE3E-CFEC7E69C5E9}" dt="2022-09-21T11:42:43.623" v="719"/>
          <ac:grpSpMkLst>
            <pc:docMk/>
            <pc:sldMk cId="1260288373" sldId="260"/>
            <ac:grpSpMk id="71" creationId="{A0E57EB6-B9E6-B7C5-45C5-D8D26E26926B}"/>
          </ac:grpSpMkLst>
        </pc:grpChg>
        <pc:grpChg chg="mod">
          <ac:chgData name="Durães, Cecília" userId="8a818ba3-3ef8-416c-8969-302cb0ffa99c" providerId="ADAL" clId="{D1CF6AE8-3BA6-456C-BE3E-CFEC7E69C5E9}" dt="2022-09-21T11:42:43.623" v="719"/>
          <ac:grpSpMkLst>
            <pc:docMk/>
            <pc:sldMk cId="1260288373" sldId="260"/>
            <ac:grpSpMk id="72" creationId="{6B99A72F-322E-FAB0-F1DE-A569D0067BE5}"/>
          </ac:grpSpMkLst>
        </pc:grpChg>
        <pc:grpChg chg="mod">
          <ac:chgData name="Durães, Cecília" userId="8a818ba3-3ef8-416c-8969-302cb0ffa99c" providerId="ADAL" clId="{D1CF6AE8-3BA6-456C-BE3E-CFEC7E69C5E9}" dt="2022-09-21T11:42:43.623" v="719"/>
          <ac:grpSpMkLst>
            <pc:docMk/>
            <pc:sldMk cId="1260288373" sldId="260"/>
            <ac:grpSpMk id="74" creationId="{39034AC6-9277-D65F-0FA6-C79B16244B91}"/>
          </ac:grpSpMkLst>
        </pc:grpChg>
        <pc:grpChg chg="mod">
          <ac:chgData name="Durães, Cecília" userId="8a818ba3-3ef8-416c-8969-302cb0ffa99c" providerId="ADAL" clId="{D1CF6AE8-3BA6-456C-BE3E-CFEC7E69C5E9}" dt="2022-09-21T11:42:43.623" v="719"/>
          <ac:grpSpMkLst>
            <pc:docMk/>
            <pc:sldMk cId="1260288373" sldId="260"/>
            <ac:grpSpMk id="78" creationId="{780D6F1D-7EA6-42EC-22C0-36579BCFCECC}"/>
          </ac:grpSpMkLst>
        </pc:grpChg>
        <pc:grpChg chg="mod">
          <ac:chgData name="Durães, Cecília" userId="8a818ba3-3ef8-416c-8969-302cb0ffa99c" providerId="ADAL" clId="{D1CF6AE8-3BA6-456C-BE3E-CFEC7E69C5E9}" dt="2022-09-21T11:42:43.623" v="719"/>
          <ac:grpSpMkLst>
            <pc:docMk/>
            <pc:sldMk cId="1260288373" sldId="260"/>
            <ac:grpSpMk id="82" creationId="{D9F57A9C-D08D-257B-6572-23B08AE4CA30}"/>
          </ac:grpSpMkLst>
        </pc:grpChg>
        <pc:grpChg chg="mod">
          <ac:chgData name="Durães, Cecília" userId="8a818ba3-3ef8-416c-8969-302cb0ffa99c" providerId="ADAL" clId="{D1CF6AE8-3BA6-456C-BE3E-CFEC7E69C5E9}" dt="2022-09-21T11:42:43.623" v="719"/>
          <ac:grpSpMkLst>
            <pc:docMk/>
            <pc:sldMk cId="1260288373" sldId="260"/>
            <ac:grpSpMk id="86" creationId="{D2C2084C-8884-683D-2377-BF2921F30CC1}"/>
          </ac:grpSpMkLst>
        </pc:grpChg>
        <pc:grpChg chg="mod">
          <ac:chgData name="Durães, Cecília" userId="8a818ba3-3ef8-416c-8969-302cb0ffa99c" providerId="ADAL" clId="{D1CF6AE8-3BA6-456C-BE3E-CFEC7E69C5E9}" dt="2022-09-21T11:42:43.623" v="719"/>
          <ac:grpSpMkLst>
            <pc:docMk/>
            <pc:sldMk cId="1260288373" sldId="260"/>
            <ac:grpSpMk id="90" creationId="{3E4A6CB5-373E-A210-71D2-38BEAD85D3F1}"/>
          </ac:grpSpMkLst>
        </pc:grpChg>
        <pc:grpChg chg="add del mod">
          <ac:chgData name="Durães, Cecília" userId="8a818ba3-3ef8-416c-8969-302cb0ffa99c" providerId="ADAL" clId="{D1CF6AE8-3BA6-456C-BE3E-CFEC7E69C5E9}" dt="2022-09-21T11:42:47.079" v="720"/>
          <ac:grpSpMkLst>
            <pc:docMk/>
            <pc:sldMk cId="1260288373" sldId="260"/>
            <ac:grpSpMk id="93" creationId="{22CD3FC2-3336-548A-9A33-48B2CA1D52DB}"/>
          </ac:grpSpMkLst>
        </pc:grpChg>
        <pc:grpChg chg="add del mod">
          <ac:chgData name="Durães, Cecília" userId="8a818ba3-3ef8-416c-8969-302cb0ffa99c" providerId="ADAL" clId="{D1CF6AE8-3BA6-456C-BE3E-CFEC7E69C5E9}" dt="2022-09-21T11:43:50.746" v="731" actId="478"/>
          <ac:grpSpMkLst>
            <pc:docMk/>
            <pc:sldMk cId="1260288373" sldId="260"/>
            <ac:grpSpMk id="99" creationId="{CB679B8A-6330-C817-5C41-E0871763EFE0}"/>
          </ac:grpSpMkLst>
        </pc:grpChg>
        <pc:grpChg chg="del mod">
          <ac:chgData name="Durães, Cecília" userId="8a818ba3-3ef8-416c-8969-302cb0ffa99c" providerId="ADAL" clId="{D1CF6AE8-3BA6-456C-BE3E-CFEC7E69C5E9}" dt="2022-09-21T11:43:08.581" v="722" actId="478"/>
          <ac:grpSpMkLst>
            <pc:docMk/>
            <pc:sldMk cId="1260288373" sldId="260"/>
            <ac:grpSpMk id="101" creationId="{08DA7E7B-2D58-C46D-815B-7A64CC536A7D}"/>
          </ac:grpSpMkLst>
        </pc:grpChg>
        <pc:grpChg chg="add del mod">
          <ac:chgData name="Durães, Cecília" userId="8a818ba3-3ef8-416c-8969-302cb0ffa99c" providerId="ADAL" clId="{D1CF6AE8-3BA6-456C-BE3E-CFEC7E69C5E9}" dt="2022-09-21T21:15:38.419" v="791"/>
          <ac:grpSpMkLst>
            <pc:docMk/>
            <pc:sldMk cId="1260288373" sldId="260"/>
            <ac:grpSpMk id="106" creationId="{C30807AC-1B3C-180D-802C-85E289FD02CB}"/>
          </ac:grpSpMkLst>
        </pc:grpChg>
        <pc:grpChg chg="mod">
          <ac:chgData name="Durães, Cecília" userId="8a818ba3-3ef8-416c-8969-302cb0ffa99c" providerId="ADAL" clId="{D1CF6AE8-3BA6-456C-BE3E-CFEC7E69C5E9}" dt="2022-09-21T21:15:35.377" v="790"/>
          <ac:grpSpMkLst>
            <pc:docMk/>
            <pc:sldMk cId="1260288373" sldId="260"/>
            <ac:grpSpMk id="113" creationId="{861C01CC-5151-1440-F5E4-BFCCBB2B3136}"/>
          </ac:grpSpMkLst>
        </pc:grpChg>
        <pc:grpChg chg="mod">
          <ac:chgData name="Durães, Cecília" userId="8a818ba3-3ef8-416c-8969-302cb0ffa99c" providerId="ADAL" clId="{D1CF6AE8-3BA6-456C-BE3E-CFEC7E69C5E9}" dt="2022-09-21T21:15:35.377" v="790"/>
          <ac:grpSpMkLst>
            <pc:docMk/>
            <pc:sldMk cId="1260288373" sldId="260"/>
            <ac:grpSpMk id="114" creationId="{626E9549-5F2D-A20D-87FE-103D28B7092D}"/>
          </ac:grpSpMkLst>
        </pc:grpChg>
        <pc:grpChg chg="mod">
          <ac:chgData name="Durães, Cecília" userId="8a818ba3-3ef8-416c-8969-302cb0ffa99c" providerId="ADAL" clId="{D1CF6AE8-3BA6-456C-BE3E-CFEC7E69C5E9}" dt="2022-09-21T21:15:35.377" v="790"/>
          <ac:grpSpMkLst>
            <pc:docMk/>
            <pc:sldMk cId="1260288373" sldId="260"/>
            <ac:grpSpMk id="115" creationId="{B2DD6EBA-DEC6-7DA7-525D-80E542C1D0DE}"/>
          </ac:grpSpMkLst>
        </pc:grpChg>
        <pc:grpChg chg="mod">
          <ac:chgData name="Durães, Cecília" userId="8a818ba3-3ef8-416c-8969-302cb0ffa99c" providerId="ADAL" clId="{D1CF6AE8-3BA6-456C-BE3E-CFEC7E69C5E9}" dt="2022-09-21T21:15:35.377" v="790"/>
          <ac:grpSpMkLst>
            <pc:docMk/>
            <pc:sldMk cId="1260288373" sldId="260"/>
            <ac:grpSpMk id="116" creationId="{17DFC784-9D99-FFF9-8702-D00FB34D4C4C}"/>
          </ac:grpSpMkLst>
        </pc:grpChg>
        <pc:grpChg chg="mod">
          <ac:chgData name="Durães, Cecília" userId="8a818ba3-3ef8-416c-8969-302cb0ffa99c" providerId="ADAL" clId="{D1CF6AE8-3BA6-456C-BE3E-CFEC7E69C5E9}" dt="2022-09-21T21:15:35.377" v="790"/>
          <ac:grpSpMkLst>
            <pc:docMk/>
            <pc:sldMk cId="1260288373" sldId="260"/>
            <ac:grpSpMk id="117" creationId="{4FE37828-274A-598E-4E6B-F2CE45916172}"/>
          </ac:grpSpMkLst>
        </pc:grpChg>
        <pc:grpChg chg="mod">
          <ac:chgData name="Durães, Cecília" userId="8a818ba3-3ef8-416c-8969-302cb0ffa99c" providerId="ADAL" clId="{D1CF6AE8-3BA6-456C-BE3E-CFEC7E69C5E9}" dt="2022-09-21T21:15:35.377" v="790"/>
          <ac:grpSpMkLst>
            <pc:docMk/>
            <pc:sldMk cId="1260288373" sldId="260"/>
            <ac:grpSpMk id="119" creationId="{802DBD90-96E6-6F0D-E020-E9439C38B05E}"/>
          </ac:grpSpMkLst>
        </pc:grpChg>
        <pc:grpChg chg="mod">
          <ac:chgData name="Durães, Cecília" userId="8a818ba3-3ef8-416c-8969-302cb0ffa99c" providerId="ADAL" clId="{D1CF6AE8-3BA6-456C-BE3E-CFEC7E69C5E9}" dt="2022-09-21T21:15:35.377" v="790"/>
          <ac:grpSpMkLst>
            <pc:docMk/>
            <pc:sldMk cId="1260288373" sldId="260"/>
            <ac:grpSpMk id="123" creationId="{7CED5DF2-0A43-9795-31A2-9C58CF5C6657}"/>
          </ac:grpSpMkLst>
        </pc:grpChg>
        <pc:grpChg chg="mod">
          <ac:chgData name="Durães, Cecília" userId="8a818ba3-3ef8-416c-8969-302cb0ffa99c" providerId="ADAL" clId="{D1CF6AE8-3BA6-456C-BE3E-CFEC7E69C5E9}" dt="2022-09-21T21:15:35.377" v="790"/>
          <ac:grpSpMkLst>
            <pc:docMk/>
            <pc:sldMk cId="1260288373" sldId="260"/>
            <ac:grpSpMk id="127" creationId="{25D661E0-2FD7-ECC2-8898-B7FBC27B729E}"/>
          </ac:grpSpMkLst>
        </pc:grpChg>
        <pc:grpChg chg="mod">
          <ac:chgData name="Durães, Cecília" userId="8a818ba3-3ef8-416c-8969-302cb0ffa99c" providerId="ADAL" clId="{D1CF6AE8-3BA6-456C-BE3E-CFEC7E69C5E9}" dt="2022-09-21T21:15:35.377" v="790"/>
          <ac:grpSpMkLst>
            <pc:docMk/>
            <pc:sldMk cId="1260288373" sldId="260"/>
            <ac:grpSpMk id="131" creationId="{EC1F565E-C733-3ECC-E8D0-1FF4DBB37338}"/>
          </ac:grpSpMkLst>
        </pc:grpChg>
        <pc:grpChg chg="mod">
          <ac:chgData name="Durães, Cecília" userId="8a818ba3-3ef8-416c-8969-302cb0ffa99c" providerId="ADAL" clId="{D1CF6AE8-3BA6-456C-BE3E-CFEC7E69C5E9}" dt="2022-09-21T21:15:35.377" v="790"/>
          <ac:grpSpMkLst>
            <pc:docMk/>
            <pc:sldMk cId="1260288373" sldId="260"/>
            <ac:grpSpMk id="135" creationId="{80D6C193-7A75-6F30-D267-48E0AEE8F75B}"/>
          </ac:grpSpMkLst>
        </pc:grpChg>
        <pc:grpChg chg="add del mod">
          <ac:chgData name="Durães, Cecília" userId="8a818ba3-3ef8-416c-8969-302cb0ffa99c" providerId="ADAL" clId="{D1CF6AE8-3BA6-456C-BE3E-CFEC7E69C5E9}" dt="2022-09-21T21:15:38.419" v="791"/>
          <ac:grpSpMkLst>
            <pc:docMk/>
            <pc:sldMk cId="1260288373" sldId="260"/>
            <ac:grpSpMk id="138" creationId="{34375E69-0B8E-D787-2E2A-A58EC2C25C00}"/>
          </ac:grpSpMkLst>
        </pc:grpChg>
        <pc:grpChg chg="add mod">
          <ac:chgData name="Durães, Cecília" userId="8a818ba3-3ef8-416c-8969-302cb0ffa99c" providerId="ADAL" clId="{D1CF6AE8-3BA6-456C-BE3E-CFEC7E69C5E9}" dt="2022-09-21T21:17:36.970" v="808" actId="164"/>
          <ac:grpSpMkLst>
            <pc:docMk/>
            <pc:sldMk cId="1260288373" sldId="260"/>
            <ac:grpSpMk id="143" creationId="{F8C1FC6E-159E-E051-8D14-4D39E435AA6E}"/>
          </ac:grpSpMkLst>
        </pc:grpChg>
        <pc:grpChg chg="mod">
          <ac:chgData name="Durães, Cecília" userId="8a818ba3-3ef8-416c-8969-302cb0ffa99c" providerId="ADAL" clId="{D1CF6AE8-3BA6-456C-BE3E-CFEC7E69C5E9}" dt="2022-09-21T21:15:47.829" v="792"/>
          <ac:grpSpMkLst>
            <pc:docMk/>
            <pc:sldMk cId="1260288373" sldId="260"/>
            <ac:grpSpMk id="150" creationId="{7D2A9099-1F40-9A21-7B8E-8AC17F16C485}"/>
          </ac:grpSpMkLst>
        </pc:grpChg>
        <pc:grpChg chg="mod">
          <ac:chgData name="Durães, Cecília" userId="8a818ba3-3ef8-416c-8969-302cb0ffa99c" providerId="ADAL" clId="{D1CF6AE8-3BA6-456C-BE3E-CFEC7E69C5E9}" dt="2022-09-21T21:15:47.829" v="792"/>
          <ac:grpSpMkLst>
            <pc:docMk/>
            <pc:sldMk cId="1260288373" sldId="260"/>
            <ac:grpSpMk id="151" creationId="{31A97593-F10D-A11B-3B14-43E2AF5AD922}"/>
          </ac:grpSpMkLst>
        </pc:grpChg>
        <pc:grpChg chg="mod">
          <ac:chgData name="Durães, Cecília" userId="8a818ba3-3ef8-416c-8969-302cb0ffa99c" providerId="ADAL" clId="{D1CF6AE8-3BA6-456C-BE3E-CFEC7E69C5E9}" dt="2022-09-21T21:15:47.829" v="792"/>
          <ac:grpSpMkLst>
            <pc:docMk/>
            <pc:sldMk cId="1260288373" sldId="260"/>
            <ac:grpSpMk id="152" creationId="{C35B7143-A03C-7E3E-04D1-53D3B6FA7377}"/>
          </ac:grpSpMkLst>
        </pc:grpChg>
        <pc:grpChg chg="mod">
          <ac:chgData name="Durães, Cecília" userId="8a818ba3-3ef8-416c-8969-302cb0ffa99c" providerId="ADAL" clId="{D1CF6AE8-3BA6-456C-BE3E-CFEC7E69C5E9}" dt="2022-09-21T21:15:47.829" v="792"/>
          <ac:grpSpMkLst>
            <pc:docMk/>
            <pc:sldMk cId="1260288373" sldId="260"/>
            <ac:grpSpMk id="153" creationId="{22008477-18A5-BF31-1627-B4C554FDAB27}"/>
          </ac:grpSpMkLst>
        </pc:grpChg>
        <pc:grpChg chg="mod">
          <ac:chgData name="Durães, Cecília" userId="8a818ba3-3ef8-416c-8969-302cb0ffa99c" providerId="ADAL" clId="{D1CF6AE8-3BA6-456C-BE3E-CFEC7E69C5E9}" dt="2022-09-21T21:15:47.829" v="792"/>
          <ac:grpSpMkLst>
            <pc:docMk/>
            <pc:sldMk cId="1260288373" sldId="260"/>
            <ac:grpSpMk id="154" creationId="{F393FCBE-D1F4-B791-2D2C-9EE048F184A9}"/>
          </ac:grpSpMkLst>
        </pc:grpChg>
        <pc:grpChg chg="mod">
          <ac:chgData name="Durães, Cecília" userId="8a818ba3-3ef8-416c-8969-302cb0ffa99c" providerId="ADAL" clId="{D1CF6AE8-3BA6-456C-BE3E-CFEC7E69C5E9}" dt="2022-09-21T21:15:47.829" v="792"/>
          <ac:grpSpMkLst>
            <pc:docMk/>
            <pc:sldMk cId="1260288373" sldId="260"/>
            <ac:grpSpMk id="156" creationId="{FC196541-7676-9C3C-690F-AE68A1888800}"/>
          </ac:grpSpMkLst>
        </pc:grpChg>
        <pc:grpChg chg="mod">
          <ac:chgData name="Durães, Cecília" userId="8a818ba3-3ef8-416c-8969-302cb0ffa99c" providerId="ADAL" clId="{D1CF6AE8-3BA6-456C-BE3E-CFEC7E69C5E9}" dt="2022-09-21T21:15:47.829" v="792"/>
          <ac:grpSpMkLst>
            <pc:docMk/>
            <pc:sldMk cId="1260288373" sldId="260"/>
            <ac:grpSpMk id="160" creationId="{FF9277AB-D934-B8A7-FB80-6EC0AD99579C}"/>
          </ac:grpSpMkLst>
        </pc:grpChg>
        <pc:grpChg chg="mod">
          <ac:chgData name="Durães, Cecília" userId="8a818ba3-3ef8-416c-8969-302cb0ffa99c" providerId="ADAL" clId="{D1CF6AE8-3BA6-456C-BE3E-CFEC7E69C5E9}" dt="2022-09-21T21:15:47.829" v="792"/>
          <ac:grpSpMkLst>
            <pc:docMk/>
            <pc:sldMk cId="1260288373" sldId="260"/>
            <ac:grpSpMk id="164" creationId="{BC81D86D-400D-D9A7-1E52-8FD5AC9E07E4}"/>
          </ac:grpSpMkLst>
        </pc:grpChg>
        <pc:grpChg chg="mod">
          <ac:chgData name="Durães, Cecília" userId="8a818ba3-3ef8-416c-8969-302cb0ffa99c" providerId="ADAL" clId="{D1CF6AE8-3BA6-456C-BE3E-CFEC7E69C5E9}" dt="2022-09-21T21:15:47.829" v="792"/>
          <ac:grpSpMkLst>
            <pc:docMk/>
            <pc:sldMk cId="1260288373" sldId="260"/>
            <ac:grpSpMk id="168" creationId="{59AAAD5C-3CCF-4167-E4F6-8A5EE43217B3}"/>
          </ac:grpSpMkLst>
        </pc:grpChg>
        <pc:grpChg chg="mod">
          <ac:chgData name="Durães, Cecília" userId="8a818ba3-3ef8-416c-8969-302cb0ffa99c" providerId="ADAL" clId="{D1CF6AE8-3BA6-456C-BE3E-CFEC7E69C5E9}" dt="2022-09-21T21:15:47.829" v="792"/>
          <ac:grpSpMkLst>
            <pc:docMk/>
            <pc:sldMk cId="1260288373" sldId="260"/>
            <ac:grpSpMk id="172" creationId="{2B4743C3-91F9-B7B3-ACB0-7759556A0737}"/>
          </ac:grpSpMkLst>
        </pc:grpChg>
        <pc:grpChg chg="add del mod">
          <ac:chgData name="Durães, Cecília" userId="8a818ba3-3ef8-416c-8969-302cb0ffa99c" providerId="ADAL" clId="{D1CF6AE8-3BA6-456C-BE3E-CFEC7E69C5E9}" dt="2022-09-21T21:15:51.577" v="793" actId="478"/>
          <ac:grpSpMkLst>
            <pc:docMk/>
            <pc:sldMk cId="1260288373" sldId="260"/>
            <ac:grpSpMk id="175" creationId="{37A398A1-39CF-3CD1-2404-F563E9B997F7}"/>
          </ac:grpSpMkLst>
        </pc:grpChg>
        <pc:grpChg chg="add del mod">
          <ac:chgData name="Durães, Cecília" userId="8a818ba3-3ef8-416c-8969-302cb0ffa99c" providerId="ADAL" clId="{D1CF6AE8-3BA6-456C-BE3E-CFEC7E69C5E9}" dt="2022-09-21T21:17:46.075" v="811" actId="478"/>
          <ac:grpSpMkLst>
            <pc:docMk/>
            <pc:sldMk cId="1260288373" sldId="260"/>
            <ac:grpSpMk id="180" creationId="{65B68A5E-D929-8050-D0A4-D3FC4EA2CD10}"/>
          </ac:grpSpMkLst>
        </pc:grpChg>
        <pc:grpChg chg="add mod">
          <ac:chgData name="Durães, Cecília" userId="8a818ba3-3ef8-416c-8969-302cb0ffa99c" providerId="ADAL" clId="{D1CF6AE8-3BA6-456C-BE3E-CFEC7E69C5E9}" dt="2022-09-21T21:18:51.156" v="823" actId="164"/>
          <ac:grpSpMkLst>
            <pc:docMk/>
            <pc:sldMk cId="1260288373" sldId="260"/>
            <ac:grpSpMk id="182" creationId="{397792A7-F2AE-FF1D-13BA-2D4D8D5E52D3}"/>
          </ac:grpSpMkLst>
        </pc:grpChg>
        <pc:grpChg chg="del mod">
          <ac:chgData name="Durães, Cecília" userId="8a818ba3-3ef8-416c-8969-302cb0ffa99c" providerId="ADAL" clId="{D1CF6AE8-3BA6-456C-BE3E-CFEC7E69C5E9}" dt="2022-09-21T21:18:09.611" v="814" actId="478"/>
          <ac:grpSpMkLst>
            <pc:docMk/>
            <pc:sldMk cId="1260288373" sldId="260"/>
            <ac:grpSpMk id="184" creationId="{EBB4AB01-CEEF-C218-CBE3-2C268D3F84B0}"/>
          </ac:grpSpMkLst>
        </pc:grpChg>
        <pc:grpChg chg="add del mod">
          <ac:chgData name="Durães, Cecília" userId="8a818ba3-3ef8-416c-8969-302cb0ffa99c" providerId="ADAL" clId="{D1CF6AE8-3BA6-456C-BE3E-CFEC7E69C5E9}" dt="2022-09-21T21:18:58.609" v="825" actId="478"/>
          <ac:grpSpMkLst>
            <pc:docMk/>
            <pc:sldMk cId="1260288373" sldId="260"/>
            <ac:grpSpMk id="188" creationId="{8FC88C9B-38BF-11C4-3529-BC34EE81684C}"/>
          </ac:grpSpMkLst>
        </pc:grpChg>
        <pc:grpChg chg="add mod">
          <ac:chgData name="Durães, Cecília" userId="8a818ba3-3ef8-416c-8969-302cb0ffa99c" providerId="ADAL" clId="{D1CF6AE8-3BA6-456C-BE3E-CFEC7E69C5E9}" dt="2022-09-21T21:28:03.670" v="994" actId="164"/>
          <ac:grpSpMkLst>
            <pc:docMk/>
            <pc:sldMk cId="1260288373" sldId="260"/>
            <ac:grpSpMk id="190" creationId="{C938A76C-FC9B-5687-30B6-3031B0E254FC}"/>
          </ac:grpSpMkLst>
        </pc:grpChg>
        <pc:grpChg chg="mod">
          <ac:chgData name="Durães, Cecília" userId="8a818ba3-3ef8-416c-8969-302cb0ffa99c" providerId="ADAL" clId="{D1CF6AE8-3BA6-456C-BE3E-CFEC7E69C5E9}" dt="2022-09-21T21:28:02.075" v="993" actId="164"/>
          <ac:grpSpMkLst>
            <pc:docMk/>
            <pc:sldMk cId="1260288373" sldId="260"/>
            <ac:grpSpMk id="197" creationId="{467FA3B7-C894-870E-622B-F40F67AA7133}"/>
          </ac:grpSpMkLst>
        </pc:grpChg>
        <pc:grpChg chg="mod">
          <ac:chgData name="Durães, Cecília" userId="8a818ba3-3ef8-416c-8969-302cb0ffa99c" providerId="ADAL" clId="{D1CF6AE8-3BA6-456C-BE3E-CFEC7E69C5E9}" dt="2022-09-21T21:28:02.075" v="993" actId="164"/>
          <ac:grpSpMkLst>
            <pc:docMk/>
            <pc:sldMk cId="1260288373" sldId="260"/>
            <ac:grpSpMk id="198" creationId="{6ABA3407-C08E-D590-1651-0F4CCB92671A}"/>
          </ac:grpSpMkLst>
        </pc:grpChg>
        <pc:grpChg chg="mod">
          <ac:chgData name="Durães, Cecília" userId="8a818ba3-3ef8-416c-8969-302cb0ffa99c" providerId="ADAL" clId="{D1CF6AE8-3BA6-456C-BE3E-CFEC7E69C5E9}" dt="2022-09-21T21:28:02.075" v="993" actId="164"/>
          <ac:grpSpMkLst>
            <pc:docMk/>
            <pc:sldMk cId="1260288373" sldId="260"/>
            <ac:grpSpMk id="199" creationId="{E27EC565-5351-731A-E9CF-2A755FB0B6E2}"/>
          </ac:grpSpMkLst>
        </pc:grpChg>
        <pc:grpChg chg="mod">
          <ac:chgData name="Durães, Cecília" userId="8a818ba3-3ef8-416c-8969-302cb0ffa99c" providerId="ADAL" clId="{D1CF6AE8-3BA6-456C-BE3E-CFEC7E69C5E9}" dt="2022-09-21T21:28:02.075" v="993" actId="164"/>
          <ac:grpSpMkLst>
            <pc:docMk/>
            <pc:sldMk cId="1260288373" sldId="260"/>
            <ac:grpSpMk id="200" creationId="{382FBE30-221B-194A-8F1A-5B8B13AB9A9B}"/>
          </ac:grpSpMkLst>
        </pc:grpChg>
        <pc:grpChg chg="mod">
          <ac:chgData name="Durães, Cecília" userId="8a818ba3-3ef8-416c-8969-302cb0ffa99c" providerId="ADAL" clId="{D1CF6AE8-3BA6-456C-BE3E-CFEC7E69C5E9}" dt="2022-09-21T21:28:02.075" v="993" actId="164"/>
          <ac:grpSpMkLst>
            <pc:docMk/>
            <pc:sldMk cId="1260288373" sldId="260"/>
            <ac:grpSpMk id="201" creationId="{0F319F25-EDF4-0343-00C1-853301F00130}"/>
          </ac:grpSpMkLst>
        </pc:grpChg>
        <pc:grpChg chg="mod">
          <ac:chgData name="Durães, Cecília" userId="8a818ba3-3ef8-416c-8969-302cb0ffa99c" providerId="ADAL" clId="{D1CF6AE8-3BA6-456C-BE3E-CFEC7E69C5E9}" dt="2022-09-21T21:28:02.075" v="993" actId="164"/>
          <ac:grpSpMkLst>
            <pc:docMk/>
            <pc:sldMk cId="1260288373" sldId="260"/>
            <ac:grpSpMk id="203" creationId="{A2E9E34A-A022-4FC4-1097-112DFE3C2984}"/>
          </ac:grpSpMkLst>
        </pc:grpChg>
        <pc:grpChg chg="mod">
          <ac:chgData name="Durães, Cecília" userId="8a818ba3-3ef8-416c-8969-302cb0ffa99c" providerId="ADAL" clId="{D1CF6AE8-3BA6-456C-BE3E-CFEC7E69C5E9}" dt="2022-09-21T21:28:02.075" v="993" actId="164"/>
          <ac:grpSpMkLst>
            <pc:docMk/>
            <pc:sldMk cId="1260288373" sldId="260"/>
            <ac:grpSpMk id="207" creationId="{A9ADA59F-2983-A812-947F-769189F05B81}"/>
          </ac:grpSpMkLst>
        </pc:grpChg>
        <pc:grpChg chg="mod">
          <ac:chgData name="Durães, Cecília" userId="8a818ba3-3ef8-416c-8969-302cb0ffa99c" providerId="ADAL" clId="{D1CF6AE8-3BA6-456C-BE3E-CFEC7E69C5E9}" dt="2022-09-21T21:28:02.075" v="993" actId="164"/>
          <ac:grpSpMkLst>
            <pc:docMk/>
            <pc:sldMk cId="1260288373" sldId="260"/>
            <ac:grpSpMk id="211" creationId="{32086CA1-E4A5-5E8D-83B8-CF4E976B02B6}"/>
          </ac:grpSpMkLst>
        </pc:grpChg>
        <pc:grpChg chg="mod">
          <ac:chgData name="Durães, Cecília" userId="8a818ba3-3ef8-416c-8969-302cb0ffa99c" providerId="ADAL" clId="{D1CF6AE8-3BA6-456C-BE3E-CFEC7E69C5E9}" dt="2022-09-21T21:28:02.075" v="993" actId="164"/>
          <ac:grpSpMkLst>
            <pc:docMk/>
            <pc:sldMk cId="1260288373" sldId="260"/>
            <ac:grpSpMk id="215" creationId="{ACE668B0-734F-BF40-A0CE-F3174900C026}"/>
          </ac:grpSpMkLst>
        </pc:grpChg>
        <pc:grpChg chg="mod">
          <ac:chgData name="Durães, Cecília" userId="8a818ba3-3ef8-416c-8969-302cb0ffa99c" providerId="ADAL" clId="{D1CF6AE8-3BA6-456C-BE3E-CFEC7E69C5E9}" dt="2022-09-21T21:28:02.075" v="993" actId="164"/>
          <ac:grpSpMkLst>
            <pc:docMk/>
            <pc:sldMk cId="1260288373" sldId="260"/>
            <ac:grpSpMk id="219" creationId="{F71F77E1-E45B-958B-71F2-51DE6A537597}"/>
          </ac:grpSpMkLst>
        </pc:grpChg>
        <pc:grpChg chg="add del mod">
          <ac:chgData name="Durães, Cecília" userId="8a818ba3-3ef8-416c-8969-302cb0ffa99c" providerId="ADAL" clId="{D1CF6AE8-3BA6-456C-BE3E-CFEC7E69C5E9}" dt="2022-09-21T21:26:57.122" v="975" actId="478"/>
          <ac:grpSpMkLst>
            <pc:docMk/>
            <pc:sldMk cId="1260288373" sldId="260"/>
            <ac:grpSpMk id="222" creationId="{883E08FF-D333-5DC7-B328-2A0FE8D9C070}"/>
          </ac:grpSpMkLst>
        </pc:grpChg>
        <pc:grpChg chg="add del mod">
          <ac:chgData name="Durães, Cecília" userId="8a818ba3-3ef8-416c-8969-302cb0ffa99c" providerId="ADAL" clId="{D1CF6AE8-3BA6-456C-BE3E-CFEC7E69C5E9}" dt="2022-09-21T21:28:20.844" v="996" actId="478"/>
          <ac:grpSpMkLst>
            <pc:docMk/>
            <pc:sldMk cId="1260288373" sldId="260"/>
            <ac:grpSpMk id="227" creationId="{34A08FC6-47C6-4B82-753F-F319A06A0DBA}"/>
          </ac:grpSpMkLst>
        </pc:grpChg>
        <pc:picChg chg="mod">
          <ac:chgData name="Durães, Cecília" userId="8a818ba3-3ef8-416c-8969-302cb0ffa99c" providerId="ADAL" clId="{D1CF6AE8-3BA6-456C-BE3E-CFEC7E69C5E9}" dt="2022-09-21T11:35:06.913" v="625"/>
          <ac:picMkLst>
            <pc:docMk/>
            <pc:sldMk cId="1260288373" sldId="260"/>
            <ac:picMk id="5" creationId="{D2F63E92-970D-D62B-7719-B1E5BD73ED0B}"/>
          </ac:picMkLst>
        </pc:picChg>
        <pc:picChg chg="del mod">
          <ac:chgData name="Durães, Cecília" userId="8a818ba3-3ef8-416c-8969-302cb0ffa99c" providerId="ADAL" clId="{D1CF6AE8-3BA6-456C-BE3E-CFEC7E69C5E9}" dt="2022-09-21T11:38:54.872" v="641" actId="478"/>
          <ac:picMkLst>
            <pc:docMk/>
            <pc:sldMk cId="1260288373" sldId="260"/>
            <ac:picMk id="8" creationId="{88F66C4B-5E64-45AB-FE4D-A87FDB1E302F}"/>
          </ac:picMkLst>
        </pc:picChg>
        <pc:picChg chg="mod">
          <ac:chgData name="Durães, Cecília" userId="8a818ba3-3ef8-416c-8969-302cb0ffa99c" providerId="ADAL" clId="{D1CF6AE8-3BA6-456C-BE3E-CFEC7E69C5E9}" dt="2022-09-21T11:35:06.913" v="625"/>
          <ac:picMkLst>
            <pc:docMk/>
            <pc:sldMk cId="1260288373" sldId="260"/>
            <ac:picMk id="15" creationId="{1401C3F8-3623-7BB6-F347-513BEAA1BDF0}"/>
          </ac:picMkLst>
        </pc:picChg>
        <pc:picChg chg="del mod topLvl">
          <ac:chgData name="Durães, Cecília" userId="8a818ba3-3ef8-416c-8969-302cb0ffa99c" providerId="ADAL" clId="{D1CF6AE8-3BA6-456C-BE3E-CFEC7E69C5E9}" dt="2022-09-21T11:38:32.302" v="635" actId="478"/>
          <ac:picMkLst>
            <pc:docMk/>
            <pc:sldMk cId="1260288373" sldId="260"/>
            <ac:picMk id="43" creationId="{82EF6B77-7432-D936-7806-6AF9753DBFCF}"/>
          </ac:picMkLst>
        </pc:picChg>
        <pc:picChg chg="add del mod topLvl">
          <ac:chgData name="Durães, Cecília" userId="8a818ba3-3ef8-416c-8969-302cb0ffa99c" providerId="ADAL" clId="{D1CF6AE8-3BA6-456C-BE3E-CFEC7E69C5E9}" dt="2022-09-21T21:15:20.306" v="789" actId="478"/>
          <ac:picMkLst>
            <pc:docMk/>
            <pc:sldMk cId="1260288373" sldId="260"/>
            <ac:picMk id="50" creationId="{07EB0431-8AB2-C82E-6DC3-0849F6E2F58C}"/>
          </ac:picMkLst>
        </pc:picChg>
        <pc:picChg chg="mod">
          <ac:chgData name="Durães, Cecília" userId="8a818ba3-3ef8-416c-8969-302cb0ffa99c" providerId="ADAL" clId="{D1CF6AE8-3BA6-456C-BE3E-CFEC7E69C5E9}" dt="2022-09-21T11:42:17.825" v="716" actId="165"/>
          <ac:picMkLst>
            <pc:docMk/>
            <pc:sldMk cId="1260288373" sldId="260"/>
            <ac:picMk id="52" creationId="{62C69FC5-9C5C-D087-2555-556A65E09A55}"/>
          </ac:picMkLst>
        </pc:picChg>
        <pc:picChg chg="mod">
          <ac:chgData name="Durães, Cecília" userId="8a818ba3-3ef8-416c-8969-302cb0ffa99c" providerId="ADAL" clId="{D1CF6AE8-3BA6-456C-BE3E-CFEC7E69C5E9}" dt="2022-09-21T11:42:43.623" v="719"/>
          <ac:picMkLst>
            <pc:docMk/>
            <pc:sldMk cId="1260288373" sldId="260"/>
            <ac:picMk id="57" creationId="{5F531A0A-DDE7-2E86-BAD1-35764323134F}"/>
          </ac:picMkLst>
        </pc:picChg>
        <pc:picChg chg="mod">
          <ac:chgData name="Durães, Cecília" userId="8a818ba3-3ef8-416c-8969-302cb0ffa99c" providerId="ADAL" clId="{D1CF6AE8-3BA6-456C-BE3E-CFEC7E69C5E9}" dt="2022-09-21T11:42:43.623" v="719"/>
          <ac:picMkLst>
            <pc:docMk/>
            <pc:sldMk cId="1260288373" sldId="260"/>
            <ac:picMk id="60" creationId="{4952638B-1604-8B36-CE9D-5D76C5C473AD}"/>
          </ac:picMkLst>
        </pc:picChg>
        <pc:picChg chg="mod">
          <ac:chgData name="Durães, Cecília" userId="8a818ba3-3ef8-416c-8969-302cb0ffa99c" providerId="ADAL" clId="{D1CF6AE8-3BA6-456C-BE3E-CFEC7E69C5E9}" dt="2022-09-21T11:42:43.623" v="719"/>
          <ac:picMkLst>
            <pc:docMk/>
            <pc:sldMk cId="1260288373" sldId="260"/>
            <ac:picMk id="67" creationId="{3EF1B6A6-25F4-8E85-7CD9-9EF0BBB1ECC3}"/>
          </ac:picMkLst>
        </pc:picChg>
        <pc:picChg chg="mod">
          <ac:chgData name="Durães, Cecília" userId="8a818ba3-3ef8-416c-8969-302cb0ffa99c" providerId="ADAL" clId="{D1CF6AE8-3BA6-456C-BE3E-CFEC7E69C5E9}" dt="2022-09-21T11:42:43.623" v="719"/>
          <ac:picMkLst>
            <pc:docMk/>
            <pc:sldMk cId="1260288373" sldId="260"/>
            <ac:picMk id="95" creationId="{623286ED-52D0-9E48-1E09-D85FC2F76FD3}"/>
          </ac:picMkLst>
        </pc:picChg>
        <pc:picChg chg="mod">
          <ac:chgData name="Durães, Cecília" userId="8a818ba3-3ef8-416c-8969-302cb0ffa99c" providerId="ADAL" clId="{D1CF6AE8-3BA6-456C-BE3E-CFEC7E69C5E9}" dt="2022-09-21T11:43:05.539" v="721"/>
          <ac:picMkLst>
            <pc:docMk/>
            <pc:sldMk cId="1260288373" sldId="260"/>
            <ac:picMk id="100" creationId="{232A157D-F2D9-37B3-B041-922509E3887E}"/>
          </ac:picMkLst>
        </pc:picChg>
        <pc:picChg chg="del mod">
          <ac:chgData name="Durães, Cecília" userId="8a818ba3-3ef8-416c-8969-302cb0ffa99c" providerId="ADAL" clId="{D1CF6AE8-3BA6-456C-BE3E-CFEC7E69C5E9}" dt="2022-09-21T11:43:08.581" v="722" actId="478"/>
          <ac:picMkLst>
            <pc:docMk/>
            <pc:sldMk cId="1260288373" sldId="260"/>
            <ac:picMk id="103" creationId="{D64F9D60-8989-99FA-97D7-58736CF295CF}"/>
          </ac:picMkLst>
        </pc:picChg>
        <pc:picChg chg="add del mod">
          <ac:chgData name="Durães, Cecília" userId="8a818ba3-3ef8-416c-8969-302cb0ffa99c" providerId="ADAL" clId="{D1CF6AE8-3BA6-456C-BE3E-CFEC7E69C5E9}" dt="2022-09-21T21:16:13.547" v="803" actId="478"/>
          <ac:picMkLst>
            <pc:docMk/>
            <pc:sldMk cId="1260288373" sldId="260"/>
            <ac:picMk id="105" creationId="{FB63B58E-371C-A58E-6F7B-643BC7F0F32F}"/>
          </ac:picMkLst>
        </pc:picChg>
        <pc:picChg chg="mod">
          <ac:chgData name="Durães, Cecília" userId="8a818ba3-3ef8-416c-8969-302cb0ffa99c" providerId="ADAL" clId="{D1CF6AE8-3BA6-456C-BE3E-CFEC7E69C5E9}" dt="2022-09-21T21:15:35.377" v="790"/>
          <ac:picMkLst>
            <pc:docMk/>
            <pc:sldMk cId="1260288373" sldId="260"/>
            <ac:picMk id="112" creationId="{FE4EB2A7-DBAC-8B39-A984-A36F64C7257C}"/>
          </ac:picMkLst>
        </pc:picChg>
        <pc:picChg chg="mod">
          <ac:chgData name="Durães, Cecília" userId="8a818ba3-3ef8-416c-8969-302cb0ffa99c" providerId="ADAL" clId="{D1CF6AE8-3BA6-456C-BE3E-CFEC7E69C5E9}" dt="2022-09-21T21:15:35.377" v="790"/>
          <ac:picMkLst>
            <pc:docMk/>
            <pc:sldMk cId="1260288373" sldId="260"/>
            <ac:picMk id="140" creationId="{3FFF0C3D-A879-302C-5EF0-282054A47258}"/>
          </ac:picMkLst>
        </pc:picChg>
        <pc:picChg chg="mod">
          <ac:chgData name="Durães, Cecília" userId="8a818ba3-3ef8-416c-8969-302cb0ffa99c" providerId="ADAL" clId="{D1CF6AE8-3BA6-456C-BE3E-CFEC7E69C5E9}" dt="2022-09-21T21:15:47.829" v="792"/>
          <ac:picMkLst>
            <pc:docMk/>
            <pc:sldMk cId="1260288373" sldId="260"/>
            <ac:picMk id="149" creationId="{74BFF8DB-A1CF-8C8F-1D54-9B1B10445AB5}"/>
          </ac:picMkLst>
        </pc:picChg>
        <pc:picChg chg="del mod topLvl">
          <ac:chgData name="Durães, Cecília" userId="8a818ba3-3ef8-416c-8969-302cb0ffa99c" providerId="ADAL" clId="{D1CF6AE8-3BA6-456C-BE3E-CFEC7E69C5E9}" dt="2022-09-21T21:15:51.577" v="793" actId="478"/>
          <ac:picMkLst>
            <pc:docMk/>
            <pc:sldMk cId="1260288373" sldId="260"/>
            <ac:picMk id="177" creationId="{9D7172D2-27DE-6C93-5D7E-76FE91557477}"/>
          </ac:picMkLst>
        </pc:picChg>
        <pc:picChg chg="add del mod">
          <ac:chgData name="Durães, Cecília" userId="8a818ba3-3ef8-416c-8969-302cb0ffa99c" providerId="ADAL" clId="{D1CF6AE8-3BA6-456C-BE3E-CFEC7E69C5E9}" dt="2022-09-21T21:26:37.650" v="973" actId="478"/>
          <ac:picMkLst>
            <pc:docMk/>
            <pc:sldMk cId="1260288373" sldId="260"/>
            <ac:picMk id="181" creationId="{B6F741ED-C10D-0687-2DD9-8BF1DADD8EF4}"/>
          </ac:picMkLst>
        </pc:picChg>
        <pc:picChg chg="mod">
          <ac:chgData name="Durães, Cecília" userId="8a818ba3-3ef8-416c-8969-302cb0ffa99c" providerId="ADAL" clId="{D1CF6AE8-3BA6-456C-BE3E-CFEC7E69C5E9}" dt="2022-09-21T21:18:06.605" v="813"/>
          <ac:picMkLst>
            <pc:docMk/>
            <pc:sldMk cId="1260288373" sldId="260"/>
            <ac:picMk id="183" creationId="{8821C39C-11ED-44C7-44A5-02008DF389EB}"/>
          </ac:picMkLst>
        </pc:picChg>
        <pc:picChg chg="del mod">
          <ac:chgData name="Durães, Cecília" userId="8a818ba3-3ef8-416c-8969-302cb0ffa99c" providerId="ADAL" clId="{D1CF6AE8-3BA6-456C-BE3E-CFEC7E69C5E9}" dt="2022-09-21T21:18:09.611" v="814" actId="478"/>
          <ac:picMkLst>
            <pc:docMk/>
            <pc:sldMk cId="1260288373" sldId="260"/>
            <ac:picMk id="186" creationId="{D9F40C94-7B9E-B7B0-A2CA-6BAC4312CF69}"/>
          </ac:picMkLst>
        </pc:picChg>
        <pc:picChg chg="add mod">
          <ac:chgData name="Durães, Cecília" userId="8a818ba3-3ef8-416c-8969-302cb0ffa99c" providerId="ADAL" clId="{D1CF6AE8-3BA6-456C-BE3E-CFEC7E69C5E9}" dt="2022-09-21T21:21:17.883" v="941" actId="1076"/>
          <ac:picMkLst>
            <pc:docMk/>
            <pc:sldMk cId="1260288373" sldId="260"/>
            <ac:picMk id="189" creationId="{E10319A9-5E64-9D3A-961E-C460888D9C84}"/>
          </ac:picMkLst>
        </pc:picChg>
        <pc:picChg chg="mod">
          <ac:chgData name="Durães, Cecília" userId="8a818ba3-3ef8-416c-8969-302cb0ffa99c" providerId="ADAL" clId="{D1CF6AE8-3BA6-456C-BE3E-CFEC7E69C5E9}" dt="2022-09-21T21:28:02.075" v="993" actId="164"/>
          <ac:picMkLst>
            <pc:docMk/>
            <pc:sldMk cId="1260288373" sldId="260"/>
            <ac:picMk id="196" creationId="{2EC2D2A1-FD37-0B60-0278-CCF0E52AF56A}"/>
          </ac:picMkLst>
        </pc:picChg>
        <pc:picChg chg="del mod topLvl">
          <ac:chgData name="Durães, Cecília" userId="8a818ba3-3ef8-416c-8969-302cb0ffa99c" providerId="ADAL" clId="{D1CF6AE8-3BA6-456C-BE3E-CFEC7E69C5E9}" dt="2022-09-21T21:26:57.122" v="975" actId="478"/>
          <ac:picMkLst>
            <pc:docMk/>
            <pc:sldMk cId="1260288373" sldId="260"/>
            <ac:picMk id="224" creationId="{ED36C819-CE50-62CC-5C34-F103D7FD423C}"/>
          </ac:picMkLst>
        </pc:picChg>
        <pc:picChg chg="add del mod">
          <ac:chgData name="Durães, Cecília" userId="8a818ba3-3ef8-416c-8969-302cb0ffa99c" providerId="ADAL" clId="{D1CF6AE8-3BA6-456C-BE3E-CFEC7E69C5E9}" dt="2022-09-21T21:28:01.579" v="992"/>
          <ac:picMkLst>
            <pc:docMk/>
            <pc:sldMk cId="1260288373" sldId="260"/>
            <ac:picMk id="228" creationId="{04929B32-3AF2-848E-7AE0-06AB3BFCCC99}"/>
          </ac:picMkLst>
        </pc:picChg>
        <pc:picChg chg="add mod">
          <ac:chgData name="Durães, Cecília" userId="8a818ba3-3ef8-416c-8969-302cb0ffa99c" providerId="ADAL" clId="{D1CF6AE8-3BA6-456C-BE3E-CFEC7E69C5E9}" dt="2022-09-21T21:29:01.957" v="1023" actId="1076"/>
          <ac:picMkLst>
            <pc:docMk/>
            <pc:sldMk cId="1260288373" sldId="260"/>
            <ac:picMk id="229" creationId="{6AA028ED-B640-B3FE-B4FE-801CD7C9E704}"/>
          </ac:picMkLst>
        </pc:picChg>
        <pc:cxnChg chg="mod">
          <ac:chgData name="Durães, Cecília" userId="8a818ba3-3ef8-416c-8969-302cb0ffa99c" providerId="ADAL" clId="{D1CF6AE8-3BA6-456C-BE3E-CFEC7E69C5E9}" dt="2022-09-21T11:35:06.913" v="625"/>
          <ac:cxnSpMkLst>
            <pc:docMk/>
            <pc:sldMk cId="1260288373" sldId="260"/>
            <ac:cxnSpMk id="10" creationId="{0D6B83D6-EBC5-14B2-995C-83E6C8C2D60D}"/>
          </ac:cxnSpMkLst>
        </pc:cxnChg>
        <pc:cxnChg chg="mod">
          <ac:chgData name="Durães, Cecília" userId="8a818ba3-3ef8-416c-8969-302cb0ffa99c" providerId="ADAL" clId="{D1CF6AE8-3BA6-456C-BE3E-CFEC7E69C5E9}" dt="2022-09-21T11:35:06.913" v="625"/>
          <ac:cxnSpMkLst>
            <pc:docMk/>
            <pc:sldMk cId="1260288373" sldId="260"/>
            <ac:cxnSpMk id="11" creationId="{1EF683E3-CC53-205D-FF68-91D87057682B}"/>
          </ac:cxnSpMkLst>
        </pc:cxnChg>
        <pc:cxnChg chg="mod">
          <ac:chgData name="Durães, Cecília" userId="8a818ba3-3ef8-416c-8969-302cb0ffa99c" providerId="ADAL" clId="{D1CF6AE8-3BA6-456C-BE3E-CFEC7E69C5E9}" dt="2022-09-21T11:35:06.913" v="625"/>
          <ac:cxnSpMkLst>
            <pc:docMk/>
            <pc:sldMk cId="1260288373" sldId="260"/>
            <ac:cxnSpMk id="12" creationId="{BF913DE6-A9C1-CFB2-F078-291D54663AF1}"/>
          </ac:cxnSpMkLst>
        </pc:cxnChg>
        <pc:cxnChg chg="mod">
          <ac:chgData name="Durães, Cecília" userId="8a818ba3-3ef8-416c-8969-302cb0ffa99c" providerId="ADAL" clId="{D1CF6AE8-3BA6-456C-BE3E-CFEC7E69C5E9}" dt="2022-09-21T11:35:06.913" v="625"/>
          <ac:cxnSpMkLst>
            <pc:docMk/>
            <pc:sldMk cId="1260288373" sldId="260"/>
            <ac:cxnSpMk id="13" creationId="{BA0A7597-B945-62EF-C3FE-173AE7500F1E}"/>
          </ac:cxnSpMkLst>
        </pc:cxnChg>
        <pc:cxnChg chg="mod">
          <ac:chgData name="Durães, Cecília" userId="8a818ba3-3ef8-416c-8969-302cb0ffa99c" providerId="ADAL" clId="{D1CF6AE8-3BA6-456C-BE3E-CFEC7E69C5E9}" dt="2022-09-21T11:35:06.913" v="625"/>
          <ac:cxnSpMkLst>
            <pc:docMk/>
            <pc:sldMk cId="1260288373" sldId="260"/>
            <ac:cxnSpMk id="14" creationId="{C9464802-3252-8E31-2D8F-FEB2ADA92DA7}"/>
          </ac:cxnSpMkLst>
        </pc:cxnChg>
        <pc:cxnChg chg="add del mod">
          <ac:chgData name="Durães, Cecília" userId="8a818ba3-3ef8-416c-8969-302cb0ffa99c" providerId="ADAL" clId="{D1CF6AE8-3BA6-456C-BE3E-CFEC7E69C5E9}" dt="2022-09-21T11:38:19.534" v="634" actId="478"/>
          <ac:cxnSpMkLst>
            <pc:docMk/>
            <pc:sldMk cId="1260288373" sldId="260"/>
            <ac:cxnSpMk id="46" creationId="{4462C28B-4177-6D43-68D1-07F9FD8AAF83}"/>
          </ac:cxnSpMkLst>
        </pc:cxnChg>
        <pc:cxnChg chg="mod">
          <ac:chgData name="Durães, Cecília" userId="8a818ba3-3ef8-416c-8969-302cb0ffa99c" providerId="ADAL" clId="{D1CF6AE8-3BA6-456C-BE3E-CFEC7E69C5E9}" dt="2022-09-21T11:42:43.623" v="719"/>
          <ac:cxnSpMkLst>
            <pc:docMk/>
            <pc:sldMk cId="1260288373" sldId="260"/>
            <ac:cxnSpMk id="62" creationId="{4D173027-B00D-FC47-02E2-B4EBFF1A9EC0}"/>
          </ac:cxnSpMkLst>
        </pc:cxnChg>
        <pc:cxnChg chg="mod">
          <ac:chgData name="Durães, Cecília" userId="8a818ba3-3ef8-416c-8969-302cb0ffa99c" providerId="ADAL" clId="{D1CF6AE8-3BA6-456C-BE3E-CFEC7E69C5E9}" dt="2022-09-21T11:42:43.623" v="719"/>
          <ac:cxnSpMkLst>
            <pc:docMk/>
            <pc:sldMk cId="1260288373" sldId="260"/>
            <ac:cxnSpMk id="63" creationId="{8D97D85B-A694-816D-E029-11F2EB11E16F}"/>
          </ac:cxnSpMkLst>
        </pc:cxnChg>
        <pc:cxnChg chg="mod">
          <ac:chgData name="Durães, Cecília" userId="8a818ba3-3ef8-416c-8969-302cb0ffa99c" providerId="ADAL" clId="{D1CF6AE8-3BA6-456C-BE3E-CFEC7E69C5E9}" dt="2022-09-21T11:42:43.623" v="719"/>
          <ac:cxnSpMkLst>
            <pc:docMk/>
            <pc:sldMk cId="1260288373" sldId="260"/>
            <ac:cxnSpMk id="64" creationId="{732B41B7-ED5C-F4AF-7673-AC4A93CA0AE8}"/>
          </ac:cxnSpMkLst>
        </pc:cxnChg>
        <pc:cxnChg chg="mod">
          <ac:chgData name="Durães, Cecília" userId="8a818ba3-3ef8-416c-8969-302cb0ffa99c" providerId="ADAL" clId="{D1CF6AE8-3BA6-456C-BE3E-CFEC7E69C5E9}" dt="2022-09-21T11:42:43.623" v="719"/>
          <ac:cxnSpMkLst>
            <pc:docMk/>
            <pc:sldMk cId="1260288373" sldId="260"/>
            <ac:cxnSpMk id="65" creationId="{08A84E47-7CDB-D99D-F6C0-A2B7A93C31FC}"/>
          </ac:cxnSpMkLst>
        </pc:cxnChg>
        <pc:cxnChg chg="mod">
          <ac:chgData name="Durães, Cecília" userId="8a818ba3-3ef8-416c-8969-302cb0ffa99c" providerId="ADAL" clId="{D1CF6AE8-3BA6-456C-BE3E-CFEC7E69C5E9}" dt="2022-09-21T11:42:43.623" v="719"/>
          <ac:cxnSpMkLst>
            <pc:docMk/>
            <pc:sldMk cId="1260288373" sldId="260"/>
            <ac:cxnSpMk id="66" creationId="{FE4BA985-F84B-171D-E932-98A6AF1542B3}"/>
          </ac:cxnSpMkLst>
        </pc:cxnChg>
        <pc:cxnChg chg="add del mod">
          <ac:chgData name="Durães, Cecília" userId="8a818ba3-3ef8-416c-8969-302cb0ffa99c" providerId="ADAL" clId="{D1CF6AE8-3BA6-456C-BE3E-CFEC7E69C5E9}" dt="2022-09-21T11:42:47.079" v="720"/>
          <ac:cxnSpMkLst>
            <pc:docMk/>
            <pc:sldMk cId="1260288373" sldId="260"/>
            <ac:cxnSpMk id="98" creationId="{5FFFCBD8-E485-012D-4DF0-0498913C1CA8}"/>
          </ac:cxnSpMkLst>
        </pc:cxnChg>
        <pc:cxnChg chg="mod">
          <ac:chgData name="Durães, Cecília" userId="8a818ba3-3ef8-416c-8969-302cb0ffa99c" providerId="ADAL" clId="{D1CF6AE8-3BA6-456C-BE3E-CFEC7E69C5E9}" dt="2022-09-21T21:15:35.377" v="790"/>
          <ac:cxnSpMkLst>
            <pc:docMk/>
            <pc:sldMk cId="1260288373" sldId="260"/>
            <ac:cxnSpMk id="107" creationId="{639210FF-D19B-7E1C-291A-0A56066B0521}"/>
          </ac:cxnSpMkLst>
        </pc:cxnChg>
        <pc:cxnChg chg="mod">
          <ac:chgData name="Durães, Cecília" userId="8a818ba3-3ef8-416c-8969-302cb0ffa99c" providerId="ADAL" clId="{D1CF6AE8-3BA6-456C-BE3E-CFEC7E69C5E9}" dt="2022-09-21T21:15:35.377" v="790"/>
          <ac:cxnSpMkLst>
            <pc:docMk/>
            <pc:sldMk cId="1260288373" sldId="260"/>
            <ac:cxnSpMk id="108" creationId="{C922525F-832F-1C0F-491B-C2EB3FA012BE}"/>
          </ac:cxnSpMkLst>
        </pc:cxnChg>
        <pc:cxnChg chg="mod">
          <ac:chgData name="Durães, Cecília" userId="8a818ba3-3ef8-416c-8969-302cb0ffa99c" providerId="ADAL" clId="{D1CF6AE8-3BA6-456C-BE3E-CFEC7E69C5E9}" dt="2022-09-21T21:15:35.377" v="790"/>
          <ac:cxnSpMkLst>
            <pc:docMk/>
            <pc:sldMk cId="1260288373" sldId="260"/>
            <ac:cxnSpMk id="109" creationId="{7AB6E91B-7C94-882B-B986-4A1E3001BEC1}"/>
          </ac:cxnSpMkLst>
        </pc:cxnChg>
        <pc:cxnChg chg="mod">
          <ac:chgData name="Durães, Cecília" userId="8a818ba3-3ef8-416c-8969-302cb0ffa99c" providerId="ADAL" clId="{D1CF6AE8-3BA6-456C-BE3E-CFEC7E69C5E9}" dt="2022-09-21T21:15:35.377" v="790"/>
          <ac:cxnSpMkLst>
            <pc:docMk/>
            <pc:sldMk cId="1260288373" sldId="260"/>
            <ac:cxnSpMk id="110" creationId="{E9F6E13C-DCAA-7D5A-B9F4-E87773F3AE62}"/>
          </ac:cxnSpMkLst>
        </pc:cxnChg>
        <pc:cxnChg chg="mod">
          <ac:chgData name="Durães, Cecília" userId="8a818ba3-3ef8-416c-8969-302cb0ffa99c" providerId="ADAL" clId="{D1CF6AE8-3BA6-456C-BE3E-CFEC7E69C5E9}" dt="2022-09-21T21:15:35.377" v="790"/>
          <ac:cxnSpMkLst>
            <pc:docMk/>
            <pc:sldMk cId="1260288373" sldId="260"/>
            <ac:cxnSpMk id="111" creationId="{2FD5EB51-2D7D-44FD-CCBE-E71A0F5D5431}"/>
          </ac:cxnSpMkLst>
        </pc:cxnChg>
        <pc:cxnChg chg="add del mod">
          <ac:chgData name="Durães, Cecília" userId="8a818ba3-3ef8-416c-8969-302cb0ffa99c" providerId="ADAL" clId="{D1CF6AE8-3BA6-456C-BE3E-CFEC7E69C5E9}" dt="2022-09-21T21:15:38.419" v="791"/>
          <ac:cxnSpMkLst>
            <pc:docMk/>
            <pc:sldMk cId="1260288373" sldId="260"/>
            <ac:cxnSpMk id="142" creationId="{A377F578-E154-0639-FB31-2C0DFDBEACAF}"/>
          </ac:cxnSpMkLst>
        </pc:cxnChg>
        <pc:cxnChg chg="mod">
          <ac:chgData name="Durães, Cecília" userId="8a818ba3-3ef8-416c-8969-302cb0ffa99c" providerId="ADAL" clId="{D1CF6AE8-3BA6-456C-BE3E-CFEC7E69C5E9}" dt="2022-09-21T21:15:47.829" v="792"/>
          <ac:cxnSpMkLst>
            <pc:docMk/>
            <pc:sldMk cId="1260288373" sldId="260"/>
            <ac:cxnSpMk id="144" creationId="{2E3B71D6-EEDD-70B8-15E7-29FE66C89B6B}"/>
          </ac:cxnSpMkLst>
        </pc:cxnChg>
        <pc:cxnChg chg="mod">
          <ac:chgData name="Durães, Cecília" userId="8a818ba3-3ef8-416c-8969-302cb0ffa99c" providerId="ADAL" clId="{D1CF6AE8-3BA6-456C-BE3E-CFEC7E69C5E9}" dt="2022-09-21T21:15:47.829" v="792"/>
          <ac:cxnSpMkLst>
            <pc:docMk/>
            <pc:sldMk cId="1260288373" sldId="260"/>
            <ac:cxnSpMk id="145" creationId="{A59ED7E2-A490-06DF-C99C-BE7FA93EFC42}"/>
          </ac:cxnSpMkLst>
        </pc:cxnChg>
        <pc:cxnChg chg="mod">
          <ac:chgData name="Durães, Cecília" userId="8a818ba3-3ef8-416c-8969-302cb0ffa99c" providerId="ADAL" clId="{D1CF6AE8-3BA6-456C-BE3E-CFEC7E69C5E9}" dt="2022-09-21T21:15:47.829" v="792"/>
          <ac:cxnSpMkLst>
            <pc:docMk/>
            <pc:sldMk cId="1260288373" sldId="260"/>
            <ac:cxnSpMk id="146" creationId="{0E6046D8-EB75-B362-9CB1-3B8A647AB293}"/>
          </ac:cxnSpMkLst>
        </pc:cxnChg>
        <pc:cxnChg chg="mod">
          <ac:chgData name="Durães, Cecília" userId="8a818ba3-3ef8-416c-8969-302cb0ffa99c" providerId="ADAL" clId="{D1CF6AE8-3BA6-456C-BE3E-CFEC7E69C5E9}" dt="2022-09-21T21:15:47.829" v="792"/>
          <ac:cxnSpMkLst>
            <pc:docMk/>
            <pc:sldMk cId="1260288373" sldId="260"/>
            <ac:cxnSpMk id="147" creationId="{E87D2EB0-36E7-A2E9-24E3-ADE9DE090210}"/>
          </ac:cxnSpMkLst>
        </pc:cxnChg>
        <pc:cxnChg chg="mod">
          <ac:chgData name="Durães, Cecília" userId="8a818ba3-3ef8-416c-8969-302cb0ffa99c" providerId="ADAL" clId="{D1CF6AE8-3BA6-456C-BE3E-CFEC7E69C5E9}" dt="2022-09-21T21:15:47.829" v="792"/>
          <ac:cxnSpMkLst>
            <pc:docMk/>
            <pc:sldMk cId="1260288373" sldId="260"/>
            <ac:cxnSpMk id="148" creationId="{F559FE48-0721-784C-A50B-2CADDB0C3059}"/>
          </ac:cxnSpMkLst>
        </pc:cxnChg>
        <pc:cxnChg chg="add del mod">
          <ac:chgData name="Durães, Cecília" userId="8a818ba3-3ef8-416c-8969-302cb0ffa99c" providerId="ADAL" clId="{D1CF6AE8-3BA6-456C-BE3E-CFEC7E69C5E9}" dt="2022-09-21T21:16:15.151" v="804" actId="478"/>
          <ac:cxnSpMkLst>
            <pc:docMk/>
            <pc:sldMk cId="1260288373" sldId="260"/>
            <ac:cxnSpMk id="179" creationId="{08E06B44-4F5E-BCEE-2EE1-D642A1705FBC}"/>
          </ac:cxnSpMkLst>
        </pc:cxnChg>
        <pc:cxnChg chg="mod">
          <ac:chgData name="Durães, Cecília" userId="8a818ba3-3ef8-416c-8969-302cb0ffa99c" providerId="ADAL" clId="{D1CF6AE8-3BA6-456C-BE3E-CFEC7E69C5E9}" dt="2022-09-21T21:28:02.075" v="993" actId="164"/>
          <ac:cxnSpMkLst>
            <pc:docMk/>
            <pc:sldMk cId="1260288373" sldId="260"/>
            <ac:cxnSpMk id="191" creationId="{475A4D8E-A1EC-0326-409A-8DC2770AAB59}"/>
          </ac:cxnSpMkLst>
        </pc:cxnChg>
        <pc:cxnChg chg="mod">
          <ac:chgData name="Durães, Cecília" userId="8a818ba3-3ef8-416c-8969-302cb0ffa99c" providerId="ADAL" clId="{D1CF6AE8-3BA6-456C-BE3E-CFEC7E69C5E9}" dt="2022-09-21T21:28:02.075" v="993" actId="164"/>
          <ac:cxnSpMkLst>
            <pc:docMk/>
            <pc:sldMk cId="1260288373" sldId="260"/>
            <ac:cxnSpMk id="192" creationId="{A88D2F0C-9CCA-62B5-A4D6-68FBBA88818B}"/>
          </ac:cxnSpMkLst>
        </pc:cxnChg>
        <pc:cxnChg chg="mod">
          <ac:chgData name="Durães, Cecília" userId="8a818ba3-3ef8-416c-8969-302cb0ffa99c" providerId="ADAL" clId="{D1CF6AE8-3BA6-456C-BE3E-CFEC7E69C5E9}" dt="2022-09-21T21:28:02.075" v="993" actId="164"/>
          <ac:cxnSpMkLst>
            <pc:docMk/>
            <pc:sldMk cId="1260288373" sldId="260"/>
            <ac:cxnSpMk id="193" creationId="{B321EB41-6C1D-7E35-7AC2-A2626A24C8D0}"/>
          </ac:cxnSpMkLst>
        </pc:cxnChg>
        <pc:cxnChg chg="mod">
          <ac:chgData name="Durães, Cecília" userId="8a818ba3-3ef8-416c-8969-302cb0ffa99c" providerId="ADAL" clId="{D1CF6AE8-3BA6-456C-BE3E-CFEC7E69C5E9}" dt="2022-09-21T21:28:02.075" v="993" actId="164"/>
          <ac:cxnSpMkLst>
            <pc:docMk/>
            <pc:sldMk cId="1260288373" sldId="260"/>
            <ac:cxnSpMk id="194" creationId="{988C4358-E898-A621-AE2A-A1C6C97E2CC1}"/>
          </ac:cxnSpMkLst>
        </pc:cxnChg>
        <pc:cxnChg chg="mod">
          <ac:chgData name="Durães, Cecília" userId="8a818ba3-3ef8-416c-8969-302cb0ffa99c" providerId="ADAL" clId="{D1CF6AE8-3BA6-456C-BE3E-CFEC7E69C5E9}" dt="2022-09-21T21:28:02.075" v="993" actId="164"/>
          <ac:cxnSpMkLst>
            <pc:docMk/>
            <pc:sldMk cId="1260288373" sldId="260"/>
            <ac:cxnSpMk id="195" creationId="{2229D197-BD53-F39E-DA44-C0F28D63D43D}"/>
          </ac:cxnSpMkLst>
        </pc:cxnChg>
        <pc:cxnChg chg="add del mod">
          <ac:chgData name="Durães, Cecília" userId="8a818ba3-3ef8-416c-8969-302cb0ffa99c" providerId="ADAL" clId="{D1CF6AE8-3BA6-456C-BE3E-CFEC7E69C5E9}" dt="2022-09-21T21:28:35.271" v="1015" actId="478"/>
          <ac:cxnSpMkLst>
            <pc:docMk/>
            <pc:sldMk cId="1260288373" sldId="260"/>
            <ac:cxnSpMk id="226" creationId="{31ED4460-60A1-42DC-ECB3-04C673D59971}"/>
          </ac:cxnSpMkLst>
        </pc:cxnChg>
      </pc:sldChg>
      <pc:sldChg chg="addSp delSp modSp add mod">
        <pc:chgData name="Durães, Cecília" userId="8a818ba3-3ef8-416c-8969-302cb0ffa99c" providerId="ADAL" clId="{D1CF6AE8-3BA6-456C-BE3E-CFEC7E69C5E9}" dt="2022-09-22T17:45:16.451" v="1129" actId="1076"/>
        <pc:sldMkLst>
          <pc:docMk/>
          <pc:sldMk cId="499513409" sldId="261"/>
        </pc:sldMkLst>
        <pc:spChg chg="mod">
          <ac:chgData name="Durães, Cecília" userId="8a818ba3-3ef8-416c-8969-302cb0ffa99c" providerId="ADAL" clId="{D1CF6AE8-3BA6-456C-BE3E-CFEC7E69C5E9}" dt="2022-09-22T17:45:16.451" v="1129" actId="1076"/>
          <ac:spMkLst>
            <pc:docMk/>
            <pc:sldMk cId="499513409" sldId="261"/>
            <ac:spMk id="47" creationId="{3C526D3F-C3DE-E62C-7B27-33059908DF72}"/>
          </ac:spMkLst>
        </pc:spChg>
        <pc:spChg chg="del">
          <ac:chgData name="Durães, Cecília" userId="8a818ba3-3ef8-416c-8969-302cb0ffa99c" providerId="ADAL" clId="{D1CF6AE8-3BA6-456C-BE3E-CFEC7E69C5E9}" dt="2022-09-22T17:44:10.352" v="1113" actId="478"/>
          <ac:spMkLst>
            <pc:docMk/>
            <pc:sldMk cId="499513409" sldId="261"/>
            <ac:spMk id="48" creationId="{9E86529D-3CB4-F6D7-C536-9477C95AD240}"/>
          </ac:spMkLst>
        </pc:spChg>
        <pc:spChg chg="del mod">
          <ac:chgData name="Durães, Cecília" userId="8a818ba3-3ef8-416c-8969-302cb0ffa99c" providerId="ADAL" clId="{D1CF6AE8-3BA6-456C-BE3E-CFEC7E69C5E9}" dt="2022-09-22T17:44:21.984" v="1118"/>
          <ac:spMkLst>
            <pc:docMk/>
            <pc:sldMk cId="499513409" sldId="261"/>
            <ac:spMk id="49" creationId="{628F312C-AF75-60FA-B308-BD20D3089C31}"/>
          </ac:spMkLst>
        </pc:spChg>
        <pc:picChg chg="add mod">
          <ac:chgData name="Durães, Cecília" userId="8a818ba3-3ef8-416c-8969-302cb0ffa99c" providerId="ADAL" clId="{D1CF6AE8-3BA6-456C-BE3E-CFEC7E69C5E9}" dt="2022-09-22T17:44:31.639" v="1122" actId="1076"/>
          <ac:picMkLst>
            <pc:docMk/>
            <pc:sldMk cId="499513409" sldId="261"/>
            <ac:picMk id="2" creationId="{711A0ABA-A528-E9C7-3B57-4435481C76A8}"/>
          </ac:picMkLst>
        </pc:picChg>
        <pc:picChg chg="del">
          <ac:chgData name="Durães, Cecília" userId="8a818ba3-3ef8-416c-8969-302cb0ffa99c" providerId="ADAL" clId="{D1CF6AE8-3BA6-456C-BE3E-CFEC7E69C5E9}" dt="2022-09-22T17:44:09.485" v="1112" actId="478"/>
          <ac:picMkLst>
            <pc:docMk/>
            <pc:sldMk cId="499513409" sldId="261"/>
            <ac:picMk id="189" creationId="{E10319A9-5E64-9D3A-961E-C460888D9C84}"/>
          </ac:picMkLst>
        </pc:picChg>
        <pc:picChg chg="del">
          <ac:chgData name="Durães, Cecília" userId="8a818ba3-3ef8-416c-8969-302cb0ffa99c" providerId="ADAL" clId="{D1CF6AE8-3BA6-456C-BE3E-CFEC7E69C5E9}" dt="2022-09-22T17:44:08.563" v="1111" actId="478"/>
          <ac:picMkLst>
            <pc:docMk/>
            <pc:sldMk cId="499513409" sldId="261"/>
            <ac:picMk id="229" creationId="{6AA028ED-B640-B3FE-B4FE-801CD7C9E704}"/>
          </ac:picMkLst>
        </pc:picChg>
      </pc:sldChg>
    </pc:docChg>
  </pc:docChgLst>
  <pc:docChgLst>
    <pc:chgData name="Durães, Cecília" userId="8a818ba3-3ef8-416c-8969-302cb0ffa99c" providerId="ADAL" clId="{2526F1D1-A1CB-4469-A19F-896F090AB82E}"/>
    <pc:docChg chg="undo custSel addSld delSld modSld">
      <pc:chgData name="Durães, Cecília" userId="8a818ba3-3ef8-416c-8969-302cb0ffa99c" providerId="ADAL" clId="{2526F1D1-A1CB-4469-A19F-896F090AB82E}" dt="2023-02-21T18:33:12.446" v="169"/>
      <pc:docMkLst>
        <pc:docMk/>
      </pc:docMkLst>
      <pc:sldChg chg="modSp mod">
        <pc:chgData name="Durães, Cecília" userId="8a818ba3-3ef8-416c-8969-302cb0ffa99c" providerId="ADAL" clId="{2526F1D1-A1CB-4469-A19F-896F090AB82E}" dt="2023-02-20T16:10:44.177" v="34" actId="20577"/>
        <pc:sldMkLst>
          <pc:docMk/>
          <pc:sldMk cId="773699883" sldId="256"/>
        </pc:sldMkLst>
        <pc:spChg chg="mod">
          <ac:chgData name="Durães, Cecília" userId="8a818ba3-3ef8-416c-8969-302cb0ffa99c" providerId="ADAL" clId="{2526F1D1-A1CB-4469-A19F-896F090AB82E}" dt="2023-02-20T16:10:44.177" v="34" actId="20577"/>
          <ac:spMkLst>
            <pc:docMk/>
            <pc:sldMk cId="773699883" sldId="256"/>
            <ac:spMk id="58" creationId="{2343FFA6-5BB5-61DA-2524-406F466E9EE2}"/>
          </ac:spMkLst>
        </pc:spChg>
      </pc:sldChg>
      <pc:sldChg chg="addSp delSp modSp mod">
        <pc:chgData name="Durães, Cecília" userId="8a818ba3-3ef8-416c-8969-302cb0ffa99c" providerId="ADAL" clId="{2526F1D1-A1CB-4469-A19F-896F090AB82E}" dt="2023-02-20T09:31:56.690" v="22" actId="1076"/>
        <pc:sldMkLst>
          <pc:docMk/>
          <pc:sldMk cId="2888505620" sldId="257"/>
        </pc:sldMkLst>
        <pc:graphicFrameChg chg="add del mod">
          <ac:chgData name="Durães, Cecília" userId="8a818ba3-3ef8-416c-8969-302cb0ffa99c" providerId="ADAL" clId="{2526F1D1-A1CB-4469-A19F-896F090AB82E}" dt="2023-02-20T09:29:17.652" v="6"/>
          <ac:graphicFrameMkLst>
            <pc:docMk/>
            <pc:sldMk cId="2888505620" sldId="257"/>
            <ac:graphicFrameMk id="2" creationId="{F6FB28C9-0F24-2E24-ABB0-69001812C9FE}"/>
          </ac:graphicFrameMkLst>
        </pc:graphicFrameChg>
        <pc:picChg chg="add del mod">
          <ac:chgData name="Durães, Cecília" userId="8a818ba3-3ef8-416c-8969-302cb0ffa99c" providerId="ADAL" clId="{2526F1D1-A1CB-4469-A19F-896F090AB82E}" dt="2023-02-20T09:31:56.690" v="22" actId="1076"/>
          <ac:picMkLst>
            <pc:docMk/>
            <pc:sldMk cId="2888505620" sldId="257"/>
            <ac:picMk id="3" creationId="{D591EE17-5416-7C1E-8197-E77040CB2581}"/>
          </ac:picMkLst>
        </pc:picChg>
        <pc:picChg chg="add del mod">
          <ac:chgData name="Durães, Cecília" userId="8a818ba3-3ef8-416c-8969-302cb0ffa99c" providerId="ADAL" clId="{2526F1D1-A1CB-4469-A19F-896F090AB82E}" dt="2023-02-20T09:31:52.143" v="20"/>
          <ac:picMkLst>
            <pc:docMk/>
            <pc:sldMk cId="2888505620" sldId="257"/>
            <ac:picMk id="4" creationId="{7D0CF219-1909-EEE4-3D25-167496A88B42}"/>
          </ac:picMkLst>
        </pc:picChg>
      </pc:sldChg>
      <pc:sldChg chg="addSp delSp modSp mod delCm">
        <pc:chgData name="Durães, Cecília" userId="8a818ba3-3ef8-416c-8969-302cb0ffa99c" providerId="ADAL" clId="{2526F1D1-A1CB-4469-A19F-896F090AB82E}" dt="2023-02-21T18:33:12.446" v="169"/>
        <pc:sldMkLst>
          <pc:docMk/>
          <pc:sldMk cId="1260288373" sldId="260"/>
        </pc:sldMkLst>
        <pc:spChg chg="add del mod">
          <ac:chgData name="Durães, Cecília" userId="8a818ba3-3ef8-416c-8969-302cb0ffa99c" providerId="ADAL" clId="{2526F1D1-A1CB-4469-A19F-896F090AB82E}" dt="2023-02-21T16:25:29.860" v="49" actId="478"/>
          <ac:spMkLst>
            <pc:docMk/>
            <pc:sldMk cId="1260288373" sldId="260"/>
            <ac:spMk id="2" creationId="{6877A2DE-02BC-161B-5F67-240EDF4EA956}"/>
          </ac:spMkLst>
        </pc:spChg>
        <pc:spChg chg="del">
          <ac:chgData name="Durães, Cecília" userId="8a818ba3-3ef8-416c-8969-302cb0ffa99c" providerId="ADAL" clId="{2526F1D1-A1CB-4469-A19F-896F090AB82E}" dt="2023-02-17T17:18:26.675" v="0" actId="478"/>
          <ac:spMkLst>
            <pc:docMk/>
            <pc:sldMk cId="1260288373" sldId="260"/>
            <ac:spMk id="3" creationId="{122816F9-49B1-3202-80F4-987AB82F1DB8}"/>
          </ac:spMkLst>
        </pc:spChg>
        <pc:spChg chg="add del mod">
          <ac:chgData name="Durães, Cecília" userId="8a818ba3-3ef8-416c-8969-302cb0ffa99c" providerId="ADAL" clId="{2526F1D1-A1CB-4469-A19F-896F090AB82E}" dt="2023-02-21T16:25:27.467" v="48" actId="478"/>
          <ac:spMkLst>
            <pc:docMk/>
            <pc:sldMk cId="1260288373" sldId="260"/>
            <ac:spMk id="4" creationId="{F054A696-410C-862D-676C-2E32F8A900F8}"/>
          </ac:spMkLst>
        </pc:spChg>
        <pc:spChg chg="mod">
          <ac:chgData name="Durães, Cecília" userId="8a818ba3-3ef8-416c-8969-302cb0ffa99c" providerId="ADAL" clId="{2526F1D1-A1CB-4469-A19F-896F090AB82E}" dt="2023-02-21T16:29:03.375" v="69" actId="20577"/>
          <ac:spMkLst>
            <pc:docMk/>
            <pc:sldMk cId="1260288373" sldId="260"/>
            <ac:spMk id="47" creationId="{3C526D3F-C3DE-E62C-7B27-33059908DF72}"/>
          </ac:spMkLst>
        </pc:spChg>
        <pc:picChg chg="add del mod">
          <ac:chgData name="Durães, Cecília" userId="8a818ba3-3ef8-416c-8969-302cb0ffa99c" providerId="ADAL" clId="{2526F1D1-A1CB-4469-A19F-896F090AB82E}" dt="2023-02-21T16:24:25.190" v="43"/>
          <ac:picMkLst>
            <pc:docMk/>
            <pc:sldMk cId="1260288373" sldId="260"/>
            <ac:picMk id="5" creationId="{AE812D74-389C-971E-E574-D9AB02AED894}"/>
          </ac:picMkLst>
        </pc:picChg>
        <pc:picChg chg="add del mod">
          <ac:chgData name="Durães, Cecília" userId="8a818ba3-3ef8-416c-8969-302cb0ffa99c" providerId="ADAL" clId="{2526F1D1-A1CB-4469-A19F-896F090AB82E}" dt="2023-02-21T16:27:04.942" v="58" actId="478"/>
          <ac:picMkLst>
            <pc:docMk/>
            <pc:sldMk cId="1260288373" sldId="260"/>
            <ac:picMk id="6" creationId="{17A422B8-0DE7-4F76-9D63-F0DC5CFF93C7}"/>
          </ac:picMkLst>
        </pc:picChg>
        <pc:picChg chg="add mod">
          <ac:chgData name="Durães, Cecília" userId="8a818ba3-3ef8-416c-8969-302cb0ffa99c" providerId="ADAL" clId="{2526F1D1-A1CB-4469-A19F-896F090AB82E}" dt="2023-02-21T16:28:30.231" v="65" actId="1076"/>
          <ac:picMkLst>
            <pc:docMk/>
            <pc:sldMk cId="1260288373" sldId="260"/>
            <ac:picMk id="7" creationId="{666230B7-00B0-8BDC-7D9E-67F31B65594D}"/>
          </ac:picMkLst>
        </pc:picChg>
        <pc:picChg chg="add del mod">
          <ac:chgData name="Durães, Cecília" userId="8a818ba3-3ef8-416c-8969-302cb0ffa99c" providerId="ADAL" clId="{2526F1D1-A1CB-4469-A19F-896F090AB82E}" dt="2023-02-21T16:28:10.239" v="59" actId="478"/>
          <ac:picMkLst>
            <pc:docMk/>
            <pc:sldMk cId="1260288373" sldId="260"/>
            <ac:picMk id="229" creationId="{6AA028ED-B640-B3FE-B4FE-801CD7C9E704}"/>
          </ac:picMkLst>
        </pc:picChg>
      </pc:sldChg>
      <pc:sldChg chg="addSp delSp modSp mod delCm">
        <pc:chgData name="Durães, Cecília" userId="8a818ba3-3ef8-416c-8969-302cb0ffa99c" providerId="ADAL" clId="{2526F1D1-A1CB-4469-A19F-896F090AB82E}" dt="2023-02-21T18:33:07.112" v="168"/>
        <pc:sldMkLst>
          <pc:docMk/>
          <pc:sldMk cId="499513409" sldId="261"/>
        </pc:sldMkLst>
        <pc:spChg chg="mod">
          <ac:chgData name="Durães, Cecília" userId="8a818ba3-3ef8-416c-8969-302cb0ffa99c" providerId="ADAL" clId="{2526F1D1-A1CB-4469-A19F-896F090AB82E}" dt="2023-02-21T18:32:42.202" v="167" actId="14100"/>
          <ac:spMkLst>
            <pc:docMk/>
            <pc:sldMk cId="499513409" sldId="261"/>
            <ac:spMk id="47" creationId="{3C526D3F-C3DE-E62C-7B27-33059908DF72}"/>
          </ac:spMkLst>
        </pc:spChg>
        <pc:graphicFrameChg chg="add mod">
          <ac:chgData name="Durães, Cecília" userId="8a818ba3-3ef8-416c-8969-302cb0ffa99c" providerId="ADAL" clId="{2526F1D1-A1CB-4469-A19F-896F090AB82E}" dt="2023-02-21T18:29:28.206" v="72" actId="1076"/>
          <ac:graphicFrameMkLst>
            <pc:docMk/>
            <pc:sldMk cId="499513409" sldId="261"/>
            <ac:graphicFrameMk id="3" creationId="{B655F07F-1AEE-CEED-ADFA-6605612512FE}"/>
          </ac:graphicFrameMkLst>
        </pc:graphicFrameChg>
        <pc:picChg chg="del">
          <ac:chgData name="Durães, Cecília" userId="8a818ba3-3ef8-416c-8969-302cb0ffa99c" providerId="ADAL" clId="{2526F1D1-A1CB-4469-A19F-896F090AB82E}" dt="2023-02-21T18:29:18.671" v="70" actId="478"/>
          <ac:picMkLst>
            <pc:docMk/>
            <pc:sldMk cId="499513409" sldId="261"/>
            <ac:picMk id="2" creationId="{711A0ABA-A528-E9C7-3B57-4435481C76A8}"/>
          </ac:picMkLst>
        </pc:picChg>
      </pc:sldChg>
      <pc:sldChg chg="delSp new del mod">
        <pc:chgData name="Durães, Cecília" userId="8a818ba3-3ef8-416c-8969-302cb0ffa99c" providerId="ADAL" clId="{2526F1D1-A1CB-4469-A19F-896F090AB82E}" dt="2023-02-21T09:29:59.706" v="35" actId="2696"/>
        <pc:sldMkLst>
          <pc:docMk/>
          <pc:sldMk cId="2908160677" sldId="262"/>
        </pc:sldMkLst>
        <pc:spChg chg="del">
          <ac:chgData name="Durães, Cecília" userId="8a818ba3-3ef8-416c-8969-302cb0ffa99c" providerId="ADAL" clId="{2526F1D1-A1CB-4469-A19F-896F090AB82E}" dt="2023-02-20T09:32:05.916" v="24" actId="478"/>
          <ac:spMkLst>
            <pc:docMk/>
            <pc:sldMk cId="2908160677" sldId="262"/>
            <ac:spMk id="2" creationId="{5E4034A9-6F16-2CAE-E2B7-BB9706C17789}"/>
          </ac:spMkLst>
        </pc:spChg>
        <pc:spChg chg="del">
          <ac:chgData name="Durães, Cecília" userId="8a818ba3-3ef8-416c-8969-302cb0ffa99c" providerId="ADAL" clId="{2526F1D1-A1CB-4469-A19F-896F090AB82E}" dt="2023-02-20T09:32:07.466" v="25" actId="478"/>
          <ac:spMkLst>
            <pc:docMk/>
            <pc:sldMk cId="2908160677" sldId="262"/>
            <ac:spMk id="3" creationId="{E1491671-4F82-C370-7384-8273E4C461D9}"/>
          </ac:spMkLst>
        </pc:spChg>
      </pc:sldChg>
    </pc:docChg>
  </pc:docChgLst>
  <pc:docChgLst>
    <pc:chgData name="Jermann, Philip" userId="e10035d5-5694-4da2-b251-c7f1ed8245bc" providerId="ADAL" clId="{8923375E-8D5E-49B9-9B43-933FA9322452}"/>
    <pc:docChg chg="modSld">
      <pc:chgData name="Jermann, Philip" userId="e10035d5-5694-4da2-b251-c7f1ed8245bc" providerId="ADAL" clId="{8923375E-8D5E-49B9-9B43-933FA9322452}" dt="2023-03-06T09:43:19.982" v="103" actId="1036"/>
      <pc:docMkLst>
        <pc:docMk/>
      </pc:docMkLst>
      <pc:sldChg chg="delSp modSp mod modAnim">
        <pc:chgData name="Jermann, Philip" userId="e10035d5-5694-4da2-b251-c7f1ed8245bc" providerId="ADAL" clId="{8923375E-8D5E-49B9-9B43-933FA9322452}" dt="2023-03-06T09:43:19.982" v="103" actId="1036"/>
        <pc:sldMkLst>
          <pc:docMk/>
          <pc:sldMk cId="252456774" sldId="258"/>
        </pc:sldMkLst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5" creationId="{A6301960-04F4-829E-E43C-60437611436D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6" creationId="{A252CA84-2447-E641-611C-66053315389C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7" creationId="{2E4ABB1F-38E6-7195-D099-5141F0D2B232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8" creationId="{EB771D18-7D91-E007-F233-40FC66B67399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9" creationId="{3E331E0F-3D5D-AFCA-F2FD-D46E3AE43280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10" creationId="{D0E0DB97-C0FD-6E34-8591-82BDEAB301BD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11" creationId="{F4CF79F0-9EA6-F59B-AD49-9B27860812FE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12" creationId="{88F17190-4A51-FD13-DF3A-33E3740CA042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13" creationId="{2A7718F4-A025-021B-3672-9B5D5AC17285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14" creationId="{68A13415-934C-CF9E-1AA2-B9153DAA854C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15" creationId="{584DEC1D-1004-464F-1D38-7D9C8972738C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16" creationId="{13603BCF-B6B5-901E-7C76-B4A0545885B0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17" creationId="{09E0181E-E9F0-8D8D-D2E3-E45D80273173}"/>
          </ac:spMkLst>
        </pc:spChg>
        <pc:spChg chg="mod topLvl">
          <ac:chgData name="Jermann, Philip" userId="e10035d5-5694-4da2-b251-c7f1ed8245bc" providerId="ADAL" clId="{8923375E-8D5E-49B9-9B43-933FA9322452}" dt="2023-03-06T09:43:19.982" v="103" actId="1036"/>
          <ac:spMkLst>
            <pc:docMk/>
            <pc:sldMk cId="252456774" sldId="258"/>
            <ac:spMk id="18" creationId="{0E27259C-F751-4250-F7E5-F3FBA0A4E714}"/>
          </ac:spMkLst>
        </pc:spChg>
        <pc:spChg chg="mod">
          <ac:chgData name="Jermann, Philip" userId="e10035d5-5694-4da2-b251-c7f1ed8245bc" providerId="ADAL" clId="{8923375E-8D5E-49B9-9B43-933FA9322452}" dt="2023-03-06T09:43:01.586" v="79" actId="6549"/>
          <ac:spMkLst>
            <pc:docMk/>
            <pc:sldMk cId="252456774" sldId="258"/>
            <ac:spMk id="20" creationId="{D138C943-4A0B-6EC8-FA56-848F1AED2824}"/>
          </ac:spMkLst>
        </pc:spChg>
        <pc:grpChg chg="del mod">
          <ac:chgData name="Jermann, Philip" userId="e10035d5-5694-4da2-b251-c7f1ed8245bc" providerId="ADAL" clId="{8923375E-8D5E-49B9-9B43-933FA9322452}" dt="2023-03-06T09:42:02.153" v="40" actId="165"/>
          <ac:grpSpMkLst>
            <pc:docMk/>
            <pc:sldMk cId="252456774" sldId="258"/>
            <ac:grpSpMk id="4" creationId="{6A5C09B1-FC82-397B-B62F-E680D2017A7D}"/>
          </ac:grpSpMkLst>
        </pc:grpChg>
      </pc:sldChg>
    </pc:docChg>
  </pc:docChgLst>
  <pc:docChgLst>
    <pc:chgData name="Jermann, Philip" userId="e10035d5-5694-4da2-b251-c7f1ed8245bc" providerId="ADAL" clId="{A47126F1-0408-4D63-8D1F-44ACA5FE5673}"/>
    <pc:docChg chg="undo custSel modSld">
      <pc:chgData name="Jermann, Philip" userId="e10035d5-5694-4da2-b251-c7f1ed8245bc" providerId="ADAL" clId="{A47126F1-0408-4D63-8D1F-44ACA5FE5673}" dt="2023-08-28T14:34:34.078" v="3" actId="1076"/>
      <pc:docMkLst>
        <pc:docMk/>
      </pc:docMkLst>
      <pc:sldChg chg="addSp delSp modSp mod modAnim">
        <pc:chgData name="Jermann, Philip" userId="e10035d5-5694-4da2-b251-c7f1ed8245bc" providerId="ADAL" clId="{A47126F1-0408-4D63-8D1F-44ACA5FE5673}" dt="2023-08-28T14:34:34.078" v="3" actId="1076"/>
        <pc:sldMkLst>
          <pc:docMk/>
          <pc:sldMk cId="252456774" sldId="258"/>
        </pc:sldMkLst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4" creationId="{8339F896-216F-4512-B487-A2471AF5995C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28" creationId="{1CA1E247-E7C0-E266-E20E-99CC73619A67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31" creationId="{1FA10264-028C-9925-BF2C-D546ADAACBE6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41" creationId="{90892C10-D7B3-A8E0-7296-F995D5F5EA7F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43" creationId="{644EAE8C-A68E-D9D5-7133-FF314B29B4C7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44" creationId="{9B7A6AB9-1E2E-DD39-E66B-503897945F2F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46" creationId="{5DBA1334-C558-75F7-DCB5-09B2199CBA5D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47" creationId="{A3C50A19-0499-B459-6EBF-D9C1A1570FBE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49" creationId="{9D889B10-B6F1-5F5B-6E59-4FC9E4D06DBC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50" creationId="{4A9B0C3A-CF80-8DD7-8536-FC4FD5C4B083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52" creationId="{C3FE6167-BD62-95E8-74B5-E73BE33C73E0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53" creationId="{7858AF0F-3584-7C40-4512-3EFAE12EDDB3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54" creationId="{E400B8AA-12F4-3B06-E3E9-315091A18786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55" creationId="{8ADCFED3-8E91-CF1C-3408-251F1C83D352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56" creationId="{15F2D645-ABCB-37DF-DA42-D40396CC31AC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57" creationId="{46FC1E8A-8819-4FBF-EB1D-952A8A38E31C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58" creationId="{393E586F-C84B-4E84-935F-5C75D60C1129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59" creationId="{86458F6C-FB1F-253F-0C88-21CFD2D578CB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60" creationId="{F4A9D3AD-B697-E2C9-AB12-F1ED43EF98FA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61" creationId="{E7240C7A-03B1-CC09-57ED-40D8293ACE07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62" creationId="{F7C6436E-9792-C83C-8E9E-6B8A628992F3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63" creationId="{D25386DC-4BC4-2443-F143-71F3FE7FD701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64" creationId="{6BE60AE3-8739-ECE1-97EC-6876B5686E10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65" creationId="{0008499D-1B71-50F7-99D0-431056CF00FE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66" creationId="{510FCC5F-0D7E-67A7-FC94-210CE66A8AF6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67" creationId="{91B95C36-BB4B-BF4C-1DF6-04011D63EEC1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68" creationId="{E423AB0A-D4B6-0767-DAEB-D0536409C387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69" creationId="{666A9B87-0290-AF98-91C7-73E8F5B6351C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70" creationId="{68F2C442-1F36-01C5-F4C1-C60D3CA48FCD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71" creationId="{4E5F719C-7B23-4E53-C3F5-BBE6347682FC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72" creationId="{B529EC04-7367-AAF3-12E1-456EAEEC2A68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73" creationId="{A5105BA1-29D3-CF7F-A664-E2DFA994B569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74" creationId="{E9920E37-FEC7-61C1-7D56-7CE0DD309220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75" creationId="{B7D66245-AB50-16F2-3C92-BC5F731284B7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76" creationId="{F80F3995-B8AE-42AE-183C-D1BEA1989E00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77" creationId="{C58B6B6C-09E8-1047-AC16-09DA97D61DCA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78" creationId="{2724893E-65D3-FD14-9346-F01F44F7EA31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79" creationId="{5736C8D7-75B1-CDF7-66FB-8601C9D7A6DA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80" creationId="{7AE609F6-06E2-38C6-D61C-B17A8FA5534A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81" creationId="{A24933FF-8B9B-DB07-3535-32B7732027B6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82" creationId="{0EE409EB-7D74-344F-8C92-E468F189758B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83" creationId="{51F2D485-7150-155B-A78B-0CD030282999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84" creationId="{357ECB2A-E8A5-7B1B-708E-0C66C987E947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85" creationId="{D2CAA1EE-8140-D8E6-F6D1-A21087448E3A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86" creationId="{F31C2F89-E5CC-5F3B-A791-8278B87A3299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87" creationId="{146CB1FC-7D46-32D3-AFA7-C96C9DA2AAF2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88" creationId="{DA4B4B41-77C1-7DD9-84C7-ED5872EE0FF9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89" creationId="{52319992-3211-FCB2-D8B5-AA15C43F74AC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90" creationId="{BA71F63B-3D06-2EAF-A612-EC0C101979DF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91" creationId="{60DF3596-EEF5-4929-F059-E399561EB89D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92" creationId="{DF322636-37A9-1F32-589C-0DDBE25FD3BB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93" creationId="{66EF5AA6-A5EA-B30C-B0B6-1E5CB07F9C1E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94" creationId="{EDB8ED38-DE79-A567-E288-40ADEE518E7B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95" creationId="{08FBA48B-0DFB-93F8-E2B3-E1398DAD2738}"/>
          </ac:spMkLst>
        </pc:spChg>
        <pc:spChg chg="mod">
          <ac:chgData name="Jermann, Philip" userId="e10035d5-5694-4da2-b251-c7f1ed8245bc" providerId="ADAL" clId="{A47126F1-0408-4D63-8D1F-44ACA5FE5673}" dt="2023-08-28T14:34:28.415" v="1" actId="27803"/>
          <ac:spMkLst>
            <pc:docMk/>
            <pc:sldMk cId="252456774" sldId="258"/>
            <ac:spMk id="96" creationId="{4F662052-26F1-F1C5-F910-8D4342A42A10}"/>
          </ac:spMkLst>
        </pc:spChg>
        <pc:grpChg chg="mod">
          <ac:chgData name="Jermann, Philip" userId="e10035d5-5694-4da2-b251-c7f1ed8245bc" providerId="ADAL" clId="{A47126F1-0408-4D63-8D1F-44ACA5FE5673}" dt="2023-08-28T14:34:28.415" v="1" actId="27803"/>
          <ac:grpSpMkLst>
            <pc:docMk/>
            <pc:sldMk cId="252456774" sldId="258"/>
            <ac:grpSpMk id="2" creationId="{B0328828-9A1E-D343-834D-A874B5176DFE}"/>
          </ac:grpSpMkLst>
        </pc:grpChg>
        <pc:grpChg chg="mod">
          <ac:chgData name="Jermann, Philip" userId="e10035d5-5694-4da2-b251-c7f1ed8245bc" providerId="ADAL" clId="{A47126F1-0408-4D63-8D1F-44ACA5FE5673}" dt="2023-08-28T14:34:28.415" v="1" actId="27803"/>
          <ac:grpSpMkLst>
            <pc:docMk/>
            <pc:sldMk cId="252456774" sldId="258"/>
            <ac:grpSpMk id="3" creationId="{09F141B3-7D2F-B7C5-2F8F-93F58E13BCBA}"/>
          </ac:grpSpMkLst>
        </pc:grpChg>
        <pc:grpChg chg="mod">
          <ac:chgData name="Jermann, Philip" userId="e10035d5-5694-4da2-b251-c7f1ed8245bc" providerId="ADAL" clId="{A47126F1-0408-4D63-8D1F-44ACA5FE5673}" dt="2023-08-28T14:34:28.415" v="1" actId="27803"/>
          <ac:grpSpMkLst>
            <pc:docMk/>
            <pc:sldMk cId="252456774" sldId="258"/>
            <ac:grpSpMk id="30" creationId="{D6E63CE1-A46B-9722-CA4E-9DA465548E3D}"/>
          </ac:grpSpMkLst>
        </pc:grpChg>
        <pc:grpChg chg="mod">
          <ac:chgData name="Jermann, Philip" userId="e10035d5-5694-4da2-b251-c7f1ed8245bc" providerId="ADAL" clId="{A47126F1-0408-4D63-8D1F-44ACA5FE5673}" dt="2023-08-28T14:34:28.415" v="1" actId="27803"/>
          <ac:grpSpMkLst>
            <pc:docMk/>
            <pc:sldMk cId="252456774" sldId="258"/>
            <ac:grpSpMk id="42" creationId="{B6DEC2E2-C253-BA8A-DA7A-6ABDB1CDD1C0}"/>
          </ac:grpSpMkLst>
        </pc:grpChg>
        <pc:grpChg chg="mod">
          <ac:chgData name="Jermann, Philip" userId="e10035d5-5694-4da2-b251-c7f1ed8245bc" providerId="ADAL" clId="{A47126F1-0408-4D63-8D1F-44ACA5FE5673}" dt="2023-08-28T14:34:28.415" v="1" actId="27803"/>
          <ac:grpSpMkLst>
            <pc:docMk/>
            <pc:sldMk cId="252456774" sldId="258"/>
            <ac:grpSpMk id="45" creationId="{8CA2CE58-BA27-24C8-BBF2-BBBEFFF8489E}"/>
          </ac:grpSpMkLst>
        </pc:grpChg>
        <pc:grpChg chg="mod">
          <ac:chgData name="Jermann, Philip" userId="e10035d5-5694-4da2-b251-c7f1ed8245bc" providerId="ADAL" clId="{A47126F1-0408-4D63-8D1F-44ACA5FE5673}" dt="2023-08-28T14:34:28.415" v="1" actId="27803"/>
          <ac:grpSpMkLst>
            <pc:docMk/>
            <pc:sldMk cId="252456774" sldId="258"/>
            <ac:grpSpMk id="48" creationId="{5C58366F-F4F8-5792-0D51-85869DECAC10}"/>
          </ac:grpSpMkLst>
        </pc:grpChg>
        <pc:grpChg chg="mod">
          <ac:chgData name="Jermann, Philip" userId="e10035d5-5694-4da2-b251-c7f1ed8245bc" providerId="ADAL" clId="{A47126F1-0408-4D63-8D1F-44ACA5FE5673}" dt="2023-08-28T14:34:28.415" v="1" actId="27803"/>
          <ac:grpSpMkLst>
            <pc:docMk/>
            <pc:sldMk cId="252456774" sldId="258"/>
            <ac:grpSpMk id="51" creationId="{88777E69-4E95-CD02-70F4-7416325EDEC3}"/>
          </ac:grpSpMkLst>
        </pc:grpChg>
        <pc:picChg chg="add del mod">
          <ac:chgData name="Jermann, Philip" userId="e10035d5-5694-4da2-b251-c7f1ed8245bc" providerId="ADAL" clId="{A47126F1-0408-4D63-8D1F-44ACA5FE5673}" dt="2023-08-28T14:34:34.078" v="3" actId="1076"/>
          <ac:picMkLst>
            <pc:docMk/>
            <pc:sldMk cId="252456774" sldId="258"/>
            <ac:picMk id="27" creationId="{A4336FD6-CD03-5D14-2C48-4CB0A079BB46}"/>
          </ac:picMkLst>
        </pc:picChg>
      </pc:sldChg>
    </pc:docChg>
  </pc:docChgLst>
  <pc:docChgLst>
    <pc:chgData name="Jermann, Philip" userId="e10035d5-5694-4da2-b251-c7f1ed8245bc" providerId="ADAL" clId="{75472882-0991-42D9-9CC3-E7ADC5403C23}"/>
    <pc:docChg chg="modSld">
      <pc:chgData name="Jermann, Philip" userId="e10035d5-5694-4da2-b251-c7f1ed8245bc" providerId="ADAL" clId="{75472882-0991-42D9-9CC3-E7ADC5403C23}" dt="2023-02-15T13:49:00.221" v="17"/>
      <pc:docMkLst>
        <pc:docMk/>
      </pc:docMkLst>
      <pc:sldChg chg="addSp modSp mod addCm">
        <pc:chgData name="Jermann, Philip" userId="e10035d5-5694-4da2-b251-c7f1ed8245bc" providerId="ADAL" clId="{75472882-0991-42D9-9CC3-E7ADC5403C23}" dt="2023-02-15T13:48:32.259" v="16"/>
        <pc:sldMkLst>
          <pc:docMk/>
          <pc:sldMk cId="1260288373" sldId="260"/>
        </pc:sldMkLst>
        <pc:spChg chg="add mod">
          <ac:chgData name="Jermann, Philip" userId="e10035d5-5694-4da2-b251-c7f1ed8245bc" providerId="ADAL" clId="{75472882-0991-42D9-9CC3-E7ADC5403C23}" dt="2023-02-15T13:37:55.383" v="6" actId="1076"/>
          <ac:spMkLst>
            <pc:docMk/>
            <pc:sldMk cId="1260288373" sldId="260"/>
            <ac:spMk id="2" creationId="{6877A2DE-02BC-161B-5F67-240EDF4EA956}"/>
          </ac:spMkLst>
        </pc:spChg>
        <pc:spChg chg="add mod">
          <ac:chgData name="Jermann, Philip" userId="e10035d5-5694-4da2-b251-c7f1ed8245bc" providerId="ADAL" clId="{75472882-0991-42D9-9CC3-E7ADC5403C23}" dt="2023-02-15T13:43:34.030" v="15" actId="14100"/>
          <ac:spMkLst>
            <pc:docMk/>
            <pc:sldMk cId="1260288373" sldId="260"/>
            <ac:spMk id="3" creationId="{122816F9-49B1-3202-80F4-987AB82F1DB8}"/>
          </ac:spMkLst>
        </pc:spChg>
        <pc:spChg chg="add mod">
          <ac:chgData name="Jermann, Philip" userId="e10035d5-5694-4da2-b251-c7f1ed8245bc" providerId="ADAL" clId="{75472882-0991-42D9-9CC3-E7ADC5403C23}" dt="2023-02-15T13:39:47.324" v="11" actId="20577"/>
          <ac:spMkLst>
            <pc:docMk/>
            <pc:sldMk cId="1260288373" sldId="260"/>
            <ac:spMk id="4" creationId="{F054A696-410C-862D-676C-2E32F8A900F8}"/>
          </ac:spMkLst>
        </pc:spChg>
      </pc:sldChg>
      <pc:sldChg chg="addCm">
        <pc:chgData name="Jermann, Philip" userId="e10035d5-5694-4da2-b251-c7f1ed8245bc" providerId="ADAL" clId="{75472882-0991-42D9-9CC3-E7ADC5403C23}" dt="2023-02-15T13:49:00.221" v="17"/>
        <pc:sldMkLst>
          <pc:docMk/>
          <pc:sldMk cId="499513409" sldId="261"/>
        </pc:sldMkLst>
      </pc:sldChg>
    </pc:docChg>
  </pc:docChgLst>
</pc:chgInfo>
</file>

<file path=ppt/comments/modernComment_100_2E1DB92B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8D1F96E0-90FB-4C27-B24D-C19878522CB1}" authorId="{B7447899-6E9E-B954-F80B-6EAAB7E45A49}" created="2023-09-05T06:02:52.502">
    <ac:txMkLst xmlns:ac="http://schemas.microsoft.com/office/drawing/2013/main/command">
      <pc:docMk xmlns:pc="http://schemas.microsoft.com/office/powerpoint/2013/main/command"/>
      <pc:sldMk xmlns:pc="http://schemas.microsoft.com/office/powerpoint/2013/main/command" cId="773699883" sldId="256"/>
      <ac:spMk id="58" creationId="{2343FFA6-5BB5-61DA-2524-406F466E9EE2}"/>
      <ac:txMk cp="20" len="1">
        <ac:context len="183" hash="3674182105"/>
      </ac:txMk>
    </ac:txMkLst>
    <p188:pos x="1659821" y="287336"/>
    <p188:txBody>
      <a:bodyPr/>
      <a:lstStyle/>
      <a:p>
        <a:r>
          <a:rPr lang="en-US"/>
          <a:t>We added ‘S’ in the labels of Supplementary Tables/Figrues. Please confirm.</a:t>
        </a:r>
      </a:p>
    </p188:txBody>
  </p188:cm>
</p188:cmLst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EBA67A-C768-9637-3900-DE675C849C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5DA592E-5CE9-0CD2-1E41-362F1929DF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F517F3-8E62-0F31-F24F-E03C83FA5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94F8-D1B0-4E4A-A1F8-1194B6B1FD09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5B1EC6-8619-67DD-7105-E0B1EDD61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F9220-F35A-8F2B-8BD4-53399AB461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4ED71-887F-4838-B271-532714E9FF6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490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759034-0890-303C-D1AC-E845470EC5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1A7816-8351-697E-F740-B0FC42C2ED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64333D-14E0-D661-2ACC-A70202520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94F8-D1B0-4E4A-A1F8-1194B6B1FD09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0CD047-AA90-20A0-8C48-E77B906873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4FEEB0-A3D1-0D4F-3740-061FB5ED08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4ED71-887F-4838-B271-532714E9FF6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79725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1F6F63-6CF7-DDDA-373C-894C712DE40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0FFF36-C8F8-4439-5656-42C0BCFD1F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78A3C1-91C4-C0D6-5CEF-CB825ED0F6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94F8-D1B0-4E4A-A1F8-1194B6B1FD09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2C547B-AFA7-E93B-326B-4D08AD364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E3451C-E8F9-F8F4-E224-4D34D4F8A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4ED71-887F-4838-B271-532714E9FF6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7673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DAAFD4-A255-C21C-FD67-EDDAD4C58C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1DE75A-9C0F-6881-BEA2-97051FC176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E2349E-CC11-6450-563D-6639EE6F9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94F8-D1B0-4E4A-A1F8-1194B6B1FD09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9EADCA-3C9B-826F-8F7C-BF913DAD9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B41E09-8867-3048-38ED-C2D061B64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4ED71-887F-4838-B271-532714E9FF6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96894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808150-7932-7A3A-243B-8D99EC02EA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759BA1-B571-2F06-6DDB-68130C3232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A47A20-1FE2-2D71-0CEE-91127B9C1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94F8-D1B0-4E4A-A1F8-1194B6B1FD09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94C147-8836-2587-87C3-87E4266E13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3FFB12-0196-682E-1162-D42D55855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4ED71-887F-4838-B271-532714E9FF6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42744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ABFDB0-5727-6137-11DA-C078560DD2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FF72ED-9181-F98B-3CFA-076D37072E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C8F4FA-4399-4975-110C-B2AFDD1924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B962CA-6051-0F1C-FD0E-43917ABA3E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94F8-D1B0-4E4A-A1F8-1194B6B1FD09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51F79A-06D4-D8C3-7D67-2B046D833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E3F556-08E2-265B-3792-2C364E046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4ED71-887F-4838-B271-532714E9FF6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41099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5F6B7A-9B03-1660-1231-09A1144815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D6C1C8-C753-E46C-ABF2-B7C6225313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FE212F-1F37-89DD-60E9-C222A0485F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503B93-5878-9104-497C-3593CCFF84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5FEBBC2-A23A-2A55-FBA3-307BA21442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04B759-46AE-0461-AFE6-DE6AFE788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94F8-D1B0-4E4A-A1F8-1194B6B1FD09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04CC02D-F7E6-43DE-71AC-31BB21DF3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083D7C-3BD3-58AB-9CB1-CBF4DA433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4ED71-887F-4838-B271-532714E9FF6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17765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F21450-61E0-8F7C-61CE-A5FF06EBB9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23CEA2-D558-7C01-232F-437EE989A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94F8-D1B0-4E4A-A1F8-1194B6B1FD09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38F539-C8D0-C4B1-EA49-7E9B1ABAA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33610A-01A7-C55A-A660-3952E9F96E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4ED71-887F-4838-B271-532714E9FF6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49086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D6790E-F674-7226-AB79-7D86FFCC86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94F8-D1B0-4E4A-A1F8-1194B6B1FD09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F40323F-DC46-9A7D-2BDA-CB46660D5F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824558-C51C-49DF-465B-BC2FB1962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4ED71-887F-4838-B271-532714E9FF6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72566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7B2195-B8FD-C218-63FA-B41E661FC6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7AE920-C532-C56F-9345-CA219D297D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5831A1-B320-BC7D-D054-972715FCB4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CA64B0-C3F5-7D24-26C5-E758430EE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94F8-D1B0-4E4A-A1F8-1194B6B1FD09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6236E0-E3C8-C297-F2D9-3C6200E7DB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6BEA27-19D5-7976-2915-BA13D1BEA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4ED71-887F-4838-B271-532714E9FF6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79060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2C9E30-91DE-F762-4767-742CABF702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3D7B5B3-CB7B-244F-5BD2-B7D579121B5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21D3E9-2408-0106-DE29-F70A26E901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813865-F7EE-1E95-F628-0BAD31432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94F8-D1B0-4E4A-A1F8-1194B6B1FD09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0CEBB3-7081-9544-7C56-D41AF395D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DF7EEC-4976-CF46-0D8D-15B5DD16A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4ED71-887F-4838-B271-532714E9FF6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27631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169092-00AC-E713-FD61-0CD579897C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EAB951-5246-228C-1F9A-0D38B46B39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E48DA-15F8-3A65-1261-31AA4C77E7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3394F8-D1B0-4E4A-A1F8-1194B6B1FD09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2318B0-9878-04E2-06EC-96E71BA5D6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740351-50BC-3F72-37E7-ABC2D54DF8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04ED71-887F-4838-B271-532714E9FF6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60529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18/10/relationships/comments" Target="../comments/modernComment_100_2E1DB92B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Group 58">
            <a:extLst>
              <a:ext uri="{FF2B5EF4-FFF2-40B4-BE49-F238E27FC236}">
                <a16:creationId xmlns:a16="http://schemas.microsoft.com/office/drawing/2014/main" id="{E1B0DA4E-2FE2-8461-1B0F-7B0D42901C0D}"/>
              </a:ext>
            </a:extLst>
          </p:cNvPr>
          <p:cNvGrpSpPr/>
          <p:nvPr/>
        </p:nvGrpSpPr>
        <p:grpSpPr>
          <a:xfrm>
            <a:off x="1173895" y="1068196"/>
            <a:ext cx="9516681" cy="5433927"/>
            <a:chOff x="1433750" y="319259"/>
            <a:chExt cx="9516681" cy="5433927"/>
          </a:xfrm>
        </p:grpSpPr>
        <p:pic>
          <p:nvPicPr>
            <p:cNvPr id="55" name="Graphic 54">
              <a:extLst>
                <a:ext uri="{FF2B5EF4-FFF2-40B4-BE49-F238E27FC236}">
                  <a16:creationId xmlns:a16="http://schemas.microsoft.com/office/drawing/2014/main" id="{BF894C79-F69C-3C51-71CD-335F601C2DA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1461433" y="5495147"/>
              <a:ext cx="224907" cy="224907"/>
            </a:xfrm>
            <a:prstGeom prst="rect">
              <a:avLst/>
            </a:prstGeom>
          </p:spPr>
        </p:pic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F451771-BCBC-CD49-8D2D-BE1A037367FC}"/>
                </a:ext>
              </a:extLst>
            </p:cNvPr>
            <p:cNvSpPr txBox="1"/>
            <p:nvPr/>
          </p:nvSpPr>
          <p:spPr>
            <a:xfrm>
              <a:off x="1714024" y="5463400"/>
              <a:ext cx="1876200" cy="289786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normAutofit/>
            </a:bodyPr>
            <a:lstStyle/>
            <a:p>
              <a:pPr>
                <a:lnSpc>
                  <a:spcPct val="110000"/>
                </a:lnSpc>
                <a:spcBef>
                  <a:spcPts val="200"/>
                </a:spcBef>
                <a:buClr>
                  <a:srgbClr val="E61316"/>
                </a:buClr>
                <a:buSzPct val="100000"/>
              </a:pPr>
              <a:r>
                <a:rPr lang="en-US" sz="1100" dirty="0">
                  <a:solidFill>
                    <a:srgbClr val="222222"/>
                  </a:solidFill>
                  <a:latin typeface="Arial" panose="020B0604020202020204"/>
                </a:rPr>
                <a:t>FDA/EMA approved therapy</a:t>
              </a:r>
            </a:p>
          </p:txBody>
        </p:sp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0ED3D65E-A11A-848F-D4E6-1F13EB9D982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33750" y="319259"/>
              <a:ext cx="9516681" cy="5255207"/>
            </a:xfrm>
            <a:prstGeom prst="rect">
              <a:avLst/>
            </a:prstGeom>
          </p:spPr>
        </p:pic>
      </p:grpSp>
      <p:sp>
        <p:nvSpPr>
          <p:cNvPr id="58" name="TextBox 57">
            <a:extLst>
              <a:ext uri="{FF2B5EF4-FFF2-40B4-BE49-F238E27FC236}">
                <a16:creationId xmlns:a16="http://schemas.microsoft.com/office/drawing/2014/main" id="{2343FFA6-5BB5-61DA-2524-406F466E9EE2}"/>
              </a:ext>
            </a:extLst>
          </p:cNvPr>
          <p:cNvSpPr txBox="1"/>
          <p:nvPr/>
        </p:nvSpPr>
        <p:spPr>
          <a:xfrm>
            <a:off x="1103927" y="534597"/>
            <a:ext cx="95166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. 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Oncomine Dx Express Test target genes, covering a wide range of clinically relevant biomarkers. Genes in bold are only available for analysis in FFPE samples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3699883"/>
      </p:ext>
    </p:extLst>
  </p:cSld>
  <p:clrMapOvr>
    <a:masterClrMapping/>
  </p:clrMapOvr>
  <p:extLst>
    <p:ext uri="{6950BFC3-D8DA-4A85-94F7-54DA5524770B}">
      <p188:commentRel xmlns:p188="http://schemas.microsoft.com/office/powerpoint/2018/8/main" xmlns="" r:id="rId5"/>
    </p:ext>
  </p:extLs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694C414F-BF50-D5C4-E3B1-2C2B199A8915}"/>
              </a:ext>
            </a:extLst>
          </p:cNvPr>
          <p:cNvSpPr txBox="1"/>
          <p:nvPr/>
        </p:nvSpPr>
        <p:spPr>
          <a:xfrm>
            <a:off x="124361" y="961049"/>
            <a:ext cx="89521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2. 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Mutation metrics of study phase I pre-characterized samples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BBB16C8-8A67-EEC5-9E9A-86CE6429C4A1}"/>
              </a:ext>
            </a:extLst>
          </p:cNvPr>
          <p:cNvSpPr txBox="1"/>
          <p:nvPr/>
        </p:nvSpPr>
        <p:spPr>
          <a:xfrm>
            <a:off x="124361" y="5913209"/>
            <a:ext cx="60355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100" dirty="0">
                <a:latin typeface="Arial" panose="020B0604020202020204" pitchFamily="34" charset="0"/>
                <a:cs typeface="Arial" panose="020B0604020202020204" pitchFamily="34" charset="0"/>
              </a:rPr>
              <a:t>* Lack of data in Nice and Porto study centers represents samples with failed sequencing runs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591EE17-5416-7C1E-8197-E77040CB25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846" y="1233303"/>
            <a:ext cx="11922034" cy="46636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85056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6301960-04F4-829E-E43C-60437611436D}"/>
              </a:ext>
            </a:extLst>
          </p:cNvPr>
          <p:cNvSpPr txBox="1"/>
          <p:nvPr/>
        </p:nvSpPr>
        <p:spPr>
          <a:xfrm>
            <a:off x="1577817" y="1982519"/>
            <a:ext cx="2646207" cy="600164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defTabSz="457200"/>
            <a:r>
              <a:rPr lang="de-CH" sz="1100" i="1" dirty="0">
                <a:solidFill>
                  <a:srgbClr val="222222"/>
                </a:solidFill>
                <a:latin typeface="Arial" panose="020B0604020202020204"/>
              </a:rPr>
              <a:t>KRAS</a:t>
            </a:r>
            <a:r>
              <a:rPr lang="de-CH" sz="1100" dirty="0">
                <a:solidFill>
                  <a:srgbClr val="222222"/>
                </a:solidFill>
                <a:latin typeface="Arial" panose="020B0604020202020204"/>
              </a:rPr>
              <a:t> G12C, </a:t>
            </a:r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BRAF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 V600E, </a:t>
            </a:r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EGFR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 ex20ins, uncommon </a:t>
            </a:r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EGFR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, </a:t>
            </a:r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MET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 ex14,</a:t>
            </a:r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 ROS1 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fu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252CA84-2447-E641-611C-66053315389C}"/>
              </a:ext>
            </a:extLst>
          </p:cNvPr>
          <p:cNvSpPr txBox="1"/>
          <p:nvPr/>
        </p:nvSpPr>
        <p:spPr>
          <a:xfrm>
            <a:off x="1330626" y="1633312"/>
            <a:ext cx="508000" cy="368300"/>
          </a:xfrm>
          <a:prstGeom prst="rect">
            <a:avLst/>
          </a:prstGeom>
          <a:noFill/>
        </p:spPr>
        <p:txBody>
          <a:bodyPr wrap="none" lIns="0" tIns="0" rIns="0" bIns="0" rtlCol="0" anchor="ctr">
            <a:normAutofit/>
          </a:bodyPr>
          <a:lstStyle/>
          <a:p>
            <a:pPr>
              <a:lnSpc>
                <a:spcPct val="120000"/>
              </a:lnSpc>
              <a:spcBef>
                <a:spcPts val="200"/>
              </a:spcBef>
              <a:buClr>
                <a:srgbClr val="E71315"/>
              </a:buClr>
              <a:buSzPct val="100000"/>
            </a:pPr>
            <a:r>
              <a:rPr lang="de-CH" sz="1400" b="1" dirty="0">
                <a:solidFill>
                  <a:srgbClr val="74090B"/>
                </a:solidFill>
                <a:latin typeface="Arial" panose="020B0604020202020204"/>
              </a:rPr>
              <a:t>I-A</a:t>
            </a:r>
            <a:endParaRPr lang="en-US" sz="1400" b="1" dirty="0">
              <a:solidFill>
                <a:srgbClr val="74090B"/>
              </a:solidFill>
              <a:latin typeface="Arial" panose="020B0604020202020204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E4ABB1F-38E6-7195-D099-5141F0D2B232}"/>
              </a:ext>
            </a:extLst>
          </p:cNvPr>
          <p:cNvSpPr txBox="1"/>
          <p:nvPr/>
        </p:nvSpPr>
        <p:spPr>
          <a:xfrm>
            <a:off x="1330626" y="2058689"/>
            <a:ext cx="380681" cy="368300"/>
          </a:xfrm>
          <a:prstGeom prst="rect">
            <a:avLst/>
          </a:prstGeom>
          <a:noFill/>
        </p:spPr>
        <p:txBody>
          <a:bodyPr wrap="none" lIns="0" tIns="0" rIns="0" bIns="0" rtlCol="0" anchor="ctr">
            <a:normAutofit/>
          </a:bodyPr>
          <a:lstStyle/>
          <a:p>
            <a:pPr>
              <a:lnSpc>
                <a:spcPct val="120000"/>
              </a:lnSpc>
              <a:spcBef>
                <a:spcPts val="200"/>
              </a:spcBef>
              <a:buClr>
                <a:srgbClr val="E71315"/>
              </a:buClr>
              <a:buSzPct val="100000"/>
            </a:pPr>
            <a:r>
              <a:rPr lang="de-CH" sz="1400" b="1" dirty="0">
                <a:solidFill>
                  <a:srgbClr val="7C0A0C"/>
                </a:solidFill>
                <a:latin typeface="Arial" panose="020B0604020202020204"/>
              </a:rPr>
              <a:t>I-B</a:t>
            </a:r>
            <a:endParaRPr lang="en-US" sz="1400" b="1" dirty="0">
              <a:solidFill>
                <a:srgbClr val="7C0A0C"/>
              </a:solidFill>
              <a:latin typeface="Arial" panose="020B0604020202020204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B771D18-7D91-E007-F233-40FC66B67399}"/>
              </a:ext>
            </a:extLst>
          </p:cNvPr>
          <p:cNvSpPr txBox="1"/>
          <p:nvPr/>
        </p:nvSpPr>
        <p:spPr>
          <a:xfrm>
            <a:off x="1577817" y="1633312"/>
            <a:ext cx="2646207" cy="430887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defTabSz="457200"/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ALK 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fus, </a:t>
            </a:r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EGFR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 T790M, </a:t>
            </a:r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EGFR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 ex19del &amp; L858R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E331E0F-3D5D-AFCA-F2FD-D46E3AE43280}"/>
              </a:ext>
            </a:extLst>
          </p:cNvPr>
          <p:cNvSpPr txBox="1"/>
          <p:nvPr/>
        </p:nvSpPr>
        <p:spPr>
          <a:xfrm>
            <a:off x="1330626" y="2430878"/>
            <a:ext cx="508000" cy="368300"/>
          </a:xfrm>
          <a:prstGeom prst="rect">
            <a:avLst/>
          </a:prstGeom>
          <a:noFill/>
        </p:spPr>
        <p:txBody>
          <a:bodyPr wrap="none" lIns="0" tIns="0" rIns="0" bIns="0" rtlCol="0" anchor="ctr">
            <a:normAutofit/>
          </a:bodyPr>
          <a:lstStyle/>
          <a:p>
            <a:pPr>
              <a:lnSpc>
                <a:spcPct val="120000"/>
              </a:lnSpc>
              <a:spcBef>
                <a:spcPts val="200"/>
              </a:spcBef>
              <a:buClr>
                <a:srgbClr val="E71315"/>
              </a:buClr>
              <a:buSzPct val="100000"/>
            </a:pPr>
            <a:r>
              <a:rPr lang="de-CH" sz="1400" b="1" dirty="0">
                <a:solidFill>
                  <a:srgbClr val="7C0A0C"/>
                </a:solidFill>
                <a:latin typeface="Arial" panose="020B0604020202020204"/>
              </a:rPr>
              <a:t>I-C</a:t>
            </a:r>
            <a:endParaRPr lang="en-US" sz="1400" b="1" dirty="0">
              <a:solidFill>
                <a:srgbClr val="7C0A0C"/>
              </a:solidFill>
              <a:latin typeface="Arial" panose="020B0604020202020204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0E0DB97-C0FD-6E34-8591-82BDEAB301BD}"/>
              </a:ext>
            </a:extLst>
          </p:cNvPr>
          <p:cNvSpPr txBox="1"/>
          <p:nvPr/>
        </p:nvSpPr>
        <p:spPr>
          <a:xfrm>
            <a:off x="1577817" y="2514687"/>
            <a:ext cx="2371037" cy="261610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defTabSz="457200"/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NTRK 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and </a:t>
            </a:r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RET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 fu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4CF79F0-9EA6-F59B-AD49-9B27860812FE}"/>
              </a:ext>
            </a:extLst>
          </p:cNvPr>
          <p:cNvSpPr txBox="1"/>
          <p:nvPr/>
        </p:nvSpPr>
        <p:spPr>
          <a:xfrm>
            <a:off x="2231783" y="1388675"/>
            <a:ext cx="12022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57200"/>
            <a:r>
              <a:rPr lang="en-US" sz="1400" b="1" dirty="0">
                <a:solidFill>
                  <a:srgbClr val="222222">
                    <a:lumMod val="90000"/>
                    <a:lumOff val="10000"/>
                  </a:srgbClr>
                </a:solidFill>
                <a:latin typeface="Arial" panose="020B0604020202020204"/>
              </a:rPr>
              <a:t>NSCL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8F17190-4A51-FD13-DF3A-33E3740CA042}"/>
              </a:ext>
            </a:extLst>
          </p:cNvPr>
          <p:cNvSpPr txBox="1"/>
          <p:nvPr/>
        </p:nvSpPr>
        <p:spPr>
          <a:xfrm>
            <a:off x="1330626" y="3032625"/>
            <a:ext cx="380681" cy="312439"/>
          </a:xfrm>
          <a:prstGeom prst="rect">
            <a:avLst/>
          </a:prstGeom>
          <a:noFill/>
        </p:spPr>
        <p:txBody>
          <a:bodyPr wrap="none" lIns="0" tIns="0" rIns="0" bIns="0" rtlCol="0">
            <a:normAutofit/>
          </a:bodyPr>
          <a:lstStyle/>
          <a:p>
            <a:pPr>
              <a:lnSpc>
                <a:spcPct val="120000"/>
              </a:lnSpc>
              <a:spcBef>
                <a:spcPts val="200"/>
              </a:spcBef>
              <a:buClr>
                <a:srgbClr val="E71315"/>
              </a:buClr>
              <a:buSzPct val="100000"/>
            </a:pPr>
            <a:r>
              <a:rPr lang="de-CH" sz="1400" b="1" dirty="0">
                <a:solidFill>
                  <a:srgbClr val="7C0A0C"/>
                </a:solidFill>
                <a:latin typeface="Arial" panose="020B0604020202020204"/>
              </a:rPr>
              <a:t>I-A</a:t>
            </a:r>
            <a:endParaRPr lang="en-US" sz="1400" b="1" dirty="0">
              <a:solidFill>
                <a:srgbClr val="7C0A0C"/>
              </a:solidFill>
              <a:latin typeface="Arial" panose="020B0604020202020204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A7718F4-A025-021B-3672-9B5D5AC17285}"/>
              </a:ext>
            </a:extLst>
          </p:cNvPr>
          <p:cNvSpPr txBox="1"/>
          <p:nvPr/>
        </p:nvSpPr>
        <p:spPr>
          <a:xfrm>
            <a:off x="1577817" y="3031852"/>
            <a:ext cx="2174678" cy="261610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defTabSz="457200"/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ERBB2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 ampl, </a:t>
            </a:r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PIK3CA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 mu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8A13415-934C-CF9E-1AA2-B9153DAA854C}"/>
              </a:ext>
            </a:extLst>
          </p:cNvPr>
          <p:cNvSpPr txBox="1"/>
          <p:nvPr/>
        </p:nvSpPr>
        <p:spPr>
          <a:xfrm>
            <a:off x="1330626" y="3502000"/>
            <a:ext cx="508000" cy="368300"/>
          </a:xfrm>
          <a:prstGeom prst="rect">
            <a:avLst/>
          </a:prstGeom>
          <a:noFill/>
        </p:spPr>
        <p:txBody>
          <a:bodyPr wrap="none" lIns="0" tIns="0" rIns="0" bIns="0" rtlCol="0">
            <a:normAutofit/>
          </a:bodyPr>
          <a:lstStyle/>
          <a:p>
            <a:pPr>
              <a:lnSpc>
                <a:spcPct val="120000"/>
              </a:lnSpc>
              <a:spcBef>
                <a:spcPts val="200"/>
              </a:spcBef>
              <a:buClr>
                <a:srgbClr val="E71315"/>
              </a:buClr>
              <a:buSzPct val="100000"/>
            </a:pPr>
            <a:r>
              <a:rPr lang="de-CH" sz="1400" b="1" dirty="0">
                <a:solidFill>
                  <a:srgbClr val="7C0A0C"/>
                </a:solidFill>
                <a:latin typeface="Arial" panose="020B0604020202020204"/>
              </a:rPr>
              <a:t>I-A</a:t>
            </a:r>
            <a:endParaRPr lang="en-US" sz="1400" b="1" dirty="0">
              <a:solidFill>
                <a:srgbClr val="7C0A0C"/>
              </a:solidFill>
              <a:latin typeface="Arial" panose="020B0604020202020204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84DEC1D-1004-464F-1D38-7D9C8972738C}"/>
              </a:ext>
            </a:extLst>
          </p:cNvPr>
          <p:cNvSpPr txBox="1"/>
          <p:nvPr/>
        </p:nvSpPr>
        <p:spPr>
          <a:xfrm>
            <a:off x="1577817" y="3497464"/>
            <a:ext cx="1853102" cy="261610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defTabSz="457200"/>
            <a:r>
              <a:rPr lang="en-US" sz="1100" i="1" dirty="0">
                <a:solidFill>
                  <a:srgbClr val="222222"/>
                </a:solidFill>
                <a:latin typeface="Arial" panose="020B0604020202020204"/>
              </a:rPr>
              <a:t>BRAF</a:t>
            </a:r>
            <a:r>
              <a:rPr lang="en-US" sz="1100" dirty="0">
                <a:solidFill>
                  <a:srgbClr val="222222"/>
                </a:solidFill>
                <a:latin typeface="Arial" panose="020B0604020202020204"/>
              </a:rPr>
              <a:t> V600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3603BCF-B6B5-901E-7C76-B4A0545885B0}"/>
              </a:ext>
            </a:extLst>
          </p:cNvPr>
          <p:cNvSpPr txBox="1"/>
          <p:nvPr/>
        </p:nvSpPr>
        <p:spPr>
          <a:xfrm>
            <a:off x="2052549" y="3274050"/>
            <a:ext cx="1560674" cy="307777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defTabSz="457200"/>
            <a:r>
              <a:rPr lang="en-US" sz="1400" b="1" dirty="0">
                <a:solidFill>
                  <a:srgbClr val="222222">
                    <a:lumMod val="90000"/>
                    <a:lumOff val="10000"/>
                  </a:srgbClr>
                </a:solidFill>
                <a:latin typeface="Arial" panose="020B0604020202020204"/>
              </a:rPr>
              <a:t>Colorecta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9E0181E-E9F0-8D8D-D2E3-E45D80273173}"/>
              </a:ext>
            </a:extLst>
          </p:cNvPr>
          <p:cNvSpPr txBox="1"/>
          <p:nvPr/>
        </p:nvSpPr>
        <p:spPr>
          <a:xfrm>
            <a:off x="2030555" y="2778199"/>
            <a:ext cx="1604662" cy="307777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defTabSz="457200"/>
            <a:r>
              <a:rPr lang="en-US" sz="1400" b="1" dirty="0">
                <a:solidFill>
                  <a:srgbClr val="222222">
                    <a:lumMod val="90000"/>
                    <a:lumOff val="10000"/>
                  </a:srgbClr>
                </a:solidFill>
                <a:latin typeface="Arial" panose="020B0604020202020204"/>
              </a:rPr>
              <a:t>Breast cancer</a:t>
            </a:r>
          </a:p>
        </p:txBody>
      </p:sp>
      <p:sp>
        <p:nvSpPr>
          <p:cNvPr id="18" name="Rectangle: Rounded Corners 63">
            <a:extLst>
              <a:ext uri="{FF2B5EF4-FFF2-40B4-BE49-F238E27FC236}">
                <a16:creationId xmlns:a16="http://schemas.microsoft.com/office/drawing/2014/main" id="{0E27259C-F751-4250-F7E5-F3FBA0A4E714}"/>
              </a:ext>
            </a:extLst>
          </p:cNvPr>
          <p:cNvSpPr/>
          <p:nvPr/>
        </p:nvSpPr>
        <p:spPr bwMode="auto">
          <a:xfrm>
            <a:off x="1204215" y="1414057"/>
            <a:ext cx="2963751" cy="2393633"/>
          </a:xfrm>
          <a:prstGeom prst="roundRect">
            <a:avLst>
              <a:gd name="adj" fmla="val 8066"/>
            </a:avLst>
          </a:prstGeom>
          <a:noFill/>
          <a:ln w="6350" cap="flat" cmpd="sng" algn="ctr">
            <a:solidFill>
              <a:srgbClr val="74090B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dirty="0">
              <a:solidFill>
                <a:srgbClr val="222222"/>
              </a:solidFill>
              <a:latin typeface="Arial" pitchFamily="124" charset="0"/>
            </a:endParaRP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4DCFE518-D68F-D1E9-A85C-19FC7DBE8E01}"/>
              </a:ext>
            </a:extLst>
          </p:cNvPr>
          <p:cNvGrpSpPr/>
          <p:nvPr/>
        </p:nvGrpSpPr>
        <p:grpSpPr>
          <a:xfrm>
            <a:off x="7660511" y="2037600"/>
            <a:ext cx="2670495" cy="1088117"/>
            <a:chOff x="8756308" y="1200743"/>
            <a:chExt cx="2670495" cy="1088117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138C943-4A0B-6EC8-FA56-848F1AED2824}"/>
                </a:ext>
              </a:extLst>
            </p:cNvPr>
            <p:cNvSpPr txBox="1"/>
            <p:nvPr/>
          </p:nvSpPr>
          <p:spPr>
            <a:xfrm>
              <a:off x="9121939" y="1507486"/>
              <a:ext cx="2192112" cy="261610"/>
            </a:xfrm>
            <a:prstGeom prst="rect">
              <a:avLst/>
            </a:prstGeom>
            <a:noFill/>
          </p:spPr>
          <p:txBody>
            <a:bodyPr wrap="square" anchor="ctr">
              <a:spAutoFit/>
            </a:bodyPr>
            <a:lstStyle/>
            <a:p>
              <a:pPr defTabSz="457200"/>
              <a:r>
                <a:rPr lang="en-US" sz="1100" i="1" dirty="0">
                  <a:solidFill>
                    <a:srgbClr val="222222"/>
                  </a:solidFill>
                  <a:latin typeface="Arial" panose="020B0604020202020204"/>
                </a:rPr>
                <a:t>ERBB2</a:t>
              </a:r>
              <a:r>
                <a:rPr lang="en-US" sz="1100" dirty="0">
                  <a:solidFill>
                    <a:srgbClr val="222222"/>
                  </a:solidFill>
                  <a:latin typeface="Arial" panose="020B0604020202020204"/>
                </a:rPr>
                <a:t> ex20ins</a:t>
              </a:r>
            </a:p>
          </p:txBody>
        </p:sp>
        <p:sp>
          <p:nvSpPr>
            <p:cNvPr id="21" name="Rectangle: Rounded Corners 64">
              <a:extLst>
                <a:ext uri="{FF2B5EF4-FFF2-40B4-BE49-F238E27FC236}">
                  <a16:creationId xmlns:a16="http://schemas.microsoft.com/office/drawing/2014/main" id="{7473C431-E9DF-5B50-4234-B13D08DF77DC}"/>
                </a:ext>
              </a:extLst>
            </p:cNvPr>
            <p:cNvSpPr/>
            <p:nvPr/>
          </p:nvSpPr>
          <p:spPr bwMode="auto">
            <a:xfrm>
              <a:off x="8756308" y="1235549"/>
              <a:ext cx="2352081" cy="1053311"/>
            </a:xfrm>
            <a:prstGeom prst="roundRect">
              <a:avLst/>
            </a:prstGeom>
            <a:noFill/>
            <a:ln w="9525" cap="flat" cmpd="sng" algn="ctr">
              <a:solidFill>
                <a:srgbClr val="EA76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dirty="0">
                <a:solidFill>
                  <a:srgbClr val="222222"/>
                </a:solidFill>
                <a:highlight>
                  <a:srgbClr val="F67B00"/>
                </a:highlight>
                <a:latin typeface="Arial" pitchFamily="12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2F321BB-6707-BE86-34D8-295997F02706}"/>
                </a:ext>
              </a:extLst>
            </p:cNvPr>
            <p:cNvSpPr txBox="1"/>
            <p:nvPr/>
          </p:nvSpPr>
          <p:spPr>
            <a:xfrm>
              <a:off x="9466830" y="1200743"/>
              <a:ext cx="1071328" cy="307777"/>
            </a:xfrm>
            <a:prstGeom prst="rect">
              <a:avLst/>
            </a:prstGeom>
            <a:noFill/>
          </p:spPr>
          <p:txBody>
            <a:bodyPr wrap="square" anchor="ctr">
              <a:spAutoFit/>
            </a:bodyPr>
            <a:lstStyle/>
            <a:p>
              <a:pPr defTabSz="457200"/>
              <a:r>
                <a:rPr lang="en-US" sz="1400" b="1" dirty="0">
                  <a:solidFill>
                    <a:srgbClr val="222222">
                      <a:lumMod val="90000"/>
                      <a:lumOff val="10000"/>
                    </a:srgbClr>
                  </a:solidFill>
                  <a:latin typeface="Arial" panose="020B0604020202020204"/>
                </a:rPr>
                <a:t>NSCLC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CE6FDF1-6A8A-FD22-8C09-B8055FCC98DC}"/>
                </a:ext>
              </a:extLst>
            </p:cNvPr>
            <p:cNvSpPr txBox="1"/>
            <p:nvPr/>
          </p:nvSpPr>
          <p:spPr>
            <a:xfrm>
              <a:off x="8858140" y="1428146"/>
              <a:ext cx="508000" cy="368300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normAutofit/>
            </a:bodyPr>
            <a:lstStyle/>
            <a:p>
              <a:pPr>
                <a:lnSpc>
                  <a:spcPct val="120000"/>
                </a:lnSpc>
                <a:spcBef>
                  <a:spcPts val="200"/>
                </a:spcBef>
                <a:buClr>
                  <a:srgbClr val="E71315"/>
                </a:buClr>
                <a:buSzPct val="100000"/>
              </a:pPr>
              <a:r>
                <a:rPr lang="de-CH" sz="1400" b="1" dirty="0">
                  <a:solidFill>
                    <a:srgbClr val="EA7600"/>
                  </a:solidFill>
                  <a:latin typeface="Arial" panose="020B0604020202020204"/>
                </a:rPr>
                <a:t>II-B</a:t>
              </a:r>
              <a:endParaRPr lang="en-US" sz="1400" b="1" dirty="0">
                <a:solidFill>
                  <a:srgbClr val="EA7600"/>
                </a:solidFill>
                <a:latin typeface="Arial" panose="020B0604020202020204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2C21DE3-EE51-4734-80D5-EA2B5AA79EDC}"/>
                </a:ext>
              </a:extLst>
            </p:cNvPr>
            <p:cNvSpPr txBox="1"/>
            <p:nvPr/>
          </p:nvSpPr>
          <p:spPr>
            <a:xfrm>
              <a:off x="9344493" y="1761591"/>
              <a:ext cx="1316001" cy="307777"/>
            </a:xfrm>
            <a:prstGeom prst="rect">
              <a:avLst/>
            </a:prstGeom>
            <a:noFill/>
          </p:spPr>
          <p:txBody>
            <a:bodyPr wrap="square" anchor="ctr">
              <a:spAutoFit/>
            </a:bodyPr>
            <a:lstStyle/>
            <a:p>
              <a:pPr defTabSz="457200"/>
              <a:r>
                <a:rPr lang="en-US" sz="1400" b="1" dirty="0">
                  <a:solidFill>
                    <a:srgbClr val="222222">
                      <a:lumMod val="90000"/>
                      <a:lumOff val="10000"/>
                    </a:srgbClr>
                  </a:solidFill>
                  <a:latin typeface="Arial" panose="020B0604020202020204"/>
                </a:rPr>
                <a:t>Colorectal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C37A8E0-3039-8F71-435A-529C523580F6}"/>
                </a:ext>
              </a:extLst>
            </p:cNvPr>
            <p:cNvSpPr txBox="1"/>
            <p:nvPr/>
          </p:nvSpPr>
          <p:spPr>
            <a:xfrm>
              <a:off x="9143936" y="1983394"/>
              <a:ext cx="2282867" cy="261610"/>
            </a:xfrm>
            <a:prstGeom prst="rect">
              <a:avLst/>
            </a:prstGeom>
            <a:noFill/>
          </p:spPr>
          <p:txBody>
            <a:bodyPr wrap="square" anchor="ctr">
              <a:spAutoFit/>
            </a:bodyPr>
            <a:lstStyle/>
            <a:p>
              <a:pPr defTabSz="457200"/>
              <a:r>
                <a:rPr lang="en-US" sz="1100" i="1" dirty="0">
                  <a:solidFill>
                    <a:srgbClr val="222222"/>
                  </a:solidFill>
                  <a:latin typeface="Arial" panose="020B0604020202020204"/>
                </a:rPr>
                <a:t>ERBB2</a:t>
              </a:r>
              <a:r>
                <a:rPr lang="en-US" sz="1100" dirty="0">
                  <a:solidFill>
                    <a:srgbClr val="222222"/>
                  </a:solidFill>
                  <a:latin typeface="Arial" panose="020B0604020202020204"/>
                </a:rPr>
                <a:t> ampl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36CC40A-3B42-CB13-CF10-388755904C30}"/>
                </a:ext>
              </a:extLst>
            </p:cNvPr>
            <p:cNvSpPr txBox="1"/>
            <p:nvPr/>
          </p:nvSpPr>
          <p:spPr>
            <a:xfrm>
              <a:off x="8879527" y="1920560"/>
              <a:ext cx="508000" cy="368300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normAutofit/>
            </a:bodyPr>
            <a:lstStyle/>
            <a:p>
              <a:pPr>
                <a:lnSpc>
                  <a:spcPct val="120000"/>
                </a:lnSpc>
                <a:spcBef>
                  <a:spcPts val="200"/>
                </a:spcBef>
                <a:buClr>
                  <a:srgbClr val="E71315"/>
                </a:buClr>
                <a:buSzPct val="100000"/>
              </a:pPr>
              <a:r>
                <a:rPr lang="de-CH" sz="1400" b="1" dirty="0">
                  <a:solidFill>
                    <a:srgbClr val="EA7600"/>
                  </a:solidFill>
                  <a:latin typeface="Arial" panose="020B0604020202020204"/>
                </a:rPr>
                <a:t>II-B</a:t>
              </a:r>
              <a:endParaRPr lang="en-US" sz="1400" b="1" dirty="0">
                <a:solidFill>
                  <a:srgbClr val="EA7600"/>
                </a:solidFill>
                <a:latin typeface="Arial" panose="020B0604020202020204"/>
              </a:endParaRPr>
            </a:p>
          </p:txBody>
        </p:sp>
      </p:grpSp>
      <p:pic>
        <p:nvPicPr>
          <p:cNvPr id="27" name="Graphic 26">
            <a:extLst>
              <a:ext uri="{FF2B5EF4-FFF2-40B4-BE49-F238E27FC236}">
                <a16:creationId xmlns:a16="http://schemas.microsoft.com/office/drawing/2014/main" id="{A4336FD6-CD03-5D14-2C48-4CB0A079BB4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l="25321" t="19297" r="24953" b="19701"/>
          <a:stretch/>
        </p:blipFill>
        <p:spPr>
          <a:xfrm>
            <a:off x="2955027" y="1987248"/>
            <a:ext cx="5742143" cy="396240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AB6A2BEF-79E9-C335-E3CF-7EC24F3FF162}"/>
              </a:ext>
            </a:extLst>
          </p:cNvPr>
          <p:cNvSpPr txBox="1"/>
          <p:nvPr/>
        </p:nvSpPr>
        <p:spPr>
          <a:xfrm>
            <a:off x="5368898" y="1865382"/>
            <a:ext cx="914400" cy="381001"/>
          </a:xfrm>
          <a:prstGeom prst="rect">
            <a:avLst/>
          </a:prstGeom>
          <a:noFill/>
        </p:spPr>
        <p:txBody>
          <a:bodyPr wrap="none" lIns="0" tIns="0" rIns="0" bIns="0" rtlCol="0">
            <a:normAutofit/>
          </a:bodyPr>
          <a:lstStyle/>
          <a:p>
            <a:pPr>
              <a:lnSpc>
                <a:spcPct val="120000"/>
              </a:lnSpc>
              <a:spcBef>
                <a:spcPts val="200"/>
              </a:spcBef>
              <a:buClr>
                <a:srgbClr val="E71315"/>
              </a:buClr>
              <a:buSzPct val="100000"/>
            </a:pPr>
            <a:r>
              <a:rPr lang="en-US" sz="2000" b="1" dirty="0">
                <a:solidFill>
                  <a:srgbClr val="222222"/>
                </a:solidFill>
                <a:latin typeface="Arial" panose="020B0604020202020204"/>
              </a:rPr>
              <a:t>ESCAT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5452D2A5-D5F2-64BE-0F6B-54156FC4F9A5}"/>
              </a:ext>
            </a:extLst>
          </p:cNvPr>
          <p:cNvGrpSpPr/>
          <p:nvPr/>
        </p:nvGrpSpPr>
        <p:grpSpPr>
          <a:xfrm>
            <a:off x="7983138" y="3302639"/>
            <a:ext cx="1914946" cy="963570"/>
            <a:chOff x="8343643" y="3018875"/>
            <a:chExt cx="1914946" cy="963570"/>
          </a:xfrm>
        </p:grpSpPr>
        <p:sp>
          <p:nvSpPr>
            <p:cNvPr id="33" name="Rectangle: Rounded Corners 79">
              <a:extLst>
                <a:ext uri="{FF2B5EF4-FFF2-40B4-BE49-F238E27FC236}">
                  <a16:creationId xmlns:a16="http://schemas.microsoft.com/office/drawing/2014/main" id="{E01CD561-3D5A-2F8E-A516-C68F4732A801}"/>
                </a:ext>
              </a:extLst>
            </p:cNvPr>
            <p:cNvSpPr/>
            <p:nvPr/>
          </p:nvSpPr>
          <p:spPr bwMode="auto">
            <a:xfrm>
              <a:off x="8343643" y="3035797"/>
              <a:ext cx="1610146" cy="946648"/>
            </a:xfrm>
            <a:prstGeom prst="roundRect">
              <a:avLst/>
            </a:prstGeom>
            <a:noFill/>
            <a:ln w="9525" cap="flat" cmpd="sng" algn="ctr">
              <a:solidFill>
                <a:srgbClr val="B4BD01">
                  <a:lumMod val="75000"/>
                </a:srgbClr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222222"/>
                </a:solidFill>
                <a:effectLst/>
                <a:highlight>
                  <a:srgbClr val="F67B00"/>
                </a:highlight>
                <a:uLnTx/>
                <a:uFillTx/>
                <a:latin typeface="Arial" pitchFamily="12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4455761-F94B-25BC-57A6-7E76C8782F4C}"/>
                </a:ext>
              </a:extLst>
            </p:cNvPr>
            <p:cNvSpPr txBox="1"/>
            <p:nvPr/>
          </p:nvSpPr>
          <p:spPr>
            <a:xfrm>
              <a:off x="8788956" y="3018875"/>
              <a:ext cx="1058418" cy="307777"/>
            </a:xfrm>
            <a:prstGeom prst="rect">
              <a:avLst/>
            </a:prstGeom>
            <a:noFill/>
          </p:spPr>
          <p:txBody>
            <a:bodyPr wrap="square" anchor="ctr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0" cap="none" spc="0" normalizeH="0" baseline="0" noProof="0" dirty="0">
                  <a:ln>
                    <a:noFill/>
                  </a:ln>
                  <a:solidFill>
                    <a:srgbClr val="222222">
                      <a:lumMod val="90000"/>
                      <a:lumOff val="10000"/>
                    </a:srgbClr>
                  </a:solidFill>
                  <a:effectLst/>
                  <a:uLnTx/>
                  <a:uFillTx/>
                  <a:latin typeface="Arial" panose="020B0604020202020204"/>
                </a:rPr>
                <a:t>NSCLC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B713564-6BA2-9456-658A-187F338BD975}"/>
                </a:ext>
              </a:extLst>
            </p:cNvPr>
            <p:cNvSpPr txBox="1"/>
            <p:nvPr/>
          </p:nvSpPr>
          <p:spPr>
            <a:xfrm>
              <a:off x="8424554" y="3156882"/>
              <a:ext cx="508000" cy="368300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normAutofit/>
            </a:bodyPr>
            <a:lstStyle/>
            <a:p>
              <a:pPr marL="0" marR="0" lvl="0" indent="0" defTabSz="914400" eaLnBrk="1" fontAlgn="auto" latinLnBrk="0" hangingPunct="1">
                <a:lnSpc>
                  <a:spcPct val="120000"/>
                </a:lnSpc>
                <a:spcBef>
                  <a:spcPts val="200"/>
                </a:spcBef>
                <a:spcAft>
                  <a:spcPts val="0"/>
                </a:spcAft>
                <a:buClr>
                  <a:srgbClr val="E71315"/>
                </a:buClr>
                <a:buSzPct val="100000"/>
                <a:buFontTx/>
                <a:buNone/>
                <a:tabLst/>
                <a:defRPr/>
              </a:pPr>
              <a:r>
                <a:rPr kumimoji="0" lang="de-CH" sz="1400" b="1" i="0" u="none" strike="noStrike" kern="0" cap="none" spc="0" normalizeH="0" baseline="0" noProof="0" dirty="0">
                  <a:ln>
                    <a:noFill/>
                  </a:ln>
                  <a:solidFill>
                    <a:srgbClr val="B4BD01"/>
                  </a:solidFill>
                  <a:effectLst/>
                  <a:uLnTx/>
                  <a:uFillTx/>
                  <a:latin typeface="Arial" panose="020B0604020202020204"/>
                </a:rPr>
                <a:t>III-A</a:t>
              </a:r>
              <a:endParaRPr kumimoji="0" lang="en-US" sz="1400" b="1" i="0" u="none" strike="noStrike" kern="0" cap="none" spc="0" normalizeH="0" baseline="0" noProof="0" dirty="0">
                <a:ln>
                  <a:noFill/>
                </a:ln>
                <a:solidFill>
                  <a:srgbClr val="B4BD01"/>
                </a:solidFill>
                <a:effectLst/>
                <a:uLnTx/>
                <a:uFillTx/>
                <a:latin typeface="Arial" panose="020B0604020202020204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501DE32-68EF-546B-BE17-58CAEAA6DBDB}"/>
                </a:ext>
              </a:extLst>
            </p:cNvPr>
            <p:cNvSpPr txBox="1"/>
            <p:nvPr/>
          </p:nvSpPr>
          <p:spPr>
            <a:xfrm>
              <a:off x="8709523" y="3233082"/>
              <a:ext cx="964039" cy="261610"/>
            </a:xfrm>
            <a:prstGeom prst="rect">
              <a:avLst/>
            </a:prstGeom>
            <a:noFill/>
          </p:spPr>
          <p:txBody>
            <a:bodyPr wrap="square" anchor="ctr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1" u="none" strike="noStrike" kern="0" cap="none" spc="0" normalizeH="0" baseline="0" noProof="0" dirty="0">
                  <a:ln>
                    <a:noFill/>
                  </a:ln>
                  <a:solidFill>
                    <a:srgbClr val="222222"/>
                  </a:solidFill>
                  <a:effectLst/>
                  <a:uLnTx/>
                  <a:uFillTx/>
                  <a:latin typeface="Arial" panose="020B0604020202020204"/>
                </a:rPr>
                <a:t>PIK3CA </a:t>
              </a:r>
              <a:r>
                <a:rPr kumimoji="0" lang="en-US" sz="1100" b="0" i="0" u="none" strike="noStrike" kern="0" cap="none" spc="0" normalizeH="0" baseline="0" noProof="0" dirty="0">
                  <a:ln>
                    <a:noFill/>
                  </a:ln>
                  <a:solidFill>
                    <a:srgbClr val="222222"/>
                  </a:solidFill>
                  <a:effectLst/>
                  <a:uLnTx/>
                  <a:uFillTx/>
                  <a:latin typeface="Arial" panose="020B0604020202020204"/>
                </a:rPr>
                <a:t>mut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E5F2448-9963-348E-8BD5-6BA4454A742A}"/>
                </a:ext>
              </a:extLst>
            </p:cNvPr>
            <p:cNvSpPr txBox="1"/>
            <p:nvPr/>
          </p:nvSpPr>
          <p:spPr>
            <a:xfrm>
              <a:off x="8377742" y="3423484"/>
              <a:ext cx="1880847" cy="307777"/>
            </a:xfrm>
            <a:prstGeom prst="rect">
              <a:avLst/>
            </a:prstGeom>
            <a:noFill/>
          </p:spPr>
          <p:txBody>
            <a:bodyPr wrap="square" anchor="ctr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0" cap="none" spc="0" normalizeH="0" baseline="0" noProof="0" dirty="0">
                  <a:ln>
                    <a:noFill/>
                  </a:ln>
                  <a:solidFill>
                    <a:srgbClr val="222222">
                      <a:lumMod val="90000"/>
                      <a:lumOff val="10000"/>
                    </a:srgbClr>
                  </a:solidFill>
                  <a:effectLst/>
                  <a:uLnTx/>
                  <a:uFillTx/>
                  <a:latin typeface="Arial" panose="020B0604020202020204"/>
                </a:rPr>
                <a:t>Gastric cancer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7015A8A-13EF-F431-D871-D1F569F13B16}"/>
                </a:ext>
              </a:extLst>
            </p:cNvPr>
            <p:cNvSpPr txBox="1"/>
            <p:nvPr/>
          </p:nvSpPr>
          <p:spPr>
            <a:xfrm>
              <a:off x="8705683" y="3676396"/>
              <a:ext cx="1020332" cy="261610"/>
            </a:xfrm>
            <a:prstGeom prst="rect">
              <a:avLst/>
            </a:prstGeom>
            <a:noFill/>
          </p:spPr>
          <p:txBody>
            <a:bodyPr wrap="square" anchor="ctr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1" u="none" strike="noStrike" kern="0" cap="none" spc="0" normalizeH="0" baseline="0" noProof="0" dirty="0">
                  <a:ln>
                    <a:noFill/>
                  </a:ln>
                  <a:solidFill>
                    <a:srgbClr val="222222"/>
                  </a:solidFill>
                  <a:effectLst/>
                  <a:uLnTx/>
                  <a:uFillTx/>
                  <a:latin typeface="Arial" panose="020B0604020202020204"/>
                </a:rPr>
                <a:t>PIK3CA</a:t>
              </a:r>
              <a:r>
                <a:rPr kumimoji="0" lang="en-US" sz="1100" b="0" i="0" u="none" strike="noStrike" kern="0" cap="none" spc="0" normalizeH="0" baseline="0" noProof="0" dirty="0">
                  <a:ln>
                    <a:noFill/>
                  </a:ln>
                  <a:solidFill>
                    <a:srgbClr val="222222"/>
                  </a:solidFill>
                  <a:effectLst/>
                  <a:uLnTx/>
                  <a:uFillTx/>
                  <a:latin typeface="Arial" panose="020B0604020202020204"/>
                </a:rPr>
                <a:t> mut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1A62B4F-4E02-3C47-E2AF-53380537C615}"/>
                </a:ext>
              </a:extLst>
            </p:cNvPr>
            <p:cNvSpPr txBox="1"/>
            <p:nvPr/>
          </p:nvSpPr>
          <p:spPr>
            <a:xfrm>
              <a:off x="8424554" y="3601122"/>
              <a:ext cx="508000" cy="38132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normAutofit/>
            </a:bodyPr>
            <a:lstStyle/>
            <a:p>
              <a:pPr marL="0" marR="0" lvl="0" indent="0" defTabSz="914400" eaLnBrk="1" fontAlgn="auto" latinLnBrk="0" hangingPunct="1">
                <a:lnSpc>
                  <a:spcPct val="120000"/>
                </a:lnSpc>
                <a:spcBef>
                  <a:spcPts val="200"/>
                </a:spcBef>
                <a:spcAft>
                  <a:spcPts val="0"/>
                </a:spcAft>
                <a:buClr>
                  <a:srgbClr val="E71315"/>
                </a:buClr>
                <a:buSzPct val="100000"/>
                <a:buFontTx/>
                <a:buNone/>
                <a:tabLst/>
                <a:defRPr/>
              </a:pPr>
              <a:r>
                <a:rPr kumimoji="0" lang="de-CH" sz="1400" b="1" i="0" u="none" strike="noStrike" kern="0" cap="none" spc="0" normalizeH="0" baseline="0" noProof="0" dirty="0">
                  <a:ln>
                    <a:noFill/>
                  </a:ln>
                  <a:solidFill>
                    <a:srgbClr val="B4BD01"/>
                  </a:solidFill>
                  <a:effectLst/>
                  <a:uLnTx/>
                  <a:uFillTx/>
                  <a:latin typeface="Arial" panose="020B0604020202020204"/>
                </a:rPr>
                <a:t>III-A</a:t>
              </a:r>
              <a:endParaRPr kumimoji="0" lang="en-US" sz="1400" b="1" i="0" u="none" strike="noStrike" kern="0" cap="none" spc="0" normalizeH="0" baseline="0" noProof="0" dirty="0">
                <a:ln>
                  <a:noFill/>
                </a:ln>
                <a:solidFill>
                  <a:srgbClr val="B4BD01"/>
                </a:solidFill>
                <a:effectLst/>
                <a:uLnTx/>
                <a:uFillTx/>
                <a:latin typeface="Arial" panose="020B0604020202020204"/>
              </a:endParaRP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2A2C5A64-B1F0-B6F7-F6D2-8D2901B1A7C0}"/>
              </a:ext>
            </a:extLst>
          </p:cNvPr>
          <p:cNvSpPr txBox="1"/>
          <p:nvPr/>
        </p:nvSpPr>
        <p:spPr>
          <a:xfrm>
            <a:off x="419944" y="5964937"/>
            <a:ext cx="114505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Clinical relevance of biobank selected samples included in the ODxET evaluation with tumor type, variant and ESCAT tier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s: fusions; ampl: amplifications; mut: mutations; ex: exon; ins: insertion, del: deletion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5245677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9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7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0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9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3" dur="50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6" dur="5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9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3DCB4652-A7CF-BE3A-6151-5E044264C994}"/>
              </a:ext>
            </a:extLst>
          </p:cNvPr>
          <p:cNvSpPr txBox="1"/>
          <p:nvPr/>
        </p:nvSpPr>
        <p:spPr>
          <a:xfrm>
            <a:off x="2098745" y="5526351"/>
            <a:ext cx="8204579" cy="515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20000"/>
              </a:lnSpc>
              <a:spcBef>
                <a:spcPts val="100"/>
              </a:spcBef>
              <a:spcAft>
                <a:spcPts val="0"/>
              </a:spcAft>
              <a:buClr>
                <a:srgbClr val="E71315"/>
              </a:buClr>
              <a:buSzPct val="100000"/>
              <a:buFont typeface="Arial" panose="020B0604020202020204" pitchFamily="34" charset="0"/>
              <a:buNone/>
              <a:tabLst/>
              <a:defRPr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Evaluated SNVs and indels representing clinically relevant genes and variants. Only mutation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pre-characterized testing information are displayed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611314E-E92B-B516-4EE7-A44A4E1203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9903" y="694731"/>
            <a:ext cx="7212193" cy="49016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47277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>
            <a:extLst>
              <a:ext uri="{FF2B5EF4-FFF2-40B4-BE49-F238E27FC236}">
                <a16:creationId xmlns:a16="http://schemas.microsoft.com/office/drawing/2014/main" id="{3C526D3F-C3DE-E62C-7B27-33059908DF72}"/>
              </a:ext>
            </a:extLst>
          </p:cNvPr>
          <p:cNvSpPr txBox="1"/>
          <p:nvPr/>
        </p:nvSpPr>
        <p:spPr>
          <a:xfrm>
            <a:off x="775063" y="5149517"/>
            <a:ext cx="10558468" cy="73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20000"/>
              </a:lnSpc>
              <a:spcBef>
                <a:spcPts val="100"/>
              </a:spcBef>
              <a:spcAft>
                <a:spcPts val="0"/>
              </a:spcAft>
              <a:buClr>
                <a:srgbClr val="E71315"/>
              </a:buClr>
              <a:buSzPct val="100000"/>
              <a:buFont typeface="Arial" panose="020B0604020202020204" pitchFamily="34" charset="0"/>
              <a:buNone/>
              <a:tabLst/>
              <a:defRPr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Evaluated fusion isoforms (A) and splice variants (B) representing clinically relevant variants. Only fusions and splice variants with pre-characterized information are shown. The number of isoforms tested and partner genes are illustrated. *Novel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L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usion identified with exon tiling imbalance; partner gene is not known.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E86529D-3CB4-F6D7-C536-9477C95AD240}"/>
              </a:ext>
            </a:extLst>
          </p:cNvPr>
          <p:cNvSpPr txBox="1"/>
          <p:nvPr/>
        </p:nvSpPr>
        <p:spPr>
          <a:xfrm>
            <a:off x="8246778" y="971678"/>
            <a:ext cx="4614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sz="1600" b="1" dirty="0">
                <a:latin typeface="Arial" panose="020B0604020202020204"/>
              </a:rPr>
              <a:t>B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28F312C-AF75-60FA-B308-BD20D3089C31}"/>
              </a:ext>
            </a:extLst>
          </p:cNvPr>
          <p:cNvSpPr txBox="1"/>
          <p:nvPr/>
        </p:nvSpPr>
        <p:spPr>
          <a:xfrm>
            <a:off x="441883" y="969705"/>
            <a:ext cx="4614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sz="1600" b="1" dirty="0">
                <a:latin typeface="Arial" panose="020B0604020202020204"/>
              </a:rPr>
              <a:t>A</a:t>
            </a:r>
          </a:p>
        </p:txBody>
      </p:sp>
      <p:pic>
        <p:nvPicPr>
          <p:cNvPr id="189" name="Picture 188">
            <a:extLst>
              <a:ext uri="{FF2B5EF4-FFF2-40B4-BE49-F238E27FC236}">
                <a16:creationId xmlns:a16="http://schemas.microsoft.com/office/drawing/2014/main" id="{E10319A9-5E64-9D3A-961E-C460888D9C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77486" y="1483474"/>
            <a:ext cx="2052000" cy="332352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66230B7-00B0-8BDC-7D9E-67F31B6559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5063" y="1138982"/>
            <a:ext cx="6186150" cy="36582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02883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>
            <a:extLst>
              <a:ext uri="{FF2B5EF4-FFF2-40B4-BE49-F238E27FC236}">
                <a16:creationId xmlns:a16="http://schemas.microsoft.com/office/drawing/2014/main" id="{3C526D3F-C3DE-E62C-7B27-33059908DF72}"/>
              </a:ext>
            </a:extLst>
          </p:cNvPr>
          <p:cNvSpPr txBox="1"/>
          <p:nvPr/>
        </p:nvSpPr>
        <p:spPr>
          <a:xfrm>
            <a:off x="2898649" y="5608772"/>
            <a:ext cx="5916168" cy="73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20000"/>
              </a:lnSpc>
              <a:spcBef>
                <a:spcPts val="100"/>
              </a:spcBef>
              <a:spcAft>
                <a:spcPts val="0"/>
              </a:spcAft>
              <a:buClr>
                <a:srgbClr val="E71315"/>
              </a:buClr>
              <a:buSzPct val="100000"/>
              <a:buFont typeface="Arial" panose="020B0604020202020204" pitchFamily="34" charset="0"/>
              <a:buNone/>
              <a:tabLst/>
              <a:defRPr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etection of fusions and splice variants by ODxET. Molecular counts are shown only for pre-characterized fusions and splice variants in study phase II with clinical tumor sample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655F07F-1AEE-CEED-ADFA-6605612512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3973121"/>
              </p:ext>
            </p:extLst>
          </p:nvPr>
        </p:nvGraphicFramePr>
        <p:xfrm>
          <a:off x="2542223" y="1565275"/>
          <a:ext cx="6467475" cy="3727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9" r:id="rId3" imgW="6467317" imgH="3726848" progId="Prism9.Document">
                  <p:embed/>
                </p:oleObj>
              </mc:Choice>
              <mc:Fallback>
                <p:oleObj name="Prism 9" r:id="rId3" imgW="6467317" imgH="3726848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655F07F-1AEE-CEED-ADFA-6605612512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42223" y="1565275"/>
                        <a:ext cx="6467475" cy="3727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99513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02</TotalTime>
  <Words>298</Words>
  <Application>Microsoft Office PowerPoint</Application>
  <PresentationFormat>Widescreen</PresentationFormat>
  <Paragraphs>36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rmo Fisher Scientif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rães, Cecília</dc:creator>
  <cp:lastModifiedBy>MDPI</cp:lastModifiedBy>
  <cp:revision>5</cp:revision>
  <dcterms:created xsi:type="dcterms:W3CDTF">2022-09-20T15:30:34Z</dcterms:created>
  <dcterms:modified xsi:type="dcterms:W3CDTF">2023-09-07T03:11:10Z</dcterms:modified>
</cp:coreProperties>
</file>